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2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3.xml" ContentType="application/vnd.openxmlformats-officedocument.themeOverr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14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theme/themeOverride15.xml" ContentType="application/vnd.openxmlformats-officedocument.themeOverrid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16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theme/themeOverride17.xml" ContentType="application/vnd.openxmlformats-officedocument.themeOverrid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theme/themeOverride18.xml" ContentType="application/vnd.openxmlformats-officedocument.themeOverride+xml"/>
  <Override PartName="/ppt/charts/chart19.xml" ContentType="application/vnd.openxmlformats-officedocument.drawingml.chart+xml"/>
  <Override PartName="/ppt/theme/themeOverride19.xml" ContentType="application/vnd.openxmlformats-officedocument.themeOverride+xml"/>
  <Override PartName="/ppt/charts/chart20.xml" ContentType="application/vnd.openxmlformats-officedocument.drawingml.chart+xml"/>
  <Override PartName="/ppt/theme/themeOverride20.xml" ContentType="application/vnd.openxmlformats-officedocument.themeOverride+xml"/>
  <Override PartName="/ppt/charts/chart21.xml" ContentType="application/vnd.openxmlformats-officedocument.drawingml.chart+xml"/>
  <Override PartName="/ppt/theme/themeOverride21.xml" ContentType="application/vnd.openxmlformats-officedocument.themeOverride+xml"/>
  <Override PartName="/ppt/charts/chart22.xml" ContentType="application/vnd.openxmlformats-officedocument.drawingml.chart+xml"/>
  <Override PartName="/ppt/theme/themeOverride22.xml" ContentType="application/vnd.openxmlformats-officedocument.themeOverride+xml"/>
  <Override PartName="/ppt/charts/chart23.xml" ContentType="application/vnd.openxmlformats-officedocument.drawingml.chart+xml"/>
  <Override PartName="/ppt/theme/themeOverride23.xml" ContentType="application/vnd.openxmlformats-officedocument.themeOverride+xml"/>
  <Override PartName="/ppt/charts/chart24.xml" ContentType="application/vnd.openxmlformats-officedocument.drawingml.chart+xml"/>
  <Override PartName="/ppt/theme/themeOverride24.xml" ContentType="application/vnd.openxmlformats-officedocument.themeOverride+xml"/>
  <Override PartName="/ppt/charts/chart25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theme/themeOverride25.xml" ContentType="application/vnd.openxmlformats-officedocument.themeOverride+xml"/>
  <Override PartName="/ppt/charts/chart26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theme/themeOverride26.xml" ContentType="application/vnd.openxmlformats-officedocument.themeOverride+xml"/>
  <Override PartName="/ppt/charts/chart27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theme/themeOverride27.xml" ContentType="application/vnd.openxmlformats-officedocument.themeOverride+xml"/>
  <Override PartName="/ppt/charts/chart28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theme/themeOverride28.xml" ContentType="application/vnd.openxmlformats-officedocument.themeOverride+xml"/>
  <Override PartName="/ppt/charts/chart29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theme/themeOverride29.xml" ContentType="application/vnd.openxmlformats-officedocument.themeOverride+xml"/>
  <Override PartName="/ppt/charts/chart30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theme/themeOverride30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02" r:id="rId2"/>
    <p:sldId id="303" r:id="rId3"/>
    <p:sldId id="304" r:id="rId4"/>
    <p:sldId id="305" r:id="rId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5.xm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6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7.xm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8.xm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oleObject" Target="file:///C:\Users\CASE\Desktop\JJD%20Lab%202022\Experiments\HDAC6%20and%20Proteasomal%20activity%20in%20MM%20cells\HDAC6%20Inhibitors%20and%20MM\XTT%20Compilation-%203HDAC6i%20in%203%20MMCls.xlsx" TargetMode="External"/></Relationships>
</file>

<file path=ppt/charts/_rels/chart19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CASE\Desktop\JJD%20Lab%202022\Experiments\HDAC6%20and%20Proteasomal%20activity%20in%20MM%20cells\Effect%20of%20Non-specific%20HDACi%20on%20Proteasomal%20Activity%20in%20MM%20cells\07-08-2022%20to%2007-12-2022\07-12-2022%20non-specific%20HDACi%20on%20MM%20cells%20after%2072hrs.xlsb.xlsx" TargetMode="External"/><Relationship Id="rId1" Type="http://schemas.openxmlformats.org/officeDocument/2006/relationships/themeOverride" Target="../theme/themeOverrid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20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CASE\Desktop\JJD%20Lab%202022\Experiments\HDAC6%20and%20Proteasomal%20activity%20in%20MM%20cells\Effect%20of%20Non-specific%20HDACi%20on%20Proteasomal%20Activity%20in%20MM%20cells\07-08-2022%20to%2007-12-2022\07-12-2022%20non-specific%20HDACi%20on%20MM%20cells%20after%2072hrs.xlsb.xlsx" TargetMode="External"/><Relationship Id="rId1" Type="http://schemas.openxmlformats.org/officeDocument/2006/relationships/themeOverride" Target="../theme/themeOverride20.xml"/></Relationships>
</file>

<file path=ppt/charts/_rels/chart2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CASE\Desktop\JJD%20Lab%202022\Experiments\HDAC6%20and%20Proteasomal%20activity%20in%20MM%20cells\Effect%20of%20Non-specific%20HDACi%20on%20Proteasomal%20Activity%20in%20MM%20cells\07-08-2022%20to%2007-12-2022\07-12-2022%20non-specific%20HDACi%20on%20MM%20cells%20after%2072hrs.xlsb.xlsx" TargetMode="External"/><Relationship Id="rId1" Type="http://schemas.openxmlformats.org/officeDocument/2006/relationships/themeOverride" Target="../theme/themeOverride21.xml"/></Relationships>
</file>

<file path=ppt/charts/_rels/chart2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CASE\Desktop\JJD%20Lab%202022\Experiments\HDAC6%20and%20Proteasomal%20activity%20in%20MM%20cells\Effect%20of%20Non-specific%20HDACi%20on%20Proteasomal%20Activity%20in%20MM%20cells\07-08-2022%20to%2007-12-2022\07-12-2022%20non-specific%20HDACi%20on%20MM%20cells%20after%2072hrs.xlsb.xlsx" TargetMode="External"/><Relationship Id="rId1" Type="http://schemas.openxmlformats.org/officeDocument/2006/relationships/themeOverride" Target="../theme/themeOverride22.xml"/></Relationships>
</file>

<file path=ppt/charts/_rels/chart2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CASE\Desktop\JJD%20Lab%202022\Experiments\HDAC6%20and%20Proteasomal%20activity%20in%20MM%20cells\Effect%20of%20Non-specific%20HDACi%20on%20Proteasomal%20Activity%20in%20MM%20cells\07-08-2022%20to%2007-12-2022\07-12-2022%20non-specific%20HDACi%20on%20MM%20cells%20after%2072hrs.xlsb.xlsx" TargetMode="External"/><Relationship Id="rId1" Type="http://schemas.openxmlformats.org/officeDocument/2006/relationships/themeOverride" Target="../theme/themeOverride23.xml"/></Relationships>
</file>

<file path=ppt/charts/_rels/chart2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CASE\Desktop\JJD%20Lab%202022\Experiments\HDAC6%20and%20Proteasomal%20activity%20in%20MM%20cells\Effect%20of%20Non-specific%20HDACi%20on%20Proteasomal%20Activity%20in%20MM%20cells\07-08-2022%20to%2007-12-2022\07-12-2022%20non-specific%20HDACi%20on%20MM%20cells%20after%2072hrs.xlsb.xlsx" TargetMode="External"/><Relationship Id="rId1" Type="http://schemas.openxmlformats.org/officeDocument/2006/relationships/themeOverride" Target="../theme/themeOverrid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5.xm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oleObject" Target="file:///C:\Users\CASE\Desktop\JJD%20Lab%202022\Experiments\Effect%20of%20HAT%20activators%20on%20proteasomal%20activity\08-03-2022%20Proteasome%20activity%20in%20the%20presence%20of%20HAT%20activators-2hr%20and%2024%20hr.xlsx" TargetMode="Externa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6.xm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oleObject" Target="file:///C:\Users\CASE\Desktop\JJD%20Lab%202022\Experiments\Effect%20of%20HAT%20activators%20on%20proteasomal%20activity\08-03-2022%20Proteasome%20activity%20in%20the%20presence%20of%20HAT%20activators-2hr%20and%2024%20hr.xlsx" TargetMode="Externa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7.xml"/><Relationship Id="rId2" Type="http://schemas.microsoft.com/office/2011/relationships/chartColorStyle" Target="colors21.xml"/><Relationship Id="rId1" Type="http://schemas.microsoft.com/office/2011/relationships/chartStyle" Target="style21.xml"/><Relationship Id="rId4" Type="http://schemas.openxmlformats.org/officeDocument/2006/relationships/oleObject" Target="file:///C:\Users\CASE\Desktop\JJD%20Lab%202022\Experiments\Effect%20of%20HAT%20activators%20on%20proteasomal%20activity\08-03-2022%20Proteasome%20activity%20in%20the%20presence%20of%20HAT%20activators-2hr%20and%2024%20hr.xlsx" TargetMode="Externa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8.xml"/><Relationship Id="rId2" Type="http://schemas.microsoft.com/office/2011/relationships/chartColorStyle" Target="colors22.xml"/><Relationship Id="rId1" Type="http://schemas.microsoft.com/office/2011/relationships/chartStyle" Target="style22.xml"/><Relationship Id="rId4" Type="http://schemas.openxmlformats.org/officeDocument/2006/relationships/oleObject" Target="file:///C:\Users\CASE\Desktop\JJD%20Lab%202022\Experiments\Effect%20of%20HAT%20activators%20on%20proteasomal%20activity\08-03-2022%20Proteasome%20activity%20in%20the%20presence%20of%20HAT%20activators-2hr%20and%2024%20hr.xlsx" TargetMode="Externa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9.xml"/><Relationship Id="rId2" Type="http://schemas.microsoft.com/office/2011/relationships/chartColorStyle" Target="colors23.xml"/><Relationship Id="rId1" Type="http://schemas.microsoft.com/office/2011/relationships/chartStyle" Target="style23.xml"/><Relationship Id="rId4" Type="http://schemas.openxmlformats.org/officeDocument/2006/relationships/oleObject" Target="file:///C:\Users\CASE\Desktop\JJD%20Lab%202022\Experiments\Effect%20of%20HAT%20activators%20on%20proteasomal%20activity\08-03-2022%20Proteasome%20activity%20in%20the%20presence%20of%20HAT%20activators-2hr%20and%2024%20hr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0.xml"/><Relationship Id="rId2" Type="http://schemas.microsoft.com/office/2011/relationships/chartColorStyle" Target="colors24.xml"/><Relationship Id="rId1" Type="http://schemas.microsoft.com/office/2011/relationships/chartStyle" Target="style24.xml"/><Relationship Id="rId4" Type="http://schemas.openxmlformats.org/officeDocument/2006/relationships/oleObject" Target="file:///C:\Users\CASE\Desktop\JJD%20Lab%202022\Experiments\Effect%20of%20HAT%20activators%20on%20proteasomal%20activity\08-03-2022%20Proteasome%20activity%20in%20the%20presence%20of%20HAT%20activators-2hr%20and%2024%20hr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Users\CASE\Desktop\JJD%20Lab%202022\Experiments\HDAC6%20and%20Proteasomal%20activity%20in%20MM%20cells\HDAC6%20Inhibitors%20and%20MM\07-22-2022%20MMCLs%20treated%20with%20HDAC6i%20at%201%20uM%20and%200.3%20uM\Proteasome%20Activity\07-21-2022%20%202hr%20HDAC6i%20on%20Proteasome%20Activit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Tubastatin-A 0.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0220329467539286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39761120437509"/>
          <c:y val="0.13004629629629633"/>
          <c:w val="0.78467506925917063"/>
          <c:h val="0.66690883083110086"/>
        </c:manualLayout>
      </c:layout>
      <c:scatterChart>
        <c:scatterStyle val="lineMarker"/>
        <c:varyColors val="0"/>
        <c:ser>
          <c:idx val="0"/>
          <c:order val="0"/>
          <c:tx>
            <c:v>RPMI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X$6:$X$13</c:f>
                <c:numCache>
                  <c:formatCode>General</c:formatCode>
                  <c:ptCount val="8"/>
                  <c:pt idx="0">
                    <c:v>4.8958781542503678</c:v>
                  </c:pt>
                  <c:pt idx="1">
                    <c:v>0.93708983060371187</c:v>
                  </c:pt>
                  <c:pt idx="2">
                    <c:v>2.722362886215659</c:v>
                  </c:pt>
                  <c:pt idx="3">
                    <c:v>3.8106013040758731</c:v>
                  </c:pt>
                  <c:pt idx="4">
                    <c:v>4.0764985662108426</c:v>
                  </c:pt>
                  <c:pt idx="5">
                    <c:v>2.3464646048892637</c:v>
                  </c:pt>
                  <c:pt idx="6">
                    <c:v>1.0526136688066889</c:v>
                  </c:pt>
                  <c:pt idx="7">
                    <c:v>0.5818476408593336</c:v>
                  </c:pt>
                </c:numCache>
              </c:numRef>
            </c:plus>
            <c:minus>
              <c:numRef>
                <c:f>[1]Sheet1!$X$6:$X$13</c:f>
                <c:numCache>
                  <c:formatCode>General</c:formatCode>
                  <c:ptCount val="8"/>
                  <c:pt idx="0">
                    <c:v>4.8958781542503678</c:v>
                  </c:pt>
                  <c:pt idx="1">
                    <c:v>0.93708983060371187</c:v>
                  </c:pt>
                  <c:pt idx="2">
                    <c:v>2.722362886215659</c:v>
                  </c:pt>
                  <c:pt idx="3">
                    <c:v>3.8106013040758731</c:v>
                  </c:pt>
                  <c:pt idx="4">
                    <c:v>4.0764985662108426</c:v>
                  </c:pt>
                  <c:pt idx="5">
                    <c:v>2.3464646048892637</c:v>
                  </c:pt>
                  <c:pt idx="6">
                    <c:v>1.0526136688066889</c:v>
                  </c:pt>
                  <c:pt idx="7">
                    <c:v>0.581847640859333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V$6:$V$13</c:f>
              <c:numCache>
                <c:formatCode>General</c:formatCode>
                <c:ptCount val="8"/>
                <c:pt idx="0">
                  <c:v>164.08520431003916</c:v>
                </c:pt>
                <c:pt idx="1">
                  <c:v>129.11560338447191</c:v>
                </c:pt>
                <c:pt idx="2">
                  <c:v>116.61605347117471</c:v>
                </c:pt>
                <c:pt idx="3">
                  <c:v>120.6858326014699</c:v>
                </c:pt>
                <c:pt idx="4">
                  <c:v>104.25554616079384</c:v>
                </c:pt>
                <c:pt idx="5">
                  <c:v>101.02426904157204</c:v>
                </c:pt>
                <c:pt idx="6">
                  <c:v>99.079917042500497</c:v>
                </c:pt>
                <c:pt idx="7">
                  <c:v>100.000000000000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18-44D7-BA07-ABDC955E9358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G$6:$AG$13</c:f>
                <c:numCache>
                  <c:formatCode>General</c:formatCode>
                  <c:ptCount val="8"/>
                  <c:pt idx="0">
                    <c:v>2.3905275265798163</c:v>
                  </c:pt>
                  <c:pt idx="1">
                    <c:v>1.8213153652673979</c:v>
                  </c:pt>
                  <c:pt idx="2">
                    <c:v>2.4215661594405229</c:v>
                  </c:pt>
                  <c:pt idx="3">
                    <c:v>1.0833018963767909</c:v>
                  </c:pt>
                  <c:pt idx="4">
                    <c:v>1.7121534148917175</c:v>
                  </c:pt>
                  <c:pt idx="5">
                    <c:v>3.7604654564381406</c:v>
                  </c:pt>
                  <c:pt idx="6">
                    <c:v>1.9480605107241526</c:v>
                  </c:pt>
                  <c:pt idx="7">
                    <c:v>2.3844730859182222</c:v>
                  </c:pt>
                </c:numCache>
              </c:numRef>
            </c:plus>
            <c:minus>
              <c:numRef>
                <c:f>[1]Sheet1!$AG$6:$AG$13</c:f>
                <c:numCache>
                  <c:formatCode>General</c:formatCode>
                  <c:ptCount val="8"/>
                  <c:pt idx="0">
                    <c:v>2.3905275265798163</c:v>
                  </c:pt>
                  <c:pt idx="1">
                    <c:v>1.8213153652673979</c:v>
                  </c:pt>
                  <c:pt idx="2">
                    <c:v>2.4215661594405229</c:v>
                  </c:pt>
                  <c:pt idx="3">
                    <c:v>1.0833018963767909</c:v>
                  </c:pt>
                  <c:pt idx="4">
                    <c:v>1.7121534148917175</c:v>
                  </c:pt>
                  <c:pt idx="5">
                    <c:v>3.7604654564381406</c:v>
                  </c:pt>
                  <c:pt idx="6">
                    <c:v>1.9480605107241526</c:v>
                  </c:pt>
                  <c:pt idx="7">
                    <c:v>2.384473085918222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E$6:$AE$13</c:f>
              <c:numCache>
                <c:formatCode>General</c:formatCode>
                <c:ptCount val="8"/>
                <c:pt idx="0">
                  <c:v>150.95385317435273</c:v>
                </c:pt>
                <c:pt idx="1">
                  <c:v>140.27499301888082</c:v>
                </c:pt>
                <c:pt idx="2">
                  <c:v>129.36616604642887</c:v>
                </c:pt>
                <c:pt idx="3">
                  <c:v>118.85688800573742</c:v>
                </c:pt>
                <c:pt idx="4">
                  <c:v>100.57569901570565</c:v>
                </c:pt>
                <c:pt idx="5">
                  <c:v>104.64182961495337</c:v>
                </c:pt>
                <c:pt idx="6">
                  <c:v>100.50082659195235</c:v>
                </c:pt>
                <c:pt idx="7">
                  <c:v>100.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D18-44D7-BA07-ABDC955E9358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O$6:$AO$13</c:f>
                <c:numCache>
                  <c:formatCode>General</c:formatCode>
                  <c:ptCount val="8"/>
                  <c:pt idx="0">
                    <c:v>3.082871561517863E-2</c:v>
                  </c:pt>
                  <c:pt idx="1">
                    <c:v>2.6734974644708291</c:v>
                  </c:pt>
                  <c:pt idx="2">
                    <c:v>1.042658644662344</c:v>
                  </c:pt>
                  <c:pt idx="3">
                    <c:v>1.2480247954230816</c:v>
                  </c:pt>
                  <c:pt idx="4">
                    <c:v>0.62351893305961326</c:v>
                  </c:pt>
                  <c:pt idx="5">
                    <c:v>0.37236154663681986</c:v>
                  </c:pt>
                  <c:pt idx="6">
                    <c:v>0.7742364401712899</c:v>
                  </c:pt>
                  <c:pt idx="7">
                    <c:v>2.081726791840262</c:v>
                  </c:pt>
                </c:numCache>
              </c:numRef>
            </c:plus>
            <c:minus>
              <c:numRef>
                <c:f>[1]Sheet1!$AO$6:$AO$13</c:f>
                <c:numCache>
                  <c:formatCode>General</c:formatCode>
                  <c:ptCount val="8"/>
                  <c:pt idx="0">
                    <c:v>3.082871561517863E-2</c:v>
                  </c:pt>
                  <c:pt idx="1">
                    <c:v>2.6734974644708291</c:v>
                  </c:pt>
                  <c:pt idx="2">
                    <c:v>1.042658644662344</c:v>
                  </c:pt>
                  <c:pt idx="3">
                    <c:v>1.2480247954230816</c:v>
                  </c:pt>
                  <c:pt idx="4">
                    <c:v>0.62351893305961326</c:v>
                  </c:pt>
                  <c:pt idx="5">
                    <c:v>0.37236154663681986</c:v>
                  </c:pt>
                  <c:pt idx="6">
                    <c:v>0.7742364401712899</c:v>
                  </c:pt>
                  <c:pt idx="7">
                    <c:v>2.08172679184026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M$6:$AM$13</c:f>
              <c:numCache>
                <c:formatCode>General</c:formatCode>
                <c:ptCount val="8"/>
                <c:pt idx="0">
                  <c:v>162.01111042224119</c:v>
                </c:pt>
                <c:pt idx="1">
                  <c:v>159.5450075642058</c:v>
                </c:pt>
                <c:pt idx="2">
                  <c:v>142.66925749592517</c:v>
                </c:pt>
                <c:pt idx="3">
                  <c:v>136.26586410973476</c:v>
                </c:pt>
                <c:pt idx="4">
                  <c:v>106.02646936657483</c:v>
                </c:pt>
                <c:pt idx="5">
                  <c:v>108.13717641902541</c:v>
                </c:pt>
                <c:pt idx="6">
                  <c:v>98.571644869168239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D18-44D7-BA07-ABDC955E93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613126499880229"/>
          <c:y val="0.44007217847769031"/>
          <c:w val="0.36541175978982365"/>
          <c:h val="0.287995771361913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Tubastatin-A 0.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2282060249433831"/>
          <c:y val="6.64497852704413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141629757217851"/>
          <c:y val="0.10401196235232653"/>
          <c:w val="0.79189919619422566"/>
          <c:h val="0.72312909640247003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2!$E$4:$E$11</c:f>
                <c:numCache>
                  <c:formatCode>General</c:formatCode>
                  <c:ptCount val="8"/>
                  <c:pt idx="0">
                    <c:v>4.5897881132130403</c:v>
                  </c:pt>
                  <c:pt idx="1">
                    <c:v>1.9554581382713156</c:v>
                  </c:pt>
                  <c:pt idx="2">
                    <c:v>3.4535156072191229</c:v>
                  </c:pt>
                  <c:pt idx="3">
                    <c:v>5.1834821373076521</c:v>
                  </c:pt>
                  <c:pt idx="4">
                    <c:v>2.2305660325595746</c:v>
                  </c:pt>
                  <c:pt idx="5">
                    <c:v>3.3413533785097744</c:v>
                  </c:pt>
                  <c:pt idx="6">
                    <c:v>5.4109017899003904</c:v>
                  </c:pt>
                  <c:pt idx="7">
                    <c:v>5.900688113332631</c:v>
                  </c:pt>
                </c:numCache>
              </c:numRef>
            </c:plus>
            <c:minus>
              <c:numRef>
                <c:f>[1]Sheet2!$E$4:$E$11</c:f>
                <c:numCache>
                  <c:formatCode>General</c:formatCode>
                  <c:ptCount val="8"/>
                  <c:pt idx="0">
                    <c:v>4.5897881132130403</c:v>
                  </c:pt>
                  <c:pt idx="1">
                    <c:v>1.9554581382713156</c:v>
                  </c:pt>
                  <c:pt idx="2">
                    <c:v>3.4535156072191229</c:v>
                  </c:pt>
                  <c:pt idx="3">
                    <c:v>5.1834821373076521</c:v>
                  </c:pt>
                  <c:pt idx="4">
                    <c:v>2.2305660325595746</c:v>
                  </c:pt>
                  <c:pt idx="5">
                    <c:v>3.3413533785097744</c:v>
                  </c:pt>
                  <c:pt idx="6">
                    <c:v>5.4109017899003904</c:v>
                  </c:pt>
                  <c:pt idx="7">
                    <c:v>5.90068811333263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2!$B$4:$B$11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([1]Sheet2!$C$4:$C$11,[1]Sheet2!$C$17:$C$24)</c:f>
              <c:numCache>
                <c:formatCode>General</c:formatCode>
                <c:ptCount val="16"/>
                <c:pt idx="0">
                  <c:v>99.999999999999986</c:v>
                </c:pt>
                <c:pt idx="1">
                  <c:v>101.41058664210706</c:v>
                </c:pt>
                <c:pt idx="2">
                  <c:v>100.15359046108769</c:v>
                </c:pt>
                <c:pt idx="3">
                  <c:v>92.934394141518055</c:v>
                </c:pt>
                <c:pt idx="4">
                  <c:v>93.790335702754447</c:v>
                </c:pt>
                <c:pt idx="5">
                  <c:v>92.074811490789941</c:v>
                </c:pt>
                <c:pt idx="6">
                  <c:v>92.157401587081893</c:v>
                </c:pt>
                <c:pt idx="7">
                  <c:v>98.230144156878509</c:v>
                </c:pt>
                <c:pt idx="8">
                  <c:v>100</c:v>
                </c:pt>
                <c:pt idx="9">
                  <c:v>90.583459414754685</c:v>
                </c:pt>
                <c:pt idx="10">
                  <c:v>90.954197026416736</c:v>
                </c:pt>
                <c:pt idx="11">
                  <c:v>83.226162243225161</c:v>
                </c:pt>
                <c:pt idx="12">
                  <c:v>98.387762159418017</c:v>
                </c:pt>
                <c:pt idx="13">
                  <c:v>95.087672150725709</c:v>
                </c:pt>
                <c:pt idx="14">
                  <c:v>92.575111822535078</c:v>
                </c:pt>
                <c:pt idx="15">
                  <c:v>95.183533941609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8BA-4A40-93DF-57CB87527794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2!$E$17:$E$24</c:f>
                <c:numCache>
                  <c:formatCode>General</c:formatCode>
                  <c:ptCount val="8"/>
                  <c:pt idx="0">
                    <c:v>2.1065874771587709</c:v>
                  </c:pt>
                  <c:pt idx="1">
                    <c:v>1.8721723487219513</c:v>
                  </c:pt>
                  <c:pt idx="2">
                    <c:v>0.97276723494066875</c:v>
                  </c:pt>
                  <c:pt idx="3">
                    <c:v>3.1399228323187032</c:v>
                  </c:pt>
                  <c:pt idx="4">
                    <c:v>3.1487222239918804</c:v>
                  </c:pt>
                  <c:pt idx="5">
                    <c:v>2.2656133422998042</c:v>
                  </c:pt>
                  <c:pt idx="6">
                    <c:v>0.86630483274918268</c:v>
                  </c:pt>
                  <c:pt idx="7">
                    <c:v>2.0192223023689353</c:v>
                  </c:pt>
                </c:numCache>
              </c:numRef>
            </c:plus>
            <c:minus>
              <c:numRef>
                <c:f>[1]Sheet2!$E$17:$E$24</c:f>
                <c:numCache>
                  <c:formatCode>General</c:formatCode>
                  <c:ptCount val="8"/>
                  <c:pt idx="0">
                    <c:v>2.1065874771587709</c:v>
                  </c:pt>
                  <c:pt idx="1">
                    <c:v>1.8721723487219513</c:v>
                  </c:pt>
                  <c:pt idx="2">
                    <c:v>0.97276723494066875</c:v>
                  </c:pt>
                  <c:pt idx="3">
                    <c:v>3.1399228323187032</c:v>
                  </c:pt>
                  <c:pt idx="4">
                    <c:v>3.1487222239918804</c:v>
                  </c:pt>
                  <c:pt idx="5">
                    <c:v>2.2656133422998042</c:v>
                  </c:pt>
                  <c:pt idx="6">
                    <c:v>0.86630483274918268</c:v>
                  </c:pt>
                  <c:pt idx="7">
                    <c:v>2.019222302368935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2!$B$17:$B$2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2!$C$17:$C$24</c:f>
              <c:numCache>
                <c:formatCode>General</c:formatCode>
                <c:ptCount val="8"/>
                <c:pt idx="0">
                  <c:v>100</c:v>
                </c:pt>
                <c:pt idx="1">
                  <c:v>90.583459414754685</c:v>
                </c:pt>
                <c:pt idx="2">
                  <c:v>90.954197026416736</c:v>
                </c:pt>
                <c:pt idx="3">
                  <c:v>83.226162243225161</c:v>
                </c:pt>
                <c:pt idx="4">
                  <c:v>98.387762159418017</c:v>
                </c:pt>
                <c:pt idx="5">
                  <c:v>95.087672150725709</c:v>
                </c:pt>
                <c:pt idx="6">
                  <c:v>92.575111822535078</c:v>
                </c:pt>
                <c:pt idx="7">
                  <c:v>95.183533941609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8BA-4A40-93DF-57CB87527794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2!$E$28:$E$35</c:f>
                <c:numCache>
                  <c:formatCode>General</c:formatCode>
                  <c:ptCount val="8"/>
                  <c:pt idx="0">
                    <c:v>1.8350059875954643</c:v>
                  </c:pt>
                  <c:pt idx="1">
                    <c:v>1.8776574937648718</c:v>
                  </c:pt>
                  <c:pt idx="2">
                    <c:v>2.157562747977086</c:v>
                  </c:pt>
                  <c:pt idx="3">
                    <c:v>1.4433625987661192</c:v>
                  </c:pt>
                  <c:pt idx="4">
                    <c:v>2.540427520367762</c:v>
                  </c:pt>
                  <c:pt idx="5">
                    <c:v>3.4856194221670043</c:v>
                  </c:pt>
                  <c:pt idx="6">
                    <c:v>1.8485598264623495</c:v>
                  </c:pt>
                  <c:pt idx="7">
                    <c:v>0.8693235983826455</c:v>
                  </c:pt>
                </c:numCache>
              </c:numRef>
            </c:plus>
            <c:minus>
              <c:numRef>
                <c:f>[1]Sheet2!$E$28:$E$35</c:f>
                <c:numCache>
                  <c:formatCode>General</c:formatCode>
                  <c:ptCount val="8"/>
                  <c:pt idx="0">
                    <c:v>1.8350059875954643</c:v>
                  </c:pt>
                  <c:pt idx="1">
                    <c:v>1.8776574937648718</c:v>
                  </c:pt>
                  <c:pt idx="2">
                    <c:v>2.157562747977086</c:v>
                  </c:pt>
                  <c:pt idx="3">
                    <c:v>1.4433625987661192</c:v>
                  </c:pt>
                  <c:pt idx="4">
                    <c:v>2.540427520367762</c:v>
                  </c:pt>
                  <c:pt idx="5">
                    <c:v>3.4856194221670043</c:v>
                  </c:pt>
                  <c:pt idx="6">
                    <c:v>1.8485598264623495</c:v>
                  </c:pt>
                  <c:pt idx="7">
                    <c:v>0.869323598382645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2!$B$28:$B$3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2!$C$28:$C$35</c:f>
              <c:numCache>
                <c:formatCode>General</c:formatCode>
                <c:ptCount val="8"/>
                <c:pt idx="0">
                  <c:v>100.00000000000001</c:v>
                </c:pt>
                <c:pt idx="1">
                  <c:v>101.03717262529405</c:v>
                </c:pt>
                <c:pt idx="2">
                  <c:v>101.8436854233604</c:v>
                </c:pt>
                <c:pt idx="3">
                  <c:v>91.830688615899376</c:v>
                </c:pt>
                <c:pt idx="4">
                  <c:v>96.089589375357235</c:v>
                </c:pt>
                <c:pt idx="5">
                  <c:v>102.04660881356463</c:v>
                </c:pt>
                <c:pt idx="6">
                  <c:v>90.618350197922908</c:v>
                </c:pt>
                <c:pt idx="7">
                  <c:v>99.1925881778877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8BA-4A40-93DF-57CB875277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551775729615384"/>
          <c:y val="0.49646075673123929"/>
          <c:w val="0.36955796495477206"/>
          <c:h val="0.278736512102653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Tubastatin-A 1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184313725490196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600046535839991"/>
          <c:y val="0.13004629629629633"/>
          <c:w val="0.7877703229241505"/>
          <c:h val="0.67393664333624959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2]Sheet2!$E$4:$E$11</c:f>
                <c:numCache>
                  <c:formatCode>General</c:formatCode>
                  <c:ptCount val="8"/>
                  <c:pt idx="0">
                    <c:v>7.40096748759328</c:v>
                  </c:pt>
                  <c:pt idx="1">
                    <c:v>2.4102347504622328</c:v>
                  </c:pt>
                  <c:pt idx="2">
                    <c:v>0.52539518940165986</c:v>
                  </c:pt>
                  <c:pt idx="3">
                    <c:v>3.3482714172115191</c:v>
                  </c:pt>
                  <c:pt idx="4">
                    <c:v>2.5811571390934276</c:v>
                  </c:pt>
                  <c:pt idx="5">
                    <c:v>0.6491909704855805</c:v>
                  </c:pt>
                  <c:pt idx="6">
                    <c:v>1.2561587226417466</c:v>
                  </c:pt>
                  <c:pt idx="7">
                    <c:v>2.3412732877715441</c:v>
                  </c:pt>
                </c:numCache>
              </c:numRef>
            </c:plus>
            <c:minus>
              <c:numRef>
                <c:f>[2]Sheet2!$E$4:$E$11</c:f>
                <c:numCache>
                  <c:formatCode>General</c:formatCode>
                  <c:ptCount val="8"/>
                  <c:pt idx="0">
                    <c:v>7.40096748759328</c:v>
                  </c:pt>
                  <c:pt idx="1">
                    <c:v>2.4102347504622328</c:v>
                  </c:pt>
                  <c:pt idx="2">
                    <c:v>0.52539518940165986</c:v>
                  </c:pt>
                  <c:pt idx="3">
                    <c:v>3.3482714172115191</c:v>
                  </c:pt>
                  <c:pt idx="4">
                    <c:v>2.5811571390934276</c:v>
                  </c:pt>
                  <c:pt idx="5">
                    <c:v>0.6491909704855805</c:v>
                  </c:pt>
                  <c:pt idx="6">
                    <c:v>1.2561587226417466</c:v>
                  </c:pt>
                  <c:pt idx="7">
                    <c:v>2.341273287771544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2]Sheet2!$B$4:$B$11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2]Sheet2!$D$4:$D$11</c:f>
              <c:numCache>
                <c:formatCode>General</c:formatCode>
                <c:ptCount val="8"/>
                <c:pt idx="0">
                  <c:v>100.00000000000006</c:v>
                </c:pt>
                <c:pt idx="1">
                  <c:v>102.37798296105278</c:v>
                </c:pt>
                <c:pt idx="2">
                  <c:v>111.22568611290946</c:v>
                </c:pt>
                <c:pt idx="3">
                  <c:v>114.54921422937065</c:v>
                </c:pt>
                <c:pt idx="4">
                  <c:v>104.53640503739454</c:v>
                </c:pt>
                <c:pt idx="5">
                  <c:v>101.97408717397083</c:v>
                </c:pt>
                <c:pt idx="6">
                  <c:v>106.18904952455408</c:v>
                </c:pt>
                <c:pt idx="7">
                  <c:v>102.102391338995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A9F-4FCC-ABD0-3F2D931CA2DD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2]Sheet2!$E$15:$E$22</c:f>
                <c:numCache>
                  <c:formatCode>General</c:formatCode>
                  <c:ptCount val="8"/>
                  <c:pt idx="0">
                    <c:v>2.8302483911954335</c:v>
                  </c:pt>
                  <c:pt idx="1">
                    <c:v>1.2428227518875128</c:v>
                  </c:pt>
                  <c:pt idx="2">
                    <c:v>2.6256226785217893</c:v>
                  </c:pt>
                  <c:pt idx="3">
                    <c:v>2.8649967008889501</c:v>
                  </c:pt>
                  <c:pt idx="4">
                    <c:v>1.2279124965382262</c:v>
                  </c:pt>
                  <c:pt idx="5">
                    <c:v>1.6507610633136651</c:v>
                  </c:pt>
                  <c:pt idx="6">
                    <c:v>4.2478160977889585</c:v>
                  </c:pt>
                  <c:pt idx="7">
                    <c:v>2.6431413516272033</c:v>
                  </c:pt>
                </c:numCache>
              </c:numRef>
            </c:plus>
            <c:minus>
              <c:numRef>
                <c:f>[2]Sheet2!$E$15:$E$22</c:f>
                <c:numCache>
                  <c:formatCode>General</c:formatCode>
                  <c:ptCount val="8"/>
                  <c:pt idx="0">
                    <c:v>2.8302483911954335</c:v>
                  </c:pt>
                  <c:pt idx="1">
                    <c:v>1.2428227518875128</c:v>
                  </c:pt>
                  <c:pt idx="2">
                    <c:v>2.6256226785217893</c:v>
                  </c:pt>
                  <c:pt idx="3">
                    <c:v>2.8649967008889501</c:v>
                  </c:pt>
                  <c:pt idx="4">
                    <c:v>1.2279124965382262</c:v>
                  </c:pt>
                  <c:pt idx="5">
                    <c:v>1.6507610633136651</c:v>
                  </c:pt>
                  <c:pt idx="6">
                    <c:v>4.2478160977889585</c:v>
                  </c:pt>
                  <c:pt idx="7">
                    <c:v>2.643141351627203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2]Sheet2!$B$15:$B$2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2]Sheet2!$D$15:$D$22</c:f>
              <c:numCache>
                <c:formatCode>General</c:formatCode>
                <c:ptCount val="8"/>
                <c:pt idx="0">
                  <c:v>100.00000000000009</c:v>
                </c:pt>
                <c:pt idx="1">
                  <c:v>98.334265511303187</c:v>
                </c:pt>
                <c:pt idx="2">
                  <c:v>105.47245409372279</c:v>
                </c:pt>
                <c:pt idx="3">
                  <c:v>103.64549880262179</c:v>
                </c:pt>
                <c:pt idx="4">
                  <c:v>106.9044811144686</c:v>
                </c:pt>
                <c:pt idx="5">
                  <c:v>96.785587016084847</c:v>
                </c:pt>
                <c:pt idx="6">
                  <c:v>104.38810471200054</c:v>
                </c:pt>
                <c:pt idx="7">
                  <c:v>107.404859229812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A9F-4FCC-ABD0-3F2D931CA2DD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2]Sheet2!$E$26:$E$33</c:f>
                <c:numCache>
                  <c:formatCode>General</c:formatCode>
                  <c:ptCount val="8"/>
                  <c:pt idx="0">
                    <c:v>4.0290158185564975</c:v>
                  </c:pt>
                  <c:pt idx="1">
                    <c:v>3.1923586766288286</c:v>
                  </c:pt>
                  <c:pt idx="2">
                    <c:v>3.0345050483356775</c:v>
                  </c:pt>
                  <c:pt idx="3">
                    <c:v>1.5723886574140229</c:v>
                  </c:pt>
                  <c:pt idx="4">
                    <c:v>0.59606441342644523</c:v>
                  </c:pt>
                  <c:pt idx="5">
                    <c:v>1.1305721443794245</c:v>
                  </c:pt>
                  <c:pt idx="6">
                    <c:v>1.4289092394280682</c:v>
                  </c:pt>
                  <c:pt idx="7">
                    <c:v>2.5387484261770754</c:v>
                  </c:pt>
                </c:numCache>
              </c:numRef>
            </c:plus>
            <c:minus>
              <c:numRef>
                <c:f>[2]Sheet2!$E$26:$E$33</c:f>
                <c:numCache>
                  <c:formatCode>General</c:formatCode>
                  <c:ptCount val="8"/>
                  <c:pt idx="0">
                    <c:v>4.0290158185564975</c:v>
                  </c:pt>
                  <c:pt idx="1">
                    <c:v>3.1923586766288286</c:v>
                  </c:pt>
                  <c:pt idx="2">
                    <c:v>3.0345050483356775</c:v>
                  </c:pt>
                  <c:pt idx="3">
                    <c:v>1.5723886574140229</c:v>
                  </c:pt>
                  <c:pt idx="4">
                    <c:v>0.59606441342644523</c:v>
                  </c:pt>
                  <c:pt idx="5">
                    <c:v>1.1305721443794245</c:v>
                  </c:pt>
                  <c:pt idx="6">
                    <c:v>1.4289092394280682</c:v>
                  </c:pt>
                  <c:pt idx="7">
                    <c:v>2.5387484261770754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2]Sheet2!$B$26:$B$33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2]Sheet2!$D$26:$D$33</c:f>
              <c:numCache>
                <c:formatCode>General</c:formatCode>
                <c:ptCount val="8"/>
                <c:pt idx="0">
                  <c:v>100</c:v>
                </c:pt>
                <c:pt idx="1">
                  <c:v>104.52290312305772</c:v>
                </c:pt>
                <c:pt idx="2">
                  <c:v>101.58831808434583</c:v>
                </c:pt>
                <c:pt idx="3">
                  <c:v>103.96520903922145</c:v>
                </c:pt>
                <c:pt idx="4">
                  <c:v>100.72309383285464</c:v>
                </c:pt>
                <c:pt idx="5">
                  <c:v>111.05497346112767</c:v>
                </c:pt>
                <c:pt idx="6">
                  <c:v>96.115704605251736</c:v>
                </c:pt>
                <c:pt idx="7">
                  <c:v>103.452250373018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A9F-4FCC-ABD0-3F2D931CA2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0453038210049628"/>
          <c:y val="0.42155365995917177"/>
          <c:w val="0.42145708373300861"/>
          <c:h val="0.311143919510061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738 0.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184313725490196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950800267613606"/>
          <c:y val="0.13004629629629633"/>
          <c:w val="0.77426277597653237"/>
          <c:h val="0.67393664333624959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3]Sheet2!$D$4:$D$11</c:f>
                <c:numCache>
                  <c:formatCode>General</c:formatCode>
                  <c:ptCount val="8"/>
                  <c:pt idx="0">
                    <c:v>2.4892151970222494</c:v>
                  </c:pt>
                  <c:pt idx="1">
                    <c:v>1.3495519133471554</c:v>
                  </c:pt>
                  <c:pt idx="2">
                    <c:v>2.692192551514121</c:v>
                  </c:pt>
                  <c:pt idx="3">
                    <c:v>2.2860551995622638</c:v>
                  </c:pt>
                  <c:pt idx="4">
                    <c:v>0.70343480292515359</c:v>
                  </c:pt>
                  <c:pt idx="5">
                    <c:v>1.0337181448843553</c:v>
                  </c:pt>
                  <c:pt idx="6">
                    <c:v>1.7243858104737164</c:v>
                  </c:pt>
                  <c:pt idx="7">
                    <c:v>7.3120109869589154</c:v>
                  </c:pt>
                </c:numCache>
              </c:numRef>
            </c:plus>
            <c:minus>
              <c:numRef>
                <c:f>[3]Sheet2!$D$4:$D$11</c:f>
                <c:numCache>
                  <c:formatCode>General</c:formatCode>
                  <c:ptCount val="8"/>
                  <c:pt idx="0">
                    <c:v>2.4892151970222494</c:v>
                  </c:pt>
                  <c:pt idx="1">
                    <c:v>1.3495519133471554</c:v>
                  </c:pt>
                  <c:pt idx="2">
                    <c:v>2.692192551514121</c:v>
                  </c:pt>
                  <c:pt idx="3">
                    <c:v>2.2860551995622638</c:v>
                  </c:pt>
                  <c:pt idx="4">
                    <c:v>0.70343480292515359</c:v>
                  </c:pt>
                  <c:pt idx="5">
                    <c:v>1.0337181448843553</c:v>
                  </c:pt>
                  <c:pt idx="6">
                    <c:v>1.7243858104737164</c:v>
                  </c:pt>
                  <c:pt idx="7">
                    <c:v>7.3120109869589154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3]Sheet2!$B$4:$B$11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3]Sheet2!$C$4:$C$11</c:f>
              <c:numCache>
                <c:formatCode>General</c:formatCode>
                <c:ptCount val="8"/>
                <c:pt idx="0">
                  <c:v>100.00000000000009</c:v>
                </c:pt>
                <c:pt idx="1">
                  <c:v>117.29192248471828</c:v>
                </c:pt>
                <c:pt idx="2">
                  <c:v>122.50302470033016</c:v>
                </c:pt>
                <c:pt idx="3">
                  <c:v>115.10346233514952</c:v>
                </c:pt>
                <c:pt idx="4">
                  <c:v>119.52711883214944</c:v>
                </c:pt>
                <c:pt idx="5">
                  <c:v>124.69361107480658</c:v>
                </c:pt>
                <c:pt idx="6">
                  <c:v>129.21370047539793</c:v>
                </c:pt>
                <c:pt idx="7">
                  <c:v>121.54174758801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E34-4011-8AE8-31228729600D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3]Sheet2!$D$13:$D$20</c:f>
                <c:numCache>
                  <c:formatCode>General</c:formatCode>
                  <c:ptCount val="8"/>
                  <c:pt idx="0">
                    <c:v>3.1468035717462177</c:v>
                  </c:pt>
                  <c:pt idx="1">
                    <c:v>2.1994136267100082</c:v>
                  </c:pt>
                  <c:pt idx="2">
                    <c:v>1.340822148012685</c:v>
                  </c:pt>
                  <c:pt idx="3">
                    <c:v>3.6327925039780937</c:v>
                  </c:pt>
                  <c:pt idx="4">
                    <c:v>0.92464819476351734</c:v>
                  </c:pt>
                  <c:pt idx="5">
                    <c:v>1.8788380335015351</c:v>
                  </c:pt>
                  <c:pt idx="6">
                    <c:v>1.9960818440959549</c:v>
                  </c:pt>
                  <c:pt idx="7">
                    <c:v>4.0950037903238883</c:v>
                  </c:pt>
                </c:numCache>
              </c:numRef>
            </c:plus>
            <c:minus>
              <c:numRef>
                <c:f>[3]Sheet2!$D$13:$D$20</c:f>
                <c:numCache>
                  <c:formatCode>General</c:formatCode>
                  <c:ptCount val="8"/>
                  <c:pt idx="0">
                    <c:v>3.1468035717462177</c:v>
                  </c:pt>
                  <c:pt idx="1">
                    <c:v>2.1994136267100082</c:v>
                  </c:pt>
                  <c:pt idx="2">
                    <c:v>1.340822148012685</c:v>
                  </c:pt>
                  <c:pt idx="3">
                    <c:v>3.6327925039780937</c:v>
                  </c:pt>
                  <c:pt idx="4">
                    <c:v>0.92464819476351734</c:v>
                  </c:pt>
                  <c:pt idx="5">
                    <c:v>1.8788380335015351</c:v>
                  </c:pt>
                  <c:pt idx="6">
                    <c:v>1.9960818440959549</c:v>
                  </c:pt>
                  <c:pt idx="7">
                    <c:v>4.095003790323888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3]Sheet2!$B$13:$B$20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3]Sheet2!$C$13:$C$20</c:f>
              <c:numCache>
                <c:formatCode>General</c:formatCode>
                <c:ptCount val="8"/>
                <c:pt idx="0">
                  <c:v>100.00000000000001</c:v>
                </c:pt>
                <c:pt idx="1">
                  <c:v>115.05625919218681</c:v>
                </c:pt>
                <c:pt idx="2">
                  <c:v>109.52559769984326</c:v>
                </c:pt>
                <c:pt idx="3">
                  <c:v>112.32513766371271</c:v>
                </c:pt>
                <c:pt idx="4">
                  <c:v>131.91519883621942</c:v>
                </c:pt>
                <c:pt idx="5">
                  <c:v>115.93368487523681</c:v>
                </c:pt>
                <c:pt idx="6">
                  <c:v>123.50050323633688</c:v>
                </c:pt>
                <c:pt idx="7">
                  <c:v>131.152750145157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E34-4011-8AE8-31228729600D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3]Sheet2!$D$22:$D$29</c:f>
                <c:numCache>
                  <c:formatCode>General</c:formatCode>
                  <c:ptCount val="8"/>
                  <c:pt idx="0">
                    <c:v>4.1609205213885732</c:v>
                  </c:pt>
                  <c:pt idx="1">
                    <c:v>2.0126571717895403</c:v>
                  </c:pt>
                  <c:pt idx="2">
                    <c:v>0.95899241513183597</c:v>
                  </c:pt>
                  <c:pt idx="3">
                    <c:v>2.832158365488767</c:v>
                  </c:pt>
                  <c:pt idx="4">
                    <c:v>0.97737070407648852</c:v>
                  </c:pt>
                  <c:pt idx="5">
                    <c:v>2.972623175372334</c:v>
                  </c:pt>
                  <c:pt idx="6">
                    <c:v>5.583391295615332</c:v>
                  </c:pt>
                  <c:pt idx="7">
                    <c:v>1.9137851384374478</c:v>
                  </c:pt>
                </c:numCache>
              </c:numRef>
            </c:plus>
            <c:minus>
              <c:numRef>
                <c:f>[3]Sheet2!$D$22:$D$29</c:f>
                <c:numCache>
                  <c:formatCode>General</c:formatCode>
                  <c:ptCount val="8"/>
                  <c:pt idx="0">
                    <c:v>4.1609205213885732</c:v>
                  </c:pt>
                  <c:pt idx="1">
                    <c:v>2.0126571717895403</c:v>
                  </c:pt>
                  <c:pt idx="2">
                    <c:v>0.95899241513183597</c:v>
                  </c:pt>
                  <c:pt idx="3">
                    <c:v>2.832158365488767</c:v>
                  </c:pt>
                  <c:pt idx="4">
                    <c:v>0.97737070407648852</c:v>
                  </c:pt>
                  <c:pt idx="5">
                    <c:v>2.972623175372334</c:v>
                  </c:pt>
                  <c:pt idx="6">
                    <c:v>5.583391295615332</c:v>
                  </c:pt>
                  <c:pt idx="7">
                    <c:v>1.9137851384374478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3]Sheet2!$B$22:$B$2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3]Sheet2!$C$22:$C$29</c:f>
              <c:numCache>
                <c:formatCode>General</c:formatCode>
                <c:ptCount val="8"/>
                <c:pt idx="0">
                  <c:v>100.00000000000009</c:v>
                </c:pt>
                <c:pt idx="1">
                  <c:v>104.62035901473659</c:v>
                </c:pt>
                <c:pt idx="2">
                  <c:v>101.67862189887902</c:v>
                </c:pt>
                <c:pt idx="3">
                  <c:v>103.84886052956738</c:v>
                </c:pt>
                <c:pt idx="4">
                  <c:v>123.52224969792441</c:v>
                </c:pt>
                <c:pt idx="5">
                  <c:v>116.9765065718211</c:v>
                </c:pt>
                <c:pt idx="6">
                  <c:v>111.66470631411137</c:v>
                </c:pt>
                <c:pt idx="7">
                  <c:v>114.267556145988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E34-4011-8AE8-3122872960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3075313590499373"/>
          <c:y val="0.42155365995917177"/>
          <c:w val="0.39523425433995246"/>
          <c:h val="0.311143919510061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</a:t>
            </a:r>
            <a:r>
              <a:rPr lang="en-US" sz="1400" b="1" u="sng" baseline="0"/>
              <a:t>-738 1 </a:t>
            </a:r>
            <a:r>
              <a:rPr lang="en-US" sz="1400" b="1" u="sng" baseline="0">
                <a:latin typeface="Symbol" panose="05050102010706020507" pitchFamily="18" charset="2"/>
              </a:rPr>
              <a:t>m</a:t>
            </a:r>
            <a:r>
              <a:rPr lang="en-US" sz="1400" b="1" u="sng" baseline="0"/>
              <a:t>M</a:t>
            </a:r>
            <a:endParaRPr lang="en-US" sz="1400" b="1" u="sng"/>
          </a:p>
        </c:rich>
      </c:tx>
      <c:layout>
        <c:manualLayout>
          <c:xMode val="edge"/>
          <c:yMode val="edge"/>
          <c:x val="0.3184313725490196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850874716357667"/>
          <c:y val="0.13004629629629633"/>
          <c:w val="0.78526189206428876"/>
          <c:h val="0.67393664333624959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4]Sheet2!$E$4:$E$11</c:f>
                <c:numCache>
                  <c:formatCode>General</c:formatCode>
                  <c:ptCount val="8"/>
                  <c:pt idx="0">
                    <c:v>2.1868792095589202</c:v>
                  </c:pt>
                  <c:pt idx="1">
                    <c:v>2.8173421809932431</c:v>
                  </c:pt>
                  <c:pt idx="2">
                    <c:v>3.4129340846679233</c:v>
                  </c:pt>
                  <c:pt idx="3">
                    <c:v>1.7287680992036087</c:v>
                  </c:pt>
                  <c:pt idx="4">
                    <c:v>0.6783504963677478</c:v>
                  </c:pt>
                  <c:pt idx="5">
                    <c:v>2.7769520389041871</c:v>
                  </c:pt>
                  <c:pt idx="6">
                    <c:v>2.8779896761753219</c:v>
                  </c:pt>
                  <c:pt idx="7">
                    <c:v>4.8236401411544314</c:v>
                  </c:pt>
                </c:numCache>
              </c:numRef>
            </c:plus>
            <c:minus>
              <c:numRef>
                <c:f>[4]Sheet2!$E$4:$E$11</c:f>
                <c:numCache>
                  <c:formatCode>General</c:formatCode>
                  <c:ptCount val="8"/>
                  <c:pt idx="0">
                    <c:v>2.1868792095589202</c:v>
                  </c:pt>
                  <c:pt idx="1">
                    <c:v>2.8173421809932431</c:v>
                  </c:pt>
                  <c:pt idx="2">
                    <c:v>3.4129340846679233</c:v>
                  </c:pt>
                  <c:pt idx="3">
                    <c:v>1.7287680992036087</c:v>
                  </c:pt>
                  <c:pt idx="4">
                    <c:v>0.6783504963677478</c:v>
                  </c:pt>
                  <c:pt idx="5">
                    <c:v>2.7769520389041871</c:v>
                  </c:pt>
                  <c:pt idx="6">
                    <c:v>2.8779896761753219</c:v>
                  </c:pt>
                  <c:pt idx="7">
                    <c:v>4.8236401411544314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4]Sheet2!$B$4:$B$11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4]Sheet2!$C$4:$C$11</c:f>
              <c:numCache>
                <c:formatCode>General</c:formatCode>
                <c:ptCount val="8"/>
                <c:pt idx="0">
                  <c:v>99.999999999999915</c:v>
                </c:pt>
                <c:pt idx="1">
                  <c:v>105.97561015674063</c:v>
                </c:pt>
                <c:pt idx="2">
                  <c:v>98.439904886618535</c:v>
                </c:pt>
                <c:pt idx="3">
                  <c:v>103.18756592532819</c:v>
                </c:pt>
                <c:pt idx="4">
                  <c:v>100.44741261327226</c:v>
                </c:pt>
                <c:pt idx="5">
                  <c:v>104.0907930127786</c:v>
                </c:pt>
                <c:pt idx="6">
                  <c:v>108.57114426732984</c:v>
                </c:pt>
                <c:pt idx="7">
                  <c:v>102.713825471341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670-4B59-A750-36A40731DFD5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4]Sheet2!$E$13:$E$20</c:f>
                <c:numCache>
                  <c:formatCode>General</c:formatCode>
                  <c:ptCount val="8"/>
                  <c:pt idx="0">
                    <c:v>0.53666858844136756</c:v>
                  </c:pt>
                  <c:pt idx="1">
                    <c:v>1.6066095169011141</c:v>
                  </c:pt>
                  <c:pt idx="2">
                    <c:v>0.89663640141836165</c:v>
                  </c:pt>
                  <c:pt idx="3">
                    <c:v>1.6080827550229115</c:v>
                  </c:pt>
                  <c:pt idx="4">
                    <c:v>1.0090041209735978</c:v>
                  </c:pt>
                  <c:pt idx="5">
                    <c:v>1.9988155287200979</c:v>
                  </c:pt>
                  <c:pt idx="6">
                    <c:v>0.27610554219438893</c:v>
                  </c:pt>
                  <c:pt idx="7">
                    <c:v>0.86018747746082469</c:v>
                  </c:pt>
                </c:numCache>
              </c:numRef>
            </c:plus>
            <c:minus>
              <c:numRef>
                <c:f>[4]Sheet2!$E$13:$E$20</c:f>
                <c:numCache>
                  <c:formatCode>General</c:formatCode>
                  <c:ptCount val="8"/>
                  <c:pt idx="0">
                    <c:v>0.53666858844136756</c:v>
                  </c:pt>
                  <c:pt idx="1">
                    <c:v>1.6066095169011141</c:v>
                  </c:pt>
                  <c:pt idx="2">
                    <c:v>0.89663640141836165</c:v>
                  </c:pt>
                  <c:pt idx="3">
                    <c:v>1.6080827550229115</c:v>
                  </c:pt>
                  <c:pt idx="4">
                    <c:v>1.0090041209735978</c:v>
                  </c:pt>
                  <c:pt idx="5">
                    <c:v>1.9988155287200979</c:v>
                  </c:pt>
                  <c:pt idx="6">
                    <c:v>0.27610554219438893</c:v>
                  </c:pt>
                  <c:pt idx="7">
                    <c:v>0.8601874774608246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4]Sheet2!$B$13:$B$20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4]Sheet2!$C$13:$C$20</c:f>
              <c:numCache>
                <c:formatCode>General</c:formatCode>
                <c:ptCount val="8"/>
                <c:pt idx="0">
                  <c:v>100.00000000000001</c:v>
                </c:pt>
                <c:pt idx="1">
                  <c:v>107.48993629548369</c:v>
                </c:pt>
                <c:pt idx="2">
                  <c:v>112.81289852771306</c:v>
                </c:pt>
                <c:pt idx="3">
                  <c:v>106.35834917839607</c:v>
                </c:pt>
                <c:pt idx="4">
                  <c:v>111.27868080996338</c:v>
                </c:pt>
                <c:pt idx="5">
                  <c:v>119.90304486585528</c:v>
                </c:pt>
                <c:pt idx="6">
                  <c:v>113.92033465300273</c:v>
                </c:pt>
                <c:pt idx="7">
                  <c:v>109.529774177931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670-4B59-A750-36A40731DFD5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4]Sheet2!$E$22:$E$29</c:f>
                <c:numCache>
                  <c:formatCode>General</c:formatCode>
                  <c:ptCount val="8"/>
                  <c:pt idx="0">
                    <c:v>0.80481151198149148</c:v>
                  </c:pt>
                  <c:pt idx="1">
                    <c:v>2.7301471831756055</c:v>
                  </c:pt>
                  <c:pt idx="2">
                    <c:v>0.55510684656039788</c:v>
                  </c:pt>
                  <c:pt idx="3">
                    <c:v>1.3966540534667202</c:v>
                  </c:pt>
                  <c:pt idx="4">
                    <c:v>1.6919825142581202</c:v>
                  </c:pt>
                  <c:pt idx="5">
                    <c:v>0.97556842042427971</c:v>
                  </c:pt>
                  <c:pt idx="6">
                    <c:v>1.4461914320712423</c:v>
                  </c:pt>
                  <c:pt idx="7">
                    <c:v>4.1985723215138036</c:v>
                  </c:pt>
                </c:numCache>
              </c:numRef>
            </c:plus>
            <c:minus>
              <c:numRef>
                <c:f>[4]Sheet2!$E$22:$E$29</c:f>
                <c:numCache>
                  <c:formatCode>General</c:formatCode>
                  <c:ptCount val="8"/>
                  <c:pt idx="0">
                    <c:v>0.80481151198149148</c:v>
                  </c:pt>
                  <c:pt idx="1">
                    <c:v>2.7301471831756055</c:v>
                  </c:pt>
                  <c:pt idx="2">
                    <c:v>0.55510684656039788</c:v>
                  </c:pt>
                  <c:pt idx="3">
                    <c:v>1.3966540534667202</c:v>
                  </c:pt>
                  <c:pt idx="4">
                    <c:v>1.6919825142581202</c:v>
                  </c:pt>
                  <c:pt idx="5">
                    <c:v>0.97556842042427971</c:v>
                  </c:pt>
                  <c:pt idx="6">
                    <c:v>1.4461914320712423</c:v>
                  </c:pt>
                  <c:pt idx="7">
                    <c:v>4.198572321513803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4]Sheet2!$B$22:$B$2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4]Sheet2!$C$22:$C$29</c:f>
              <c:numCache>
                <c:formatCode>General</c:formatCode>
                <c:ptCount val="8"/>
                <c:pt idx="0">
                  <c:v>100</c:v>
                </c:pt>
                <c:pt idx="1">
                  <c:v>116.76761309968805</c:v>
                </c:pt>
                <c:pt idx="2">
                  <c:v>116.13339356453999</c:v>
                </c:pt>
                <c:pt idx="3">
                  <c:v>120.25838187659629</c:v>
                </c:pt>
                <c:pt idx="4">
                  <c:v>117.77560583132117</c:v>
                </c:pt>
                <c:pt idx="5">
                  <c:v>128.63611466684432</c:v>
                </c:pt>
                <c:pt idx="6">
                  <c:v>127.39345490003807</c:v>
                </c:pt>
                <c:pt idx="7">
                  <c:v>129.601958235200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670-4B59-A750-36A40731D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5426633862611621"/>
          <c:y val="0.49562773403324584"/>
          <c:w val="0.48346820542716085"/>
          <c:h val="0.278736512102653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>
                <a:latin typeface="Arial" panose="020B0604020202020204" pitchFamily="34" charset="0"/>
                <a:cs typeface="Arial" panose="020B0604020202020204" pitchFamily="34" charset="0"/>
              </a:rPr>
              <a:t>ACY-1215 0.3 </a:t>
            </a:r>
            <a:r>
              <a:rPr lang="en-US" sz="1400" b="1" u="sng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400" b="1" u="sng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c:rich>
      </c:tx>
      <c:layout>
        <c:manualLayout>
          <c:xMode val="edge"/>
          <c:yMode val="edge"/>
          <c:x val="0.3184313725490196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416599499865668"/>
          <c:y val="0.12630098204016635"/>
          <c:w val="0.76910616487899652"/>
          <c:h val="0.64716304057726226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5]Sheet2!$D$4:$D$11</c:f>
                <c:numCache>
                  <c:formatCode>General</c:formatCode>
                  <c:ptCount val="8"/>
                  <c:pt idx="0">
                    <c:v>4.6833856936268523</c:v>
                  </c:pt>
                  <c:pt idx="1">
                    <c:v>4.203642470653933</c:v>
                  </c:pt>
                  <c:pt idx="2">
                    <c:v>5.4311386620943098</c:v>
                  </c:pt>
                  <c:pt idx="3">
                    <c:v>0.62708880051188609</c:v>
                  </c:pt>
                  <c:pt idx="4">
                    <c:v>0.63630746789640114</c:v>
                  </c:pt>
                  <c:pt idx="5">
                    <c:v>4.9886541983412496</c:v>
                  </c:pt>
                  <c:pt idx="6">
                    <c:v>3.4624582037110745</c:v>
                  </c:pt>
                  <c:pt idx="7">
                    <c:v>3.4676590586215883</c:v>
                  </c:pt>
                </c:numCache>
              </c:numRef>
            </c:plus>
            <c:minus>
              <c:numRef>
                <c:f>[5]Sheet2!$D$4:$D$11</c:f>
                <c:numCache>
                  <c:formatCode>General</c:formatCode>
                  <c:ptCount val="8"/>
                  <c:pt idx="0">
                    <c:v>4.6833856936268523</c:v>
                  </c:pt>
                  <c:pt idx="1">
                    <c:v>4.203642470653933</c:v>
                  </c:pt>
                  <c:pt idx="2">
                    <c:v>5.4311386620943098</c:v>
                  </c:pt>
                  <c:pt idx="3">
                    <c:v>0.62708880051188609</c:v>
                  </c:pt>
                  <c:pt idx="4">
                    <c:v>0.63630746789640114</c:v>
                  </c:pt>
                  <c:pt idx="5">
                    <c:v>4.9886541983412496</c:v>
                  </c:pt>
                  <c:pt idx="6">
                    <c:v>3.4624582037110745</c:v>
                  </c:pt>
                  <c:pt idx="7">
                    <c:v>3.467659058621588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5]Sheet2!$B$4:$B$11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5]Sheet2!$C$4:$C$11</c:f>
              <c:numCache>
                <c:formatCode>General</c:formatCode>
                <c:ptCount val="8"/>
                <c:pt idx="0">
                  <c:v>99.999999999999901</c:v>
                </c:pt>
                <c:pt idx="1">
                  <c:v>109.08139873594334</c:v>
                </c:pt>
                <c:pt idx="2">
                  <c:v>103.39729943384874</c:v>
                </c:pt>
                <c:pt idx="3">
                  <c:v>103.62959405842709</c:v>
                </c:pt>
                <c:pt idx="4">
                  <c:v>119.00038177172856</c:v>
                </c:pt>
                <c:pt idx="5">
                  <c:v>118.62931981558073</c:v>
                </c:pt>
                <c:pt idx="6">
                  <c:v>111.28868528568255</c:v>
                </c:pt>
                <c:pt idx="7">
                  <c:v>106.737567062624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CD-41C6-94C7-333DFF928198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5]Sheet2!$D$13:$D$20</c:f>
                <c:numCache>
                  <c:formatCode>General</c:formatCode>
                  <c:ptCount val="8"/>
                  <c:pt idx="0">
                    <c:v>1.7197961608029462</c:v>
                  </c:pt>
                  <c:pt idx="1">
                    <c:v>1.7717762123461041</c:v>
                  </c:pt>
                  <c:pt idx="2">
                    <c:v>1.1823276840878014</c:v>
                  </c:pt>
                  <c:pt idx="3">
                    <c:v>1.0627495933935713</c:v>
                  </c:pt>
                  <c:pt idx="4">
                    <c:v>1.4827876046084458</c:v>
                  </c:pt>
                  <c:pt idx="5">
                    <c:v>3.4577331870867809</c:v>
                  </c:pt>
                  <c:pt idx="6">
                    <c:v>1.9512094241815963</c:v>
                  </c:pt>
                  <c:pt idx="7">
                    <c:v>0.66851724538267598</c:v>
                  </c:pt>
                </c:numCache>
              </c:numRef>
            </c:plus>
            <c:minus>
              <c:numRef>
                <c:f>[5]Sheet2!$D$13:$D$20</c:f>
                <c:numCache>
                  <c:formatCode>General</c:formatCode>
                  <c:ptCount val="8"/>
                  <c:pt idx="0">
                    <c:v>1.7197961608029462</c:v>
                  </c:pt>
                  <c:pt idx="1">
                    <c:v>1.7717762123461041</c:v>
                  </c:pt>
                  <c:pt idx="2">
                    <c:v>1.1823276840878014</c:v>
                  </c:pt>
                  <c:pt idx="3">
                    <c:v>1.0627495933935713</c:v>
                  </c:pt>
                  <c:pt idx="4">
                    <c:v>1.4827876046084458</c:v>
                  </c:pt>
                  <c:pt idx="5">
                    <c:v>3.4577331870867809</c:v>
                  </c:pt>
                  <c:pt idx="6">
                    <c:v>1.9512094241815963</c:v>
                  </c:pt>
                  <c:pt idx="7">
                    <c:v>0.66851724538267598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5]Sheet2!$B$13:$B$20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5]Sheet2!$C$13:$C$20</c:f>
              <c:numCache>
                <c:formatCode>General</c:formatCode>
                <c:ptCount val="8"/>
                <c:pt idx="0">
                  <c:v>100.0000000000001</c:v>
                </c:pt>
                <c:pt idx="1">
                  <c:v>105.19882922054077</c:v>
                </c:pt>
                <c:pt idx="2">
                  <c:v>102.22763738686984</c:v>
                </c:pt>
                <c:pt idx="3">
                  <c:v>103.4887490063502</c:v>
                </c:pt>
                <c:pt idx="4">
                  <c:v>118.28758366156029</c:v>
                </c:pt>
                <c:pt idx="5">
                  <c:v>103.28767552435627</c:v>
                </c:pt>
                <c:pt idx="6">
                  <c:v>101.9320292914021</c:v>
                </c:pt>
                <c:pt idx="7">
                  <c:v>100.600647981243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ACD-41C6-94C7-333DFF928198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5]Sheet2!$D$22:$D$29</c:f>
                <c:numCache>
                  <c:formatCode>General</c:formatCode>
                  <c:ptCount val="8"/>
                  <c:pt idx="0">
                    <c:v>3.6095809037161444</c:v>
                  </c:pt>
                  <c:pt idx="1">
                    <c:v>2.1445742886748849</c:v>
                  </c:pt>
                  <c:pt idx="2">
                    <c:v>2.1691498269540666</c:v>
                  </c:pt>
                  <c:pt idx="3">
                    <c:v>1.0740603324616342</c:v>
                  </c:pt>
                  <c:pt idx="4">
                    <c:v>2.188564464259418</c:v>
                  </c:pt>
                  <c:pt idx="5">
                    <c:v>0.54588211128370212</c:v>
                  </c:pt>
                  <c:pt idx="6">
                    <c:v>9.1169802663189365</c:v>
                  </c:pt>
                  <c:pt idx="7">
                    <c:v>3.846845552656327</c:v>
                  </c:pt>
                </c:numCache>
              </c:numRef>
            </c:plus>
            <c:minus>
              <c:numRef>
                <c:f>[5]Sheet2!$D$22:$D$29</c:f>
                <c:numCache>
                  <c:formatCode>General</c:formatCode>
                  <c:ptCount val="8"/>
                  <c:pt idx="0">
                    <c:v>3.6095809037161444</c:v>
                  </c:pt>
                  <c:pt idx="1">
                    <c:v>2.1445742886748849</c:v>
                  </c:pt>
                  <c:pt idx="2">
                    <c:v>2.1691498269540666</c:v>
                  </c:pt>
                  <c:pt idx="3">
                    <c:v>1.0740603324616342</c:v>
                  </c:pt>
                  <c:pt idx="4">
                    <c:v>2.188564464259418</c:v>
                  </c:pt>
                  <c:pt idx="5">
                    <c:v>0.54588211128370212</c:v>
                  </c:pt>
                  <c:pt idx="6">
                    <c:v>9.1169802663189365</c:v>
                  </c:pt>
                  <c:pt idx="7">
                    <c:v>3.84684555265632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5]Sheet2!$B$22:$B$2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5]Sheet2!$C$22:$C$29</c:f>
              <c:numCache>
                <c:formatCode>General</c:formatCode>
                <c:ptCount val="8"/>
                <c:pt idx="0">
                  <c:v>100.00000000000009</c:v>
                </c:pt>
                <c:pt idx="1">
                  <c:v>104.670730630299</c:v>
                </c:pt>
                <c:pt idx="2">
                  <c:v>106.00351370560195</c:v>
                </c:pt>
                <c:pt idx="3">
                  <c:v>103.41561938182457</c:v>
                </c:pt>
                <c:pt idx="4">
                  <c:v>112.80579607879093</c:v>
                </c:pt>
                <c:pt idx="5">
                  <c:v>100.62699187921019</c:v>
                </c:pt>
                <c:pt idx="6">
                  <c:v>111.98690281030754</c:v>
                </c:pt>
                <c:pt idx="7">
                  <c:v>107.432410667982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ACD-41C6-94C7-333DFF9281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b="1" dirty="0"/>
                  <a:t>Time</a:t>
                </a:r>
                <a:r>
                  <a:rPr lang="en-US" sz="1200" b="1" dirty="0"/>
                  <a:t> (h)</a:t>
                </a:r>
              </a:p>
            </c:rich>
          </c:tx>
          <c:layout>
            <c:manualLayout>
              <c:xMode val="edge"/>
              <c:yMode val="edge"/>
              <c:x val="0.40336794141578519"/>
              <c:y val="0.903794099080725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5181253051261194"/>
          <c:y val="0.42155365995917177"/>
          <c:w val="0.4741747762408462"/>
          <c:h val="0.288672033973281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1215 1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184313725490196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533239707761981"/>
          <c:y val="0.14663513033392023"/>
          <c:w val="0.79989880022512228"/>
          <c:h val="0.65396815090311067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6]Sheet2!$E$7:$E$14</c:f>
                <c:numCache>
                  <c:formatCode>General</c:formatCode>
                  <c:ptCount val="8"/>
                  <c:pt idx="0">
                    <c:v>3.1251531946070839</c:v>
                  </c:pt>
                  <c:pt idx="1">
                    <c:v>1.0766088535451188</c:v>
                  </c:pt>
                  <c:pt idx="2">
                    <c:v>0.30574479453143433</c:v>
                  </c:pt>
                  <c:pt idx="3">
                    <c:v>1.3741511387647223</c:v>
                  </c:pt>
                  <c:pt idx="4">
                    <c:v>2.2570528970936237</c:v>
                  </c:pt>
                  <c:pt idx="5">
                    <c:v>0.73873060014504666</c:v>
                  </c:pt>
                  <c:pt idx="6">
                    <c:v>0.21566776932475543</c:v>
                  </c:pt>
                  <c:pt idx="7">
                    <c:v>1.5954763548805784</c:v>
                  </c:pt>
                </c:numCache>
              </c:numRef>
            </c:plus>
            <c:minus>
              <c:numRef>
                <c:f>[6]Sheet2!$E$7:$E$14</c:f>
                <c:numCache>
                  <c:formatCode>General</c:formatCode>
                  <c:ptCount val="8"/>
                  <c:pt idx="0">
                    <c:v>3.1251531946070839</c:v>
                  </c:pt>
                  <c:pt idx="1">
                    <c:v>1.0766088535451188</c:v>
                  </c:pt>
                  <c:pt idx="2">
                    <c:v>0.30574479453143433</c:v>
                  </c:pt>
                  <c:pt idx="3">
                    <c:v>1.3741511387647223</c:v>
                  </c:pt>
                  <c:pt idx="4">
                    <c:v>2.2570528970936237</c:v>
                  </c:pt>
                  <c:pt idx="5">
                    <c:v>0.73873060014504666</c:v>
                  </c:pt>
                  <c:pt idx="6">
                    <c:v>0.21566776932475543</c:v>
                  </c:pt>
                  <c:pt idx="7">
                    <c:v>1.5954763548805784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6]Sheet2!$B$7:$B$14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6]Sheet2!$C$7:$C$14</c:f>
              <c:numCache>
                <c:formatCode>General</c:formatCode>
                <c:ptCount val="8"/>
                <c:pt idx="0">
                  <c:v>99.999999999999929</c:v>
                </c:pt>
                <c:pt idx="1">
                  <c:v>101.70096642094494</c:v>
                </c:pt>
                <c:pt idx="2">
                  <c:v>102.8155739766768</c:v>
                </c:pt>
                <c:pt idx="3">
                  <c:v>107.50168512855841</c:v>
                </c:pt>
                <c:pt idx="4">
                  <c:v>108.66590889071024</c:v>
                </c:pt>
                <c:pt idx="5">
                  <c:v>106.6424194990484</c:v>
                </c:pt>
                <c:pt idx="6">
                  <c:v>115.25049987047494</c:v>
                </c:pt>
                <c:pt idx="7">
                  <c:v>116.876449680435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428-4C6A-96F1-724F19D5E0BD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6]Sheet2!$E$18:$E$25</c:f>
                <c:numCache>
                  <c:formatCode>General</c:formatCode>
                  <c:ptCount val="8"/>
                  <c:pt idx="0">
                    <c:v>3.8999959656852425</c:v>
                  </c:pt>
                  <c:pt idx="1">
                    <c:v>0.97837596785711589</c:v>
                  </c:pt>
                  <c:pt idx="2">
                    <c:v>0.28836501026340577</c:v>
                  </c:pt>
                  <c:pt idx="3">
                    <c:v>0.88263989546209798</c:v>
                  </c:pt>
                  <c:pt idx="4">
                    <c:v>1.1263281105288787</c:v>
                  </c:pt>
                  <c:pt idx="5">
                    <c:v>6.7523943942322484</c:v>
                  </c:pt>
                  <c:pt idx="6">
                    <c:v>0.5766301877417862</c:v>
                  </c:pt>
                  <c:pt idx="7">
                    <c:v>2.3889417961605233</c:v>
                  </c:pt>
                </c:numCache>
              </c:numRef>
            </c:plus>
            <c:minus>
              <c:numRef>
                <c:f>[6]Sheet2!$E$18:$E$25</c:f>
                <c:numCache>
                  <c:formatCode>General</c:formatCode>
                  <c:ptCount val="8"/>
                  <c:pt idx="0">
                    <c:v>3.8999959656852425</c:v>
                  </c:pt>
                  <c:pt idx="1">
                    <c:v>0.97837596785711589</c:v>
                  </c:pt>
                  <c:pt idx="2">
                    <c:v>0.28836501026340577</c:v>
                  </c:pt>
                  <c:pt idx="3">
                    <c:v>0.88263989546209798</c:v>
                  </c:pt>
                  <c:pt idx="4">
                    <c:v>1.1263281105288787</c:v>
                  </c:pt>
                  <c:pt idx="5">
                    <c:v>6.7523943942322484</c:v>
                  </c:pt>
                  <c:pt idx="6">
                    <c:v>0.5766301877417862</c:v>
                  </c:pt>
                  <c:pt idx="7">
                    <c:v>2.388941796160523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6]Sheet2!$B$18:$B$2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6]Sheet2!$C$18:$C$25</c:f>
              <c:numCache>
                <c:formatCode>General</c:formatCode>
                <c:ptCount val="8"/>
                <c:pt idx="0">
                  <c:v>100</c:v>
                </c:pt>
                <c:pt idx="1">
                  <c:v>93.485923014450663</c:v>
                </c:pt>
                <c:pt idx="2">
                  <c:v>94.46255553009297</c:v>
                </c:pt>
                <c:pt idx="3">
                  <c:v>97.717356806510324</c:v>
                </c:pt>
                <c:pt idx="4">
                  <c:v>97.380036031753846</c:v>
                </c:pt>
                <c:pt idx="5">
                  <c:v>104.2631768453298</c:v>
                </c:pt>
                <c:pt idx="6">
                  <c:v>115.74099592601573</c:v>
                </c:pt>
                <c:pt idx="7">
                  <c:v>117.74785887739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428-4C6A-96F1-724F19D5E0BD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6]Sheet2!$E$29:$E$36</c:f>
                <c:numCache>
                  <c:formatCode>General</c:formatCode>
                  <c:ptCount val="8"/>
                  <c:pt idx="0">
                    <c:v>2.2901824209138981</c:v>
                  </c:pt>
                  <c:pt idx="1">
                    <c:v>2.091267950007925</c:v>
                  </c:pt>
                  <c:pt idx="2">
                    <c:v>1.2527085735871366</c:v>
                  </c:pt>
                  <c:pt idx="3">
                    <c:v>0.96158256206917536</c:v>
                  </c:pt>
                  <c:pt idx="4">
                    <c:v>2.1933903074208185</c:v>
                  </c:pt>
                  <c:pt idx="5">
                    <c:v>5.1039449087383177</c:v>
                  </c:pt>
                  <c:pt idx="6">
                    <c:v>0.20276312192830445</c:v>
                  </c:pt>
                  <c:pt idx="7">
                    <c:v>1.996050572270355</c:v>
                  </c:pt>
                </c:numCache>
              </c:numRef>
            </c:plus>
            <c:minus>
              <c:numRef>
                <c:f>[6]Sheet2!$E$29:$E$36</c:f>
                <c:numCache>
                  <c:formatCode>General</c:formatCode>
                  <c:ptCount val="8"/>
                  <c:pt idx="0">
                    <c:v>2.2901824209138981</c:v>
                  </c:pt>
                  <c:pt idx="1">
                    <c:v>2.091267950007925</c:v>
                  </c:pt>
                  <c:pt idx="2">
                    <c:v>1.2527085735871366</c:v>
                  </c:pt>
                  <c:pt idx="3">
                    <c:v>0.96158256206917536</c:v>
                  </c:pt>
                  <c:pt idx="4">
                    <c:v>2.1933903074208185</c:v>
                  </c:pt>
                  <c:pt idx="5">
                    <c:v>5.1039449087383177</c:v>
                  </c:pt>
                  <c:pt idx="6">
                    <c:v>0.20276312192830445</c:v>
                  </c:pt>
                  <c:pt idx="7">
                    <c:v>1.99605057227035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6]Sheet2!$B$29:$B$36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6]Sheet2!$C$29:$C$36</c:f>
              <c:numCache>
                <c:formatCode>General</c:formatCode>
                <c:ptCount val="8"/>
                <c:pt idx="0">
                  <c:v>100.00000000000004</c:v>
                </c:pt>
                <c:pt idx="1">
                  <c:v>88.18202159761239</c:v>
                </c:pt>
                <c:pt idx="2">
                  <c:v>85.830282818586255</c:v>
                </c:pt>
                <c:pt idx="3">
                  <c:v>92.094173327879275</c:v>
                </c:pt>
                <c:pt idx="4">
                  <c:v>93.437922123814545</c:v>
                </c:pt>
                <c:pt idx="5">
                  <c:v>98.55006237951963</c:v>
                </c:pt>
                <c:pt idx="6">
                  <c:v>110.94719498212389</c:v>
                </c:pt>
                <c:pt idx="7">
                  <c:v>108.306256755392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428-4C6A-96F1-724F19D5E0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ime (h)</a:t>
                </a:r>
              </a:p>
            </c:rich>
          </c:tx>
          <c:layout>
            <c:manualLayout>
              <c:xMode val="edge"/>
              <c:yMode val="edge"/>
              <c:x val="0.40672463036308831"/>
              <c:y val="0.907541359029838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335050326931224"/>
          <c:y val="0.43544254884806066"/>
          <c:w val="0.37032921082574072"/>
          <c:h val="0.269477252843394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Tubastatin-A 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3903151367823992"/>
          <c:y val="4.6296296296296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882414698162729"/>
          <c:y val="0.13004629629629633"/>
          <c:w val="0.78494677165354332"/>
          <c:h val="0.67393664333624959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E$5:$E$13</c:f>
                <c:numCache>
                  <c:formatCode>General</c:formatCode>
                  <c:ptCount val="9"/>
                  <c:pt idx="0">
                    <c:v>3.3188103121596182</c:v>
                  </c:pt>
                  <c:pt idx="1">
                    <c:v>2.3885347356220588</c:v>
                  </c:pt>
                  <c:pt idx="2">
                    <c:v>1.4417822048805391</c:v>
                  </c:pt>
                  <c:pt idx="3">
                    <c:v>0.63002119877821627</c:v>
                  </c:pt>
                  <c:pt idx="4">
                    <c:v>1.1435672468725835</c:v>
                  </c:pt>
                  <c:pt idx="5">
                    <c:v>0.69988286644793651</c:v>
                  </c:pt>
                  <c:pt idx="6">
                    <c:v>5.4631675562779991</c:v>
                  </c:pt>
                  <c:pt idx="7">
                    <c:v>1.3935779518325766</c:v>
                  </c:pt>
                  <c:pt idx="8">
                    <c:v>1.7410534637829131</c:v>
                  </c:pt>
                </c:numCache>
              </c:numRef>
            </c:plus>
            <c:minus>
              <c:numRef>
                <c:f>[7]Sheet1!$E$5:$E$13</c:f>
                <c:numCache>
                  <c:formatCode>General</c:formatCode>
                  <c:ptCount val="9"/>
                  <c:pt idx="0">
                    <c:v>3.3188103121596182</c:v>
                  </c:pt>
                  <c:pt idx="1">
                    <c:v>2.3885347356220588</c:v>
                  </c:pt>
                  <c:pt idx="2">
                    <c:v>1.4417822048805391</c:v>
                  </c:pt>
                  <c:pt idx="3">
                    <c:v>0.63002119877821627</c:v>
                  </c:pt>
                  <c:pt idx="4">
                    <c:v>1.1435672468725835</c:v>
                  </c:pt>
                  <c:pt idx="5">
                    <c:v>0.69988286644793651</c:v>
                  </c:pt>
                  <c:pt idx="6">
                    <c:v>5.4631675562779991</c:v>
                  </c:pt>
                  <c:pt idx="7">
                    <c:v>1.3935779518325766</c:v>
                  </c:pt>
                  <c:pt idx="8">
                    <c:v>1.741053463782913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C$5:$C$1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D$5:$D$12</c:f>
              <c:numCache>
                <c:formatCode>General</c:formatCode>
                <c:ptCount val="8"/>
                <c:pt idx="0">
                  <c:v>100.00000000000003</c:v>
                </c:pt>
                <c:pt idx="1">
                  <c:v>103.0352780664019</c:v>
                </c:pt>
                <c:pt idx="2">
                  <c:v>117.68633931126922</c:v>
                </c:pt>
                <c:pt idx="3">
                  <c:v>116.00191354075997</c:v>
                </c:pt>
                <c:pt idx="4">
                  <c:v>119.69531020555763</c:v>
                </c:pt>
                <c:pt idx="5">
                  <c:v>114.92698492859961</c:v>
                </c:pt>
                <c:pt idx="6">
                  <c:v>122.59908656193862</c:v>
                </c:pt>
                <c:pt idx="7">
                  <c:v>109.40130085874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829-43EB-A34A-5EEEF7AC461F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I$5:$I$13</c:f>
                <c:numCache>
                  <c:formatCode>General</c:formatCode>
                  <c:ptCount val="9"/>
                  <c:pt idx="0">
                    <c:v>1.2178019845260801</c:v>
                  </c:pt>
                  <c:pt idx="1">
                    <c:v>0.99808811525562524</c:v>
                  </c:pt>
                  <c:pt idx="2">
                    <c:v>1.2798090698833582</c:v>
                  </c:pt>
                  <c:pt idx="3">
                    <c:v>2.3921672904098847</c:v>
                  </c:pt>
                  <c:pt idx="4">
                    <c:v>1.2574784438115816</c:v>
                  </c:pt>
                  <c:pt idx="5">
                    <c:v>0.81444678886710731</c:v>
                  </c:pt>
                  <c:pt idx="6">
                    <c:v>1.0093335105165047</c:v>
                  </c:pt>
                  <c:pt idx="7">
                    <c:v>1.0869154878413616</c:v>
                  </c:pt>
                  <c:pt idx="8">
                    <c:v>1.2053409765365402</c:v>
                  </c:pt>
                </c:numCache>
              </c:numRef>
            </c:plus>
            <c:minus>
              <c:numRef>
                <c:f>[7]Sheet1!$I$5:$I$13</c:f>
                <c:numCache>
                  <c:formatCode>General</c:formatCode>
                  <c:ptCount val="9"/>
                  <c:pt idx="0">
                    <c:v>1.2178019845260801</c:v>
                  </c:pt>
                  <c:pt idx="1">
                    <c:v>0.99808811525562524</c:v>
                  </c:pt>
                  <c:pt idx="2">
                    <c:v>1.2798090698833582</c:v>
                  </c:pt>
                  <c:pt idx="3">
                    <c:v>2.3921672904098847</c:v>
                  </c:pt>
                  <c:pt idx="4">
                    <c:v>1.2574784438115816</c:v>
                  </c:pt>
                  <c:pt idx="5">
                    <c:v>0.81444678886710731</c:v>
                  </c:pt>
                  <c:pt idx="6">
                    <c:v>1.0093335105165047</c:v>
                  </c:pt>
                  <c:pt idx="7">
                    <c:v>1.0869154878413616</c:v>
                  </c:pt>
                  <c:pt idx="8">
                    <c:v>1.205340976536540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G$5:$G$1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H$5:$H$12</c:f>
              <c:numCache>
                <c:formatCode>General</c:formatCode>
                <c:ptCount val="8"/>
                <c:pt idx="0">
                  <c:v>99.999999999999787</c:v>
                </c:pt>
                <c:pt idx="1">
                  <c:v>104.62986469243799</c:v>
                </c:pt>
                <c:pt idx="2">
                  <c:v>123.23212036388479</c:v>
                </c:pt>
                <c:pt idx="3">
                  <c:v>125.69394413487254</c:v>
                </c:pt>
                <c:pt idx="4">
                  <c:v>127.50390416468362</c:v>
                </c:pt>
                <c:pt idx="5">
                  <c:v>120.55803841530826</c:v>
                </c:pt>
                <c:pt idx="6">
                  <c:v>132.66439481477994</c:v>
                </c:pt>
                <c:pt idx="7">
                  <c:v>127.283972003054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829-43EB-A34A-5EEEF7AC461F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M$5:$M$13</c:f>
                <c:numCache>
                  <c:formatCode>General</c:formatCode>
                  <c:ptCount val="9"/>
                  <c:pt idx="0">
                    <c:v>1.6936539349316524</c:v>
                  </c:pt>
                  <c:pt idx="1">
                    <c:v>0.29845394324441277</c:v>
                  </c:pt>
                  <c:pt idx="2">
                    <c:v>0.89348112159263504</c:v>
                  </c:pt>
                  <c:pt idx="3">
                    <c:v>2.6336475403165536</c:v>
                  </c:pt>
                  <c:pt idx="4">
                    <c:v>1.9605226069824326</c:v>
                  </c:pt>
                  <c:pt idx="5">
                    <c:v>2.6331738198098917</c:v>
                  </c:pt>
                  <c:pt idx="6">
                    <c:v>2.1316864135337603</c:v>
                  </c:pt>
                  <c:pt idx="7">
                    <c:v>2.4630828017208031</c:v>
                  </c:pt>
                  <c:pt idx="8">
                    <c:v>1.5055011805091623</c:v>
                  </c:pt>
                </c:numCache>
              </c:numRef>
            </c:plus>
            <c:minus>
              <c:numRef>
                <c:f>[7]Sheet1!$M$5:$M$13</c:f>
                <c:numCache>
                  <c:formatCode>General</c:formatCode>
                  <c:ptCount val="9"/>
                  <c:pt idx="0">
                    <c:v>1.6936539349316524</c:v>
                  </c:pt>
                  <c:pt idx="1">
                    <c:v>0.29845394324441277</c:v>
                  </c:pt>
                  <c:pt idx="2">
                    <c:v>0.89348112159263504</c:v>
                  </c:pt>
                  <c:pt idx="3">
                    <c:v>2.6336475403165536</c:v>
                  </c:pt>
                  <c:pt idx="4">
                    <c:v>1.9605226069824326</c:v>
                  </c:pt>
                  <c:pt idx="5">
                    <c:v>2.6331738198098917</c:v>
                  </c:pt>
                  <c:pt idx="6">
                    <c:v>2.1316864135337603</c:v>
                  </c:pt>
                  <c:pt idx="7">
                    <c:v>2.4630828017208031</c:v>
                  </c:pt>
                  <c:pt idx="8">
                    <c:v>1.505501180509162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K$5:$K$1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L$5:$L$12</c:f>
              <c:numCache>
                <c:formatCode>General</c:formatCode>
                <c:ptCount val="8"/>
                <c:pt idx="0">
                  <c:v>100.00000000000044</c:v>
                </c:pt>
                <c:pt idx="1">
                  <c:v>97.977021848908208</c:v>
                </c:pt>
                <c:pt idx="2">
                  <c:v>114.61836648657321</c:v>
                </c:pt>
                <c:pt idx="3">
                  <c:v>113.02610610270875</c:v>
                </c:pt>
                <c:pt idx="4">
                  <c:v>108.37457045734567</c:v>
                </c:pt>
                <c:pt idx="5">
                  <c:v>110.69895078197584</c:v>
                </c:pt>
                <c:pt idx="6">
                  <c:v>113.61272521776935</c:v>
                </c:pt>
                <c:pt idx="7">
                  <c:v>110.722148618871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829-43EB-A34A-5EEEF7AC46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318580867046797"/>
          <c:y val="0.4585906969962088"/>
          <c:w val="0.39345268048390508"/>
          <c:h val="0.311143919510061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738 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3903151367823992"/>
          <c:y val="4.6296296296296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349081364829396"/>
          <c:y val="0.13004629629629633"/>
          <c:w val="0.79028010498687662"/>
          <c:h val="0.67393664333624959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E$18:$E$26</c:f>
                <c:numCache>
                  <c:formatCode>General</c:formatCode>
                  <c:ptCount val="9"/>
                  <c:pt idx="0">
                    <c:v>1.2676752316947588</c:v>
                  </c:pt>
                  <c:pt idx="1">
                    <c:v>1.9280391811552235</c:v>
                  </c:pt>
                  <c:pt idx="2">
                    <c:v>1.6857893977709093</c:v>
                  </c:pt>
                  <c:pt idx="3">
                    <c:v>0.90388789985908957</c:v>
                  </c:pt>
                  <c:pt idx="4">
                    <c:v>1.0739124137418066</c:v>
                  </c:pt>
                  <c:pt idx="5">
                    <c:v>1.8148603800675904</c:v>
                  </c:pt>
                  <c:pt idx="6">
                    <c:v>0.88862077766454872</c:v>
                  </c:pt>
                  <c:pt idx="7">
                    <c:v>1.1561492906691293</c:v>
                  </c:pt>
                  <c:pt idx="8">
                    <c:v>0.70185455448969136</c:v>
                  </c:pt>
                </c:numCache>
              </c:numRef>
            </c:plus>
            <c:minus>
              <c:numRef>
                <c:f>[7]Sheet1!$E$18:$E$26</c:f>
                <c:numCache>
                  <c:formatCode>General</c:formatCode>
                  <c:ptCount val="9"/>
                  <c:pt idx="0">
                    <c:v>1.2676752316947588</c:v>
                  </c:pt>
                  <c:pt idx="1">
                    <c:v>1.9280391811552235</c:v>
                  </c:pt>
                  <c:pt idx="2">
                    <c:v>1.6857893977709093</c:v>
                  </c:pt>
                  <c:pt idx="3">
                    <c:v>0.90388789985908957</c:v>
                  </c:pt>
                  <c:pt idx="4">
                    <c:v>1.0739124137418066</c:v>
                  </c:pt>
                  <c:pt idx="5">
                    <c:v>1.8148603800675904</c:v>
                  </c:pt>
                  <c:pt idx="6">
                    <c:v>0.88862077766454872</c:v>
                  </c:pt>
                  <c:pt idx="7">
                    <c:v>1.1561492906691293</c:v>
                  </c:pt>
                  <c:pt idx="8">
                    <c:v>0.7018545544896913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C$18:$C$2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D$18:$D$25</c:f>
              <c:numCache>
                <c:formatCode>General</c:formatCode>
                <c:ptCount val="8"/>
                <c:pt idx="0">
                  <c:v>100.00000000000007</c:v>
                </c:pt>
                <c:pt idx="1">
                  <c:v>104.57420322264556</c:v>
                </c:pt>
                <c:pt idx="2">
                  <c:v>118.24370164269497</c:v>
                </c:pt>
                <c:pt idx="3">
                  <c:v>117.14855752463772</c:v>
                </c:pt>
                <c:pt idx="4">
                  <c:v>118.4320582932219</c:v>
                </c:pt>
                <c:pt idx="5">
                  <c:v>111.78162863029482</c:v>
                </c:pt>
                <c:pt idx="6">
                  <c:v>95.150769965155661</c:v>
                </c:pt>
                <c:pt idx="7">
                  <c:v>93.4700919731177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BD6-4032-8F82-CAE3A195CEE6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I$18:$I$26</c:f>
                <c:numCache>
                  <c:formatCode>General</c:formatCode>
                  <c:ptCount val="9"/>
                  <c:pt idx="0">
                    <c:v>1.5497675814775016</c:v>
                  </c:pt>
                  <c:pt idx="1">
                    <c:v>1.1283224100401108</c:v>
                  </c:pt>
                  <c:pt idx="2">
                    <c:v>1.4719612077242772</c:v>
                  </c:pt>
                  <c:pt idx="3">
                    <c:v>1.6702043034502818</c:v>
                  </c:pt>
                  <c:pt idx="4">
                    <c:v>1.8463812866241376</c:v>
                  </c:pt>
                  <c:pt idx="5">
                    <c:v>2.5726786414878742</c:v>
                  </c:pt>
                  <c:pt idx="6">
                    <c:v>2.1096564776691551</c:v>
                  </c:pt>
                  <c:pt idx="7">
                    <c:v>0.48585232090933</c:v>
                  </c:pt>
                  <c:pt idx="8">
                    <c:v>1.5950780411052756</c:v>
                  </c:pt>
                </c:numCache>
              </c:numRef>
            </c:plus>
            <c:minus>
              <c:numRef>
                <c:f>[7]Sheet1!$I$18:$I$26</c:f>
                <c:numCache>
                  <c:formatCode>General</c:formatCode>
                  <c:ptCount val="9"/>
                  <c:pt idx="0">
                    <c:v>1.5497675814775016</c:v>
                  </c:pt>
                  <c:pt idx="1">
                    <c:v>1.1283224100401108</c:v>
                  </c:pt>
                  <c:pt idx="2">
                    <c:v>1.4719612077242772</c:v>
                  </c:pt>
                  <c:pt idx="3">
                    <c:v>1.6702043034502818</c:v>
                  </c:pt>
                  <c:pt idx="4">
                    <c:v>1.8463812866241376</c:v>
                  </c:pt>
                  <c:pt idx="5">
                    <c:v>2.5726786414878742</c:v>
                  </c:pt>
                  <c:pt idx="6">
                    <c:v>2.1096564776691551</c:v>
                  </c:pt>
                  <c:pt idx="7">
                    <c:v>0.48585232090933</c:v>
                  </c:pt>
                  <c:pt idx="8">
                    <c:v>1.595078041105275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G$18:$G$2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H$18:$H$25</c:f>
              <c:numCache>
                <c:formatCode>General</c:formatCode>
                <c:ptCount val="8"/>
                <c:pt idx="0">
                  <c:v>100.00000000000041</c:v>
                </c:pt>
                <c:pt idx="1">
                  <c:v>97.936726479662994</c:v>
                </c:pt>
                <c:pt idx="2">
                  <c:v>109.27230337835542</c:v>
                </c:pt>
                <c:pt idx="3">
                  <c:v>106.68583888986915</c:v>
                </c:pt>
                <c:pt idx="4">
                  <c:v>103.29096306223401</c:v>
                </c:pt>
                <c:pt idx="5">
                  <c:v>104.57113141177321</c:v>
                </c:pt>
                <c:pt idx="6">
                  <c:v>103.91110616225697</c:v>
                </c:pt>
                <c:pt idx="7">
                  <c:v>98.691123534959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BD6-4032-8F82-CAE3A195CEE6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M$18:$M$26</c:f>
                <c:numCache>
                  <c:formatCode>General</c:formatCode>
                  <c:ptCount val="9"/>
                  <c:pt idx="0">
                    <c:v>1.8705460061962327</c:v>
                  </c:pt>
                  <c:pt idx="1">
                    <c:v>2.3664950272755969</c:v>
                  </c:pt>
                  <c:pt idx="2">
                    <c:v>3.6390568240640291</c:v>
                  </c:pt>
                  <c:pt idx="3">
                    <c:v>2.7724301652548156</c:v>
                  </c:pt>
                  <c:pt idx="4">
                    <c:v>2.3108671631265496</c:v>
                  </c:pt>
                  <c:pt idx="5">
                    <c:v>3.5421886293668927</c:v>
                  </c:pt>
                  <c:pt idx="6">
                    <c:v>1.3444319381306464</c:v>
                  </c:pt>
                  <c:pt idx="7">
                    <c:v>2.0621966465709187</c:v>
                  </c:pt>
                  <c:pt idx="8">
                    <c:v>1.1202376704776251</c:v>
                  </c:pt>
                </c:numCache>
              </c:numRef>
            </c:plus>
            <c:minus>
              <c:numRef>
                <c:f>[7]Sheet1!$M$18:$M$26</c:f>
                <c:numCache>
                  <c:formatCode>General</c:formatCode>
                  <c:ptCount val="9"/>
                  <c:pt idx="0">
                    <c:v>1.8705460061962327</c:v>
                  </c:pt>
                  <c:pt idx="1">
                    <c:v>2.3664950272755969</c:v>
                  </c:pt>
                  <c:pt idx="2">
                    <c:v>3.6390568240640291</c:v>
                  </c:pt>
                  <c:pt idx="3">
                    <c:v>2.7724301652548156</c:v>
                  </c:pt>
                  <c:pt idx="4">
                    <c:v>2.3108671631265496</c:v>
                  </c:pt>
                  <c:pt idx="5">
                    <c:v>3.5421886293668927</c:v>
                  </c:pt>
                  <c:pt idx="6">
                    <c:v>1.3444319381306464</c:v>
                  </c:pt>
                  <c:pt idx="7">
                    <c:v>2.0621966465709187</c:v>
                  </c:pt>
                  <c:pt idx="8">
                    <c:v>1.120237670477625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K$18:$K$2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L$18:$L$25</c:f>
              <c:numCache>
                <c:formatCode>General</c:formatCode>
                <c:ptCount val="8"/>
                <c:pt idx="0">
                  <c:v>100.00000000000003</c:v>
                </c:pt>
                <c:pt idx="1">
                  <c:v>96.388925866396022</c:v>
                </c:pt>
                <c:pt idx="2">
                  <c:v>98.555677662860532</c:v>
                </c:pt>
                <c:pt idx="3">
                  <c:v>99.472776728061589</c:v>
                </c:pt>
                <c:pt idx="4">
                  <c:v>90.079866881122513</c:v>
                </c:pt>
                <c:pt idx="5">
                  <c:v>89.307403185017108</c:v>
                </c:pt>
                <c:pt idx="6">
                  <c:v>85.436793559461549</c:v>
                </c:pt>
                <c:pt idx="7">
                  <c:v>82.4649349897062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BD6-4032-8F82-CAE3A195C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318580867046797"/>
          <c:y val="0.4585906969962088"/>
          <c:w val="0.39345268048390508"/>
          <c:h val="0.311143919510061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1215 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3903151367823992"/>
          <c:y val="4.6296296296296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086671800755448"/>
          <c:y val="0.13004629629629633"/>
          <c:w val="0.79290406064511398"/>
          <c:h val="0.64180833790450653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E$32:$E$40</c:f>
                <c:numCache>
                  <c:formatCode>General</c:formatCode>
                  <c:ptCount val="9"/>
                  <c:pt idx="0">
                    <c:v>0.87403634200000002</c:v>
                  </c:pt>
                  <c:pt idx="1">
                    <c:v>1.9178172710000001</c:v>
                  </c:pt>
                  <c:pt idx="2">
                    <c:v>0.73941863900000004</c:v>
                  </c:pt>
                  <c:pt idx="3">
                    <c:v>1.318779725</c:v>
                  </c:pt>
                  <c:pt idx="4">
                    <c:v>0.85968654600000005</c:v>
                  </c:pt>
                  <c:pt idx="5">
                    <c:v>0.90448616800000003</c:v>
                  </c:pt>
                  <c:pt idx="6">
                    <c:v>0.79117965099999998</c:v>
                  </c:pt>
                  <c:pt idx="7">
                    <c:v>0.31309573600000001</c:v>
                  </c:pt>
                  <c:pt idx="8">
                    <c:v>1.7002304859999999</c:v>
                  </c:pt>
                </c:numCache>
              </c:numRef>
            </c:plus>
            <c:minus>
              <c:numRef>
                <c:f>[7]Sheet1!$E$32:$E$40</c:f>
                <c:numCache>
                  <c:formatCode>General</c:formatCode>
                  <c:ptCount val="9"/>
                  <c:pt idx="0">
                    <c:v>0.87403634200000002</c:v>
                  </c:pt>
                  <c:pt idx="1">
                    <c:v>1.9178172710000001</c:v>
                  </c:pt>
                  <c:pt idx="2">
                    <c:v>0.73941863900000004</c:v>
                  </c:pt>
                  <c:pt idx="3">
                    <c:v>1.318779725</c:v>
                  </c:pt>
                  <c:pt idx="4">
                    <c:v>0.85968654600000005</c:v>
                  </c:pt>
                  <c:pt idx="5">
                    <c:v>0.90448616800000003</c:v>
                  </c:pt>
                  <c:pt idx="6">
                    <c:v>0.79117965099999998</c:v>
                  </c:pt>
                  <c:pt idx="7">
                    <c:v>0.31309573600000001</c:v>
                  </c:pt>
                  <c:pt idx="8">
                    <c:v>1.700230485999999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C$32:$C$3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D$32:$D$39</c:f>
              <c:numCache>
                <c:formatCode>General</c:formatCode>
                <c:ptCount val="8"/>
                <c:pt idx="0">
                  <c:v>100</c:v>
                </c:pt>
                <c:pt idx="1">
                  <c:v>97.384665589999997</c:v>
                </c:pt>
                <c:pt idx="2">
                  <c:v>101.26676689999999</c:v>
                </c:pt>
                <c:pt idx="3">
                  <c:v>103.8637004</c:v>
                </c:pt>
                <c:pt idx="4">
                  <c:v>104.65282449999999</c:v>
                </c:pt>
                <c:pt idx="5">
                  <c:v>100.469722</c:v>
                </c:pt>
                <c:pt idx="6">
                  <c:v>94.500151610000003</c:v>
                </c:pt>
                <c:pt idx="7">
                  <c:v>98.48743505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4E9-45EB-932F-3D18F07648C4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I$32:$I$40</c:f>
                <c:numCache>
                  <c:formatCode>General</c:formatCode>
                  <c:ptCount val="9"/>
                  <c:pt idx="0">
                    <c:v>0.53935852348070668</c:v>
                  </c:pt>
                  <c:pt idx="1">
                    <c:v>2.4279505593931319</c:v>
                  </c:pt>
                  <c:pt idx="2">
                    <c:v>1.9761008863765799</c:v>
                  </c:pt>
                  <c:pt idx="3">
                    <c:v>2.1206643059299299</c:v>
                  </c:pt>
                  <c:pt idx="4">
                    <c:v>2.2145185289021985</c:v>
                  </c:pt>
                  <c:pt idx="5">
                    <c:v>2.9257155311972869</c:v>
                  </c:pt>
                  <c:pt idx="6">
                    <c:v>2.0775030490046738</c:v>
                  </c:pt>
                  <c:pt idx="7">
                    <c:v>1.6001647190809103</c:v>
                  </c:pt>
                  <c:pt idx="8">
                    <c:v>1.6317863658795415</c:v>
                  </c:pt>
                </c:numCache>
              </c:numRef>
            </c:plus>
            <c:minus>
              <c:numRef>
                <c:f>[7]Sheet1!$I$32:$I$40</c:f>
                <c:numCache>
                  <c:formatCode>General</c:formatCode>
                  <c:ptCount val="9"/>
                  <c:pt idx="0">
                    <c:v>0.53935852348070668</c:v>
                  </c:pt>
                  <c:pt idx="1">
                    <c:v>2.4279505593931319</c:v>
                  </c:pt>
                  <c:pt idx="2">
                    <c:v>1.9761008863765799</c:v>
                  </c:pt>
                  <c:pt idx="3">
                    <c:v>2.1206643059299299</c:v>
                  </c:pt>
                  <c:pt idx="4">
                    <c:v>2.2145185289021985</c:v>
                  </c:pt>
                  <c:pt idx="5">
                    <c:v>2.9257155311972869</c:v>
                  </c:pt>
                  <c:pt idx="6">
                    <c:v>2.0775030490046738</c:v>
                  </c:pt>
                  <c:pt idx="7">
                    <c:v>1.6001647190809103</c:v>
                  </c:pt>
                  <c:pt idx="8">
                    <c:v>1.631786365879541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G$32:$G$3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H$32:$H$39</c:f>
              <c:numCache>
                <c:formatCode>General</c:formatCode>
                <c:ptCount val="8"/>
                <c:pt idx="0">
                  <c:v>99.999999999999957</c:v>
                </c:pt>
                <c:pt idx="1">
                  <c:v>100.68013100751216</c:v>
                </c:pt>
                <c:pt idx="2">
                  <c:v>111.98583385590511</c:v>
                </c:pt>
                <c:pt idx="3">
                  <c:v>110.24827836404171</c:v>
                </c:pt>
                <c:pt idx="4">
                  <c:v>107.68148143596262</c:v>
                </c:pt>
                <c:pt idx="5">
                  <c:v>103.12781226282445</c:v>
                </c:pt>
                <c:pt idx="6">
                  <c:v>101.52548385878218</c:v>
                </c:pt>
                <c:pt idx="7">
                  <c:v>97.8012037550041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4E9-45EB-932F-3D18F07648C4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7]Sheet1!$M$32:$M$40</c:f>
                <c:numCache>
                  <c:formatCode>General</c:formatCode>
                  <c:ptCount val="9"/>
                  <c:pt idx="0">
                    <c:v>1.2132530355012585</c:v>
                  </c:pt>
                  <c:pt idx="1">
                    <c:v>0.78639012321548729</c:v>
                  </c:pt>
                  <c:pt idx="2">
                    <c:v>2.062035556026129</c:v>
                  </c:pt>
                  <c:pt idx="3">
                    <c:v>1.1277584924638586</c:v>
                  </c:pt>
                  <c:pt idx="4">
                    <c:v>1.1615218731374255</c:v>
                  </c:pt>
                  <c:pt idx="5">
                    <c:v>1.7866003443160126</c:v>
                  </c:pt>
                  <c:pt idx="6">
                    <c:v>1.4071297002942724</c:v>
                  </c:pt>
                  <c:pt idx="7">
                    <c:v>2.2180375149333065</c:v>
                  </c:pt>
                  <c:pt idx="8">
                    <c:v>3.9023237580748269</c:v>
                  </c:pt>
                </c:numCache>
              </c:numRef>
            </c:plus>
            <c:minus>
              <c:numRef>
                <c:f>[7]Sheet1!$M$32:$M$40</c:f>
                <c:numCache>
                  <c:formatCode>General</c:formatCode>
                  <c:ptCount val="9"/>
                  <c:pt idx="0">
                    <c:v>1.2132530355012585</c:v>
                  </c:pt>
                  <c:pt idx="1">
                    <c:v>0.78639012321548729</c:v>
                  </c:pt>
                  <c:pt idx="2">
                    <c:v>2.062035556026129</c:v>
                  </c:pt>
                  <c:pt idx="3">
                    <c:v>1.1277584924638586</c:v>
                  </c:pt>
                  <c:pt idx="4">
                    <c:v>1.1615218731374255</c:v>
                  </c:pt>
                  <c:pt idx="5">
                    <c:v>1.7866003443160126</c:v>
                  </c:pt>
                  <c:pt idx="6">
                    <c:v>1.4071297002942724</c:v>
                  </c:pt>
                  <c:pt idx="7">
                    <c:v>2.2180375149333065</c:v>
                  </c:pt>
                  <c:pt idx="8">
                    <c:v>3.902323758074826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7]Sheet1!$K$32:$K$39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7]Sheet1!$L$32:$L$39</c:f>
              <c:numCache>
                <c:formatCode>General</c:formatCode>
                <c:ptCount val="8"/>
                <c:pt idx="0">
                  <c:v>99.999999999999901</c:v>
                </c:pt>
                <c:pt idx="1">
                  <c:v>100.1507392134896</c:v>
                </c:pt>
                <c:pt idx="2">
                  <c:v>109.05786473301863</c:v>
                </c:pt>
                <c:pt idx="3">
                  <c:v>106.8031299005666</c:v>
                </c:pt>
                <c:pt idx="4">
                  <c:v>101.6377505334836</c:v>
                </c:pt>
                <c:pt idx="5">
                  <c:v>102.03540774210667</c:v>
                </c:pt>
                <c:pt idx="6">
                  <c:v>97.8083740906808</c:v>
                </c:pt>
                <c:pt idx="7">
                  <c:v>94.9091674849858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4E9-45EB-932F-3D18F07648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ime (h)</a:t>
                </a:r>
              </a:p>
            </c:rich>
          </c:tx>
          <c:layout>
            <c:manualLayout>
              <c:xMode val="edge"/>
              <c:yMode val="edge"/>
              <c:x val="0.41868934047914669"/>
              <c:y val="0.888497311644653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318580867046797"/>
          <c:y val="0.4585906969962088"/>
          <c:w val="0.39345268048390508"/>
          <c:h val="0.23617822642971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675767503095302"/>
          <c:y val="7.0187201219806775E-2"/>
          <c:w val="0.80044904322968236"/>
          <c:h val="0.74584255867197535"/>
        </c:manualLayout>
      </c:layout>
      <c:scatterChart>
        <c:scatterStyle val="lineMarker"/>
        <c:varyColors val="0"/>
        <c:ser>
          <c:idx val="2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46:$R$50</c:f>
                <c:numCache>
                  <c:formatCode>General</c:formatCode>
                  <c:ptCount val="5"/>
                  <c:pt idx="0">
                    <c:v>3.5446301242765292</c:v>
                  </c:pt>
                  <c:pt idx="1">
                    <c:v>1.2623742737275578</c:v>
                  </c:pt>
                  <c:pt idx="2">
                    <c:v>1.4269513157209972</c:v>
                  </c:pt>
                  <c:pt idx="3">
                    <c:v>2.2398596351718707</c:v>
                  </c:pt>
                  <c:pt idx="4">
                    <c:v>1.9636510383931909</c:v>
                  </c:pt>
                </c:numCache>
              </c:numRef>
            </c:plus>
            <c:minus>
              <c:numRef>
                <c:f>Sheet3!$R$46:$R$50</c:f>
                <c:numCache>
                  <c:formatCode>General</c:formatCode>
                  <c:ptCount val="5"/>
                  <c:pt idx="0">
                    <c:v>3.5446301242765292</c:v>
                  </c:pt>
                  <c:pt idx="1">
                    <c:v>1.2623742737275578</c:v>
                  </c:pt>
                  <c:pt idx="2">
                    <c:v>1.4269513157209972</c:v>
                  </c:pt>
                  <c:pt idx="3">
                    <c:v>2.2398596351718707</c:v>
                  </c:pt>
                  <c:pt idx="4">
                    <c:v>1.963651038393190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Sheet3!$O$26:$O$3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46:$P$50</c:f>
              <c:numCache>
                <c:formatCode>General</c:formatCode>
                <c:ptCount val="5"/>
                <c:pt idx="0">
                  <c:v>100</c:v>
                </c:pt>
                <c:pt idx="1">
                  <c:v>27.087440673510855</c:v>
                </c:pt>
                <c:pt idx="2">
                  <c:v>21.479826447959827</c:v>
                </c:pt>
                <c:pt idx="3">
                  <c:v>19.681551440223377</c:v>
                </c:pt>
                <c:pt idx="4">
                  <c:v>18.5359088035426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ECA-4533-8AB2-CC978C91BDB4}"/>
            </c:ext>
          </c:extLst>
        </c:ser>
        <c:ser>
          <c:idx val="0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6:$R$10</c:f>
                <c:numCache>
                  <c:formatCode>General</c:formatCode>
                  <c:ptCount val="5"/>
                  <c:pt idx="0">
                    <c:v>1.9393452191180369</c:v>
                  </c:pt>
                  <c:pt idx="1">
                    <c:v>3.6790974167051371</c:v>
                  </c:pt>
                  <c:pt idx="2">
                    <c:v>3.00917609204734</c:v>
                  </c:pt>
                  <c:pt idx="3">
                    <c:v>2.4583958657184168</c:v>
                  </c:pt>
                  <c:pt idx="4">
                    <c:v>3.1690382947943512</c:v>
                  </c:pt>
                </c:numCache>
              </c:numRef>
            </c:plus>
            <c:minus>
              <c:numRef>
                <c:f>Sheet3!$R$6:$R$10</c:f>
                <c:numCache>
                  <c:formatCode>General</c:formatCode>
                  <c:ptCount val="5"/>
                  <c:pt idx="0">
                    <c:v>1.9393452191180369</c:v>
                  </c:pt>
                  <c:pt idx="1">
                    <c:v>3.6790974167051371</c:v>
                  </c:pt>
                  <c:pt idx="2">
                    <c:v>3.00917609204734</c:v>
                  </c:pt>
                  <c:pt idx="3">
                    <c:v>2.4583958657184168</c:v>
                  </c:pt>
                  <c:pt idx="4">
                    <c:v>3.1690382947943512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3!$O$6:$O$1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(Sheet3!$P$6:$P$10,Sheet3!$P$12:$P$16)</c:f>
              <c:numCache>
                <c:formatCode>General</c:formatCode>
                <c:ptCount val="10"/>
                <c:pt idx="0">
                  <c:v>100</c:v>
                </c:pt>
                <c:pt idx="1">
                  <c:v>37.682547908633722</c:v>
                </c:pt>
                <c:pt idx="2">
                  <c:v>31.349805992823249</c:v>
                </c:pt>
                <c:pt idx="3">
                  <c:v>25.405318437577691</c:v>
                </c:pt>
                <c:pt idx="4">
                  <c:v>24.054832710329141</c:v>
                </c:pt>
                <c:pt idx="5">
                  <c:v>99.999999999999915</c:v>
                </c:pt>
                <c:pt idx="6">
                  <c:v>56.129125882958256</c:v>
                </c:pt>
                <c:pt idx="7">
                  <c:v>28.228427796560695</c:v>
                </c:pt>
                <c:pt idx="8">
                  <c:v>49.159525097929297</c:v>
                </c:pt>
                <c:pt idx="9">
                  <c:v>48.4018226482881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ECA-4533-8AB2-CC978C91BDB4}"/>
            </c:ext>
          </c:extLst>
        </c:ser>
        <c:ser>
          <c:idx val="1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26:$R$30</c:f>
                <c:numCache>
                  <c:formatCode>General</c:formatCode>
                  <c:ptCount val="5"/>
                  <c:pt idx="0">
                    <c:v>1.4631513896759172</c:v>
                  </c:pt>
                  <c:pt idx="1">
                    <c:v>4.6015023243961855</c:v>
                  </c:pt>
                  <c:pt idx="2">
                    <c:v>0.90346023067204384</c:v>
                  </c:pt>
                  <c:pt idx="3">
                    <c:v>1.148479326599559</c:v>
                  </c:pt>
                  <c:pt idx="4">
                    <c:v>1.3350200630232707</c:v>
                  </c:pt>
                </c:numCache>
              </c:numRef>
            </c:plus>
            <c:minus>
              <c:numRef>
                <c:f>Sheet3!$R$26:$R$30</c:f>
                <c:numCache>
                  <c:formatCode>General</c:formatCode>
                  <c:ptCount val="5"/>
                  <c:pt idx="0">
                    <c:v>1.4631513896759172</c:v>
                  </c:pt>
                  <c:pt idx="1">
                    <c:v>4.6015023243961855</c:v>
                  </c:pt>
                  <c:pt idx="2">
                    <c:v>0.90346023067204384</c:v>
                  </c:pt>
                  <c:pt idx="3">
                    <c:v>1.148479326599559</c:v>
                  </c:pt>
                  <c:pt idx="4">
                    <c:v>1.335020063023270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Sheet3!$O$26:$O$3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26:$P$30</c:f>
              <c:numCache>
                <c:formatCode>General</c:formatCode>
                <c:ptCount val="5"/>
                <c:pt idx="0">
                  <c:v>100</c:v>
                </c:pt>
                <c:pt idx="1">
                  <c:v>39.171295688010758</c:v>
                </c:pt>
                <c:pt idx="2">
                  <c:v>34.241169547035838</c:v>
                </c:pt>
                <c:pt idx="3">
                  <c:v>31.579297113348062</c:v>
                </c:pt>
                <c:pt idx="4">
                  <c:v>32.1267587128214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ECA-4533-8AB2-CC978C91BD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 dirty="0" err="1"/>
                  <a:t>Romidepsin</a:t>
                </a:r>
                <a:r>
                  <a:rPr lang="en-US" b="1" dirty="0"/>
                  <a:t> (</a:t>
                </a:r>
                <a:r>
                  <a:rPr lang="en-US" b="1" dirty="0">
                    <a:latin typeface="Symbol" panose="05050102010706020507" pitchFamily="18" charset="2"/>
                  </a:rPr>
                  <a:t>m</a:t>
                </a:r>
                <a:r>
                  <a:rPr lang="en-US" b="1" dirty="0"/>
                  <a:t>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"/>
      </c:val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90210784222044"/>
          <c:y val="0.16274465691788526"/>
          <c:w val="0.39345268048390508"/>
          <c:h val="0.24358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" lastClr="FFFFFF"/>
      </a:solidFill>
      <a:round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738 0.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502088078375899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697787698157662"/>
          <c:y val="0.13004629629629633"/>
          <c:w val="0.79703782026849856"/>
          <c:h val="0.66801360693184741"/>
        </c:manualLayout>
      </c:layout>
      <c:scatterChart>
        <c:scatterStyle val="lineMarker"/>
        <c:varyColors val="0"/>
        <c:ser>
          <c:idx val="0"/>
          <c:order val="0"/>
          <c:tx>
            <c:v>RPMI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X$17:$X$24</c:f>
                <c:numCache>
                  <c:formatCode>General</c:formatCode>
                  <c:ptCount val="8"/>
                  <c:pt idx="0">
                    <c:v>0.65225850792479223</c:v>
                  </c:pt>
                  <c:pt idx="1">
                    <c:v>4.8002175773549274</c:v>
                  </c:pt>
                  <c:pt idx="2">
                    <c:v>1.0631742780349116</c:v>
                  </c:pt>
                  <c:pt idx="3">
                    <c:v>3.461984148524317</c:v>
                  </c:pt>
                  <c:pt idx="4">
                    <c:v>1.6475043506974065</c:v>
                  </c:pt>
                  <c:pt idx="5">
                    <c:v>2.4562568993468146</c:v>
                  </c:pt>
                  <c:pt idx="6">
                    <c:v>0.7218812435851355</c:v>
                  </c:pt>
                  <c:pt idx="7">
                    <c:v>4.1119056329235191</c:v>
                  </c:pt>
                </c:numCache>
              </c:numRef>
            </c:plus>
            <c:minus>
              <c:numRef>
                <c:f>[1]Sheet1!$X$17:$X$24</c:f>
                <c:numCache>
                  <c:formatCode>General</c:formatCode>
                  <c:ptCount val="8"/>
                  <c:pt idx="0">
                    <c:v>0.65225850792479223</c:v>
                  </c:pt>
                  <c:pt idx="1">
                    <c:v>4.8002175773549274</c:v>
                  </c:pt>
                  <c:pt idx="2">
                    <c:v>1.0631742780349116</c:v>
                  </c:pt>
                  <c:pt idx="3">
                    <c:v>3.461984148524317</c:v>
                  </c:pt>
                  <c:pt idx="4">
                    <c:v>1.6475043506974065</c:v>
                  </c:pt>
                  <c:pt idx="5">
                    <c:v>2.4562568993468146</c:v>
                  </c:pt>
                  <c:pt idx="6">
                    <c:v>0.7218812435851355</c:v>
                  </c:pt>
                  <c:pt idx="7">
                    <c:v>4.111905632923519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V$17:$V$24</c:f>
              <c:numCache>
                <c:formatCode>General</c:formatCode>
                <c:ptCount val="8"/>
                <c:pt idx="0">
                  <c:v>172.57562087448861</c:v>
                </c:pt>
                <c:pt idx="1">
                  <c:v>122.2612110879638</c:v>
                </c:pt>
                <c:pt idx="2">
                  <c:v>111.68974330599825</c:v>
                </c:pt>
                <c:pt idx="3">
                  <c:v>115.18158104959886</c:v>
                </c:pt>
                <c:pt idx="4">
                  <c:v>128.19678083670843</c:v>
                </c:pt>
                <c:pt idx="5">
                  <c:v>97.223183247728727</c:v>
                </c:pt>
                <c:pt idx="6">
                  <c:v>102.06920915920874</c:v>
                </c:pt>
                <c:pt idx="7">
                  <c:v>99.9999999999996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B38-4554-A913-6F3E3003A128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G$17:$AG$24</c:f>
                <c:numCache>
                  <c:formatCode>General</c:formatCode>
                  <c:ptCount val="8"/>
                  <c:pt idx="0">
                    <c:v>0.15919451745415505</c:v>
                  </c:pt>
                  <c:pt idx="1">
                    <c:v>2.0047896728483416</c:v>
                  </c:pt>
                  <c:pt idx="2">
                    <c:v>1.1743488523493104</c:v>
                  </c:pt>
                  <c:pt idx="3">
                    <c:v>0.50789956799318026</c:v>
                  </c:pt>
                  <c:pt idx="4">
                    <c:v>1.1038635892603634</c:v>
                  </c:pt>
                  <c:pt idx="5">
                    <c:v>4.5702328463022681</c:v>
                  </c:pt>
                  <c:pt idx="6">
                    <c:v>0.19412541598727773</c:v>
                  </c:pt>
                  <c:pt idx="7">
                    <c:v>3.3769922779483008</c:v>
                  </c:pt>
                </c:numCache>
              </c:numRef>
            </c:plus>
            <c:minus>
              <c:numRef>
                <c:f>[1]Sheet1!$AG$17:$AG$24</c:f>
                <c:numCache>
                  <c:formatCode>General</c:formatCode>
                  <c:ptCount val="8"/>
                  <c:pt idx="0">
                    <c:v>0.15919451745415505</c:v>
                  </c:pt>
                  <c:pt idx="1">
                    <c:v>2.0047896728483416</c:v>
                  </c:pt>
                  <c:pt idx="2">
                    <c:v>1.1743488523493104</c:v>
                  </c:pt>
                  <c:pt idx="3">
                    <c:v>0.50789956799318026</c:v>
                  </c:pt>
                  <c:pt idx="4">
                    <c:v>1.1038635892603634</c:v>
                  </c:pt>
                  <c:pt idx="5">
                    <c:v>4.5702328463022681</c:v>
                  </c:pt>
                  <c:pt idx="6">
                    <c:v>0.19412541598727773</c:v>
                  </c:pt>
                  <c:pt idx="7">
                    <c:v>3.3769922779483008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E$17:$AE$24</c:f>
              <c:numCache>
                <c:formatCode>General</c:formatCode>
                <c:ptCount val="8"/>
                <c:pt idx="0">
                  <c:v>181.04267747687649</c:v>
                </c:pt>
                <c:pt idx="1">
                  <c:v>168.05093942848791</c:v>
                </c:pt>
                <c:pt idx="2">
                  <c:v>148.46637903147916</c:v>
                </c:pt>
                <c:pt idx="3">
                  <c:v>147.80324375905766</c:v>
                </c:pt>
                <c:pt idx="4">
                  <c:v>140.78629771638646</c:v>
                </c:pt>
                <c:pt idx="5">
                  <c:v>99.434213416201331</c:v>
                </c:pt>
                <c:pt idx="6">
                  <c:v>103.30509619345476</c:v>
                </c:pt>
                <c:pt idx="7">
                  <c:v>99.9999999999999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B38-4554-A913-6F3E3003A128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O$17:$AO$24</c:f>
                <c:numCache>
                  <c:formatCode>General</c:formatCode>
                  <c:ptCount val="8"/>
                  <c:pt idx="0">
                    <c:v>1.4261716957012149</c:v>
                  </c:pt>
                  <c:pt idx="1">
                    <c:v>3.0486992752016104</c:v>
                  </c:pt>
                  <c:pt idx="2">
                    <c:v>0.98530809542559605</c:v>
                  </c:pt>
                  <c:pt idx="3">
                    <c:v>3.4305016035323139</c:v>
                  </c:pt>
                  <c:pt idx="4">
                    <c:v>1.9068163740240656</c:v>
                  </c:pt>
                  <c:pt idx="5">
                    <c:v>0.92781356379054403</c:v>
                  </c:pt>
                  <c:pt idx="6">
                    <c:v>1.8822965226821629</c:v>
                  </c:pt>
                  <c:pt idx="7">
                    <c:v>0.79733918483934885</c:v>
                  </c:pt>
                </c:numCache>
              </c:numRef>
            </c:plus>
            <c:minus>
              <c:numRef>
                <c:f>[1]Sheet1!$AO$17:$AO$24</c:f>
                <c:numCache>
                  <c:formatCode>General</c:formatCode>
                  <c:ptCount val="8"/>
                  <c:pt idx="0">
                    <c:v>1.4261716957012149</c:v>
                  </c:pt>
                  <c:pt idx="1">
                    <c:v>3.0486992752016104</c:v>
                  </c:pt>
                  <c:pt idx="2">
                    <c:v>0.98530809542559605</c:v>
                  </c:pt>
                  <c:pt idx="3">
                    <c:v>3.4305016035323139</c:v>
                  </c:pt>
                  <c:pt idx="4">
                    <c:v>1.9068163740240656</c:v>
                  </c:pt>
                  <c:pt idx="5">
                    <c:v>0.92781356379054403</c:v>
                  </c:pt>
                  <c:pt idx="6">
                    <c:v>1.8822965226821629</c:v>
                  </c:pt>
                  <c:pt idx="7">
                    <c:v>0.7973391848393488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M$17:$AM$24</c:f>
              <c:numCache>
                <c:formatCode>General</c:formatCode>
                <c:ptCount val="8"/>
                <c:pt idx="0">
                  <c:v>169.28604917852161</c:v>
                </c:pt>
                <c:pt idx="1">
                  <c:v>162.98072287256349</c:v>
                </c:pt>
                <c:pt idx="2">
                  <c:v>141.1828665859891</c:v>
                </c:pt>
                <c:pt idx="3">
                  <c:v>130.86941191432791</c:v>
                </c:pt>
                <c:pt idx="4">
                  <c:v>122.03576527125132</c:v>
                </c:pt>
                <c:pt idx="5">
                  <c:v>105.40808852861869</c:v>
                </c:pt>
                <c:pt idx="6">
                  <c:v>100.48679809771758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B38-4554-A913-6F3E3003A1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613126499880229"/>
          <c:y val="0.45396106736657915"/>
          <c:w val="0.36541175978982365"/>
          <c:h val="0.274106882473024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83394155203226"/>
          <c:y val="8.0163724966879124E-2"/>
          <c:w val="0.79272788290343577"/>
          <c:h val="0.74085429679843928"/>
        </c:manualLayout>
      </c:layout>
      <c:scatterChart>
        <c:scatterStyle val="lineMarker"/>
        <c:varyColors val="0"/>
        <c:ser>
          <c:idx val="2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52:$R$56</c:f>
                <c:numCache>
                  <c:formatCode>General</c:formatCode>
                  <c:ptCount val="5"/>
                  <c:pt idx="0">
                    <c:v>3.5446301242765292</c:v>
                  </c:pt>
                  <c:pt idx="1">
                    <c:v>1.2231024279876239</c:v>
                  </c:pt>
                  <c:pt idx="2">
                    <c:v>3.5247069479334971</c:v>
                  </c:pt>
                  <c:pt idx="3">
                    <c:v>2.3769131281127893</c:v>
                  </c:pt>
                  <c:pt idx="4">
                    <c:v>2.9624631845459213</c:v>
                  </c:pt>
                </c:numCache>
              </c:numRef>
            </c:plus>
            <c:minus>
              <c:numRef>
                <c:f>Sheet3!$R$52:$R$56</c:f>
                <c:numCache>
                  <c:formatCode>General</c:formatCode>
                  <c:ptCount val="5"/>
                  <c:pt idx="0">
                    <c:v>3.5446301242765292</c:v>
                  </c:pt>
                  <c:pt idx="1">
                    <c:v>1.2231024279876239</c:v>
                  </c:pt>
                  <c:pt idx="2">
                    <c:v>3.5247069479334971</c:v>
                  </c:pt>
                  <c:pt idx="3">
                    <c:v>2.3769131281127893</c:v>
                  </c:pt>
                  <c:pt idx="4">
                    <c:v>2.962463184545921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Sheet3!$O$26:$O$3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52:$P$56</c:f>
              <c:numCache>
                <c:formatCode>General</c:formatCode>
                <c:ptCount val="5"/>
                <c:pt idx="0">
                  <c:v>99.999999999999915</c:v>
                </c:pt>
                <c:pt idx="1">
                  <c:v>39.819178366851034</c:v>
                </c:pt>
                <c:pt idx="2">
                  <c:v>46.063209905010261</c:v>
                </c:pt>
                <c:pt idx="3">
                  <c:v>44.040884039118389</c:v>
                </c:pt>
                <c:pt idx="4">
                  <c:v>40.4695842956079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B10-496E-A425-928F59BD8AF5}"/>
            </c:ext>
          </c:extLst>
        </c:ser>
        <c:ser>
          <c:idx val="0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12:$R$16</c:f>
                <c:numCache>
                  <c:formatCode>General</c:formatCode>
                  <c:ptCount val="5"/>
                  <c:pt idx="0">
                    <c:v>1.9393452191180369</c:v>
                  </c:pt>
                  <c:pt idx="1">
                    <c:v>1.1356324141193614</c:v>
                  </c:pt>
                  <c:pt idx="2">
                    <c:v>1.9358367390957014</c:v>
                  </c:pt>
                  <c:pt idx="3">
                    <c:v>3.658940767258112</c:v>
                  </c:pt>
                  <c:pt idx="4">
                    <c:v>4.651587681651618</c:v>
                  </c:pt>
                </c:numCache>
              </c:numRef>
            </c:plus>
            <c:minus>
              <c:numRef>
                <c:f>Sheet3!$R$12:$R$16</c:f>
                <c:numCache>
                  <c:formatCode>General</c:formatCode>
                  <c:ptCount val="5"/>
                  <c:pt idx="0">
                    <c:v>1.9393452191180369</c:v>
                  </c:pt>
                  <c:pt idx="1">
                    <c:v>1.1356324141193614</c:v>
                  </c:pt>
                  <c:pt idx="2">
                    <c:v>1.9358367390957014</c:v>
                  </c:pt>
                  <c:pt idx="3">
                    <c:v>3.658940767258112</c:v>
                  </c:pt>
                  <c:pt idx="4">
                    <c:v>4.651587681651618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3!$O$6:$O$1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(Sheet3!$P$6:$P$10,Sheet3!$P$12:$P$16)</c:f>
              <c:numCache>
                <c:formatCode>General</c:formatCode>
                <c:ptCount val="10"/>
                <c:pt idx="0">
                  <c:v>100</c:v>
                </c:pt>
                <c:pt idx="1">
                  <c:v>37.682547908633722</c:v>
                </c:pt>
                <c:pt idx="2">
                  <c:v>31.349805992823249</c:v>
                </c:pt>
                <c:pt idx="3">
                  <c:v>25.405318437577691</c:v>
                </c:pt>
                <c:pt idx="4">
                  <c:v>24.054832710329141</c:v>
                </c:pt>
                <c:pt idx="5">
                  <c:v>99.999999999999915</c:v>
                </c:pt>
                <c:pt idx="6">
                  <c:v>56.129125882958256</c:v>
                </c:pt>
                <c:pt idx="7">
                  <c:v>28.228427796560695</c:v>
                </c:pt>
                <c:pt idx="8">
                  <c:v>49.159525097929297</c:v>
                </c:pt>
                <c:pt idx="9">
                  <c:v>48.4018226482881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B10-496E-A425-928F59BD8AF5}"/>
            </c:ext>
          </c:extLst>
        </c:ser>
        <c:ser>
          <c:idx val="1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32:$R$36</c:f>
                <c:numCache>
                  <c:formatCode>General</c:formatCode>
                  <c:ptCount val="5"/>
                  <c:pt idx="0">
                    <c:v>1.4631513896759172</c:v>
                  </c:pt>
                  <c:pt idx="1">
                    <c:v>0.16761830690954638</c:v>
                  </c:pt>
                  <c:pt idx="2">
                    <c:v>4.5730685233455883</c:v>
                  </c:pt>
                  <c:pt idx="3">
                    <c:v>0.30917697095252811</c:v>
                  </c:pt>
                  <c:pt idx="4">
                    <c:v>1.2968208854931218</c:v>
                  </c:pt>
                </c:numCache>
              </c:numRef>
            </c:plus>
            <c:minus>
              <c:numRef>
                <c:f>Sheet3!$R$32:$R$36</c:f>
                <c:numCache>
                  <c:formatCode>General</c:formatCode>
                  <c:ptCount val="5"/>
                  <c:pt idx="0">
                    <c:v>1.4631513896759172</c:v>
                  </c:pt>
                  <c:pt idx="1">
                    <c:v>0.16761830690954638</c:v>
                  </c:pt>
                  <c:pt idx="2">
                    <c:v>4.5730685233455883</c:v>
                  </c:pt>
                  <c:pt idx="3">
                    <c:v>0.30917697095252811</c:v>
                  </c:pt>
                  <c:pt idx="4">
                    <c:v>1.2968208854931218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Sheet3!$O$26:$O$3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32:$P$36</c:f>
              <c:numCache>
                <c:formatCode>General</c:formatCode>
                <c:ptCount val="5"/>
                <c:pt idx="0">
                  <c:v>100.00000000000013</c:v>
                </c:pt>
                <c:pt idx="1">
                  <c:v>50.408663189082198</c:v>
                </c:pt>
                <c:pt idx="2">
                  <c:v>52.577473479577229</c:v>
                </c:pt>
                <c:pt idx="3">
                  <c:v>45.325932402415702</c:v>
                </c:pt>
                <c:pt idx="4">
                  <c:v>41.6746612588232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B10-496E-A425-928F59BD8A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Panobinostat (</a:t>
                </a:r>
                <a:r>
                  <a:rPr lang="en-US" dirty="0">
                    <a:latin typeface="Symbol" panose="05050102010706020507" pitchFamily="18" charset="2"/>
                  </a:rPr>
                  <a:t>m</a:t>
                </a:r>
                <a:r>
                  <a:rPr lang="en-US" dirty="0"/>
                  <a:t>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"/>
      </c:val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90210784222044"/>
          <c:y val="0.16274465691788526"/>
          <c:w val="0.39345268048390508"/>
          <c:h val="0.24358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33192537168646"/>
          <c:y val="4.5245891852125922E-2"/>
          <c:w val="0.80803459856471926"/>
          <c:h val="0.75581908241904783"/>
        </c:manualLayout>
      </c:layout>
      <c:scatterChart>
        <c:scatterStyle val="lineMarker"/>
        <c:varyColors val="0"/>
        <c:ser>
          <c:idx val="2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46:$R$50</c:f>
                <c:numCache>
                  <c:formatCode>General</c:formatCode>
                  <c:ptCount val="5"/>
                  <c:pt idx="0">
                    <c:v>3.5446301242765292</c:v>
                  </c:pt>
                  <c:pt idx="1">
                    <c:v>1.2623742737275578</c:v>
                  </c:pt>
                  <c:pt idx="2">
                    <c:v>1.4269513157209972</c:v>
                  </c:pt>
                  <c:pt idx="3">
                    <c:v>2.2398596351718707</c:v>
                  </c:pt>
                  <c:pt idx="4">
                    <c:v>1.9636510383931909</c:v>
                  </c:pt>
                </c:numCache>
              </c:numRef>
            </c:plus>
            <c:minus>
              <c:numRef>
                <c:f>Sheet3!$R$46:$R$50</c:f>
                <c:numCache>
                  <c:formatCode>General</c:formatCode>
                  <c:ptCount val="5"/>
                  <c:pt idx="0">
                    <c:v>3.5446301242765292</c:v>
                  </c:pt>
                  <c:pt idx="1">
                    <c:v>1.2623742737275578</c:v>
                  </c:pt>
                  <c:pt idx="2">
                    <c:v>1.4269513157209972</c:v>
                  </c:pt>
                  <c:pt idx="3">
                    <c:v>2.2398596351718707</c:v>
                  </c:pt>
                  <c:pt idx="4">
                    <c:v>1.963651038393190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Sheet3!$O$26:$O$3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58:$P$62</c:f>
              <c:numCache>
                <c:formatCode>General</c:formatCode>
                <c:ptCount val="5"/>
                <c:pt idx="0">
                  <c:v>99.999999999999915</c:v>
                </c:pt>
                <c:pt idx="1">
                  <c:v>115.35862030995175</c:v>
                </c:pt>
                <c:pt idx="2">
                  <c:v>65.188772103264753</c:v>
                </c:pt>
                <c:pt idx="3">
                  <c:v>37.952504980585907</c:v>
                </c:pt>
                <c:pt idx="4">
                  <c:v>38.5964904710858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94D-4721-9140-1A1173219BAB}"/>
            </c:ext>
          </c:extLst>
        </c:ser>
        <c:ser>
          <c:idx val="0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6:$R$10</c:f>
                <c:numCache>
                  <c:formatCode>General</c:formatCode>
                  <c:ptCount val="5"/>
                  <c:pt idx="0">
                    <c:v>1.9393452191180369</c:v>
                  </c:pt>
                  <c:pt idx="1">
                    <c:v>3.6790974167051371</c:v>
                  </c:pt>
                  <c:pt idx="2">
                    <c:v>3.00917609204734</c:v>
                  </c:pt>
                  <c:pt idx="3">
                    <c:v>2.4583958657184168</c:v>
                  </c:pt>
                  <c:pt idx="4">
                    <c:v>3.1690382947943512</c:v>
                  </c:pt>
                </c:numCache>
              </c:numRef>
            </c:plus>
            <c:minus>
              <c:numRef>
                <c:f>Sheet3!$R$6:$R$10</c:f>
                <c:numCache>
                  <c:formatCode>General</c:formatCode>
                  <c:ptCount val="5"/>
                  <c:pt idx="0">
                    <c:v>1.9393452191180369</c:v>
                  </c:pt>
                  <c:pt idx="1">
                    <c:v>3.6790974167051371</c:v>
                  </c:pt>
                  <c:pt idx="2">
                    <c:v>3.00917609204734</c:v>
                  </c:pt>
                  <c:pt idx="3">
                    <c:v>2.4583958657184168</c:v>
                  </c:pt>
                  <c:pt idx="4">
                    <c:v>3.1690382947943512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3!$O$6:$O$1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18:$P$22</c:f>
              <c:numCache>
                <c:formatCode>General</c:formatCode>
                <c:ptCount val="5"/>
                <c:pt idx="0">
                  <c:v>99.999999999999915</c:v>
                </c:pt>
                <c:pt idx="1">
                  <c:v>238.7998410124321</c:v>
                </c:pt>
                <c:pt idx="2">
                  <c:v>119.0594447041187</c:v>
                </c:pt>
                <c:pt idx="3">
                  <c:v>75.072047134653616</c:v>
                </c:pt>
                <c:pt idx="4">
                  <c:v>47.7983076241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94D-4721-9140-1A1173219BAB}"/>
            </c:ext>
          </c:extLst>
        </c:ser>
        <c:ser>
          <c:idx val="1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3!$R$26:$R$30</c:f>
                <c:numCache>
                  <c:formatCode>General</c:formatCode>
                  <c:ptCount val="5"/>
                  <c:pt idx="0">
                    <c:v>1.4631513896759172</c:v>
                  </c:pt>
                  <c:pt idx="1">
                    <c:v>4.6015023243961855</c:v>
                  </c:pt>
                  <c:pt idx="2">
                    <c:v>0.90346023067204384</c:v>
                  </c:pt>
                  <c:pt idx="3">
                    <c:v>1.148479326599559</c:v>
                  </c:pt>
                  <c:pt idx="4">
                    <c:v>1.3350200630232707</c:v>
                  </c:pt>
                </c:numCache>
              </c:numRef>
            </c:plus>
            <c:minus>
              <c:numRef>
                <c:f>Sheet3!$R$26:$R$30</c:f>
                <c:numCache>
                  <c:formatCode>General</c:formatCode>
                  <c:ptCount val="5"/>
                  <c:pt idx="0">
                    <c:v>1.4631513896759172</c:v>
                  </c:pt>
                  <c:pt idx="1">
                    <c:v>4.6015023243961855</c:v>
                  </c:pt>
                  <c:pt idx="2">
                    <c:v>0.90346023067204384</c:v>
                  </c:pt>
                  <c:pt idx="3">
                    <c:v>1.148479326599559</c:v>
                  </c:pt>
                  <c:pt idx="4">
                    <c:v>1.335020063023270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Sheet3!$O$26:$O$30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3!$P$38:$P$42</c:f>
              <c:numCache>
                <c:formatCode>General</c:formatCode>
                <c:ptCount val="5"/>
                <c:pt idx="0">
                  <c:v>100.00000000000013</c:v>
                </c:pt>
                <c:pt idx="1">
                  <c:v>461.0962439748206</c:v>
                </c:pt>
                <c:pt idx="2">
                  <c:v>107.76276388861196</c:v>
                </c:pt>
                <c:pt idx="3">
                  <c:v>60.389821495765005</c:v>
                </c:pt>
                <c:pt idx="4">
                  <c:v>42.7777567584858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94D-4721-9140-1A1173219B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err="1"/>
                  <a:t>Vorinostat</a:t>
                </a:r>
                <a:r>
                  <a:rPr lang="en-US" dirty="0"/>
                  <a:t> (</a:t>
                </a:r>
                <a:r>
                  <a:rPr lang="en-US" dirty="0">
                    <a:latin typeface="Symbol" panose="05050102010706020507" pitchFamily="18" charset="2"/>
                  </a:rPr>
                  <a:t>m</a:t>
                </a:r>
                <a:r>
                  <a:rPr lang="en-US" dirty="0"/>
                  <a:t>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"/>
      </c:valAx>
      <c:valAx>
        <c:axId val="1131435656"/>
        <c:scaling>
          <c:orientation val="minMax"/>
          <c:max val="5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1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790210784222044"/>
          <c:y val="0.16274465691788526"/>
          <c:w val="0.39345268048390508"/>
          <c:h val="0.24358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" lastClr="FFFFFF"/>
      </a:solidFill>
      <a:round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52470405579547"/>
          <c:y val="6.485118058061963E-2"/>
          <c:w val="0.81586389102583767"/>
          <c:h val="0.75608652352434347"/>
        </c:manualLayout>
      </c:layout>
      <c:scatterChart>
        <c:scatterStyle val="lineMarker"/>
        <c:varyColors val="0"/>
        <c:ser>
          <c:idx val="2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47:$I$51</c:f>
                <c:numCache>
                  <c:formatCode>General</c:formatCode>
                  <c:ptCount val="5"/>
                  <c:pt idx="0">
                    <c:v>0.67449330961351794</c:v>
                  </c:pt>
                  <c:pt idx="1">
                    <c:v>6.495626572389698</c:v>
                  </c:pt>
                  <c:pt idx="2">
                    <c:v>9.3009000197917722</c:v>
                  </c:pt>
                  <c:pt idx="3">
                    <c:v>5.9437404154064737</c:v>
                  </c:pt>
                  <c:pt idx="4">
                    <c:v>4.9372366302834054</c:v>
                  </c:pt>
                </c:numCache>
              </c:numRef>
            </c:plus>
            <c:minus>
              <c:numRef>
                <c:f>Sheet4!$I$47:$I$51</c:f>
                <c:numCache>
                  <c:formatCode>General</c:formatCode>
                  <c:ptCount val="5"/>
                  <c:pt idx="0">
                    <c:v>0.67449330961351794</c:v>
                  </c:pt>
                  <c:pt idx="1">
                    <c:v>6.495626572389698</c:v>
                  </c:pt>
                  <c:pt idx="2">
                    <c:v>9.3009000197917722</c:v>
                  </c:pt>
                  <c:pt idx="3">
                    <c:v>5.9437404154064737</c:v>
                  </c:pt>
                  <c:pt idx="4">
                    <c:v>4.9372366302834054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18:$C$22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47:$G$51</c:f>
              <c:numCache>
                <c:formatCode>General</c:formatCode>
                <c:ptCount val="5"/>
                <c:pt idx="0">
                  <c:v>100</c:v>
                </c:pt>
                <c:pt idx="1">
                  <c:v>62.845321992182704</c:v>
                </c:pt>
                <c:pt idx="2">
                  <c:v>53.390709370918735</c:v>
                </c:pt>
                <c:pt idx="3">
                  <c:v>51.769216138637184</c:v>
                </c:pt>
                <c:pt idx="4">
                  <c:v>51.6786214464600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F53-45D5-826C-F4F0C8EDB989}"/>
            </c:ext>
          </c:extLst>
        </c:ser>
        <c:ser>
          <c:idx val="0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4:$I$8</c:f>
                <c:numCache>
                  <c:formatCode>General</c:formatCode>
                  <c:ptCount val="5"/>
                  <c:pt idx="0">
                    <c:v>1.2277816073608268</c:v>
                  </c:pt>
                  <c:pt idx="1">
                    <c:v>2.3250999616340726</c:v>
                  </c:pt>
                  <c:pt idx="2">
                    <c:v>2.7492474384301238</c:v>
                  </c:pt>
                  <c:pt idx="3">
                    <c:v>1.2684955987253277</c:v>
                  </c:pt>
                  <c:pt idx="4">
                    <c:v>0.30681589286110278</c:v>
                  </c:pt>
                </c:numCache>
              </c:numRef>
            </c:plus>
            <c:minus>
              <c:numRef>
                <c:f>Sheet4!$I$4:$I$8</c:f>
                <c:numCache>
                  <c:formatCode>General</c:formatCode>
                  <c:ptCount val="5"/>
                  <c:pt idx="0">
                    <c:v>1.2277816073608268</c:v>
                  </c:pt>
                  <c:pt idx="1">
                    <c:v>2.3250999616340726</c:v>
                  </c:pt>
                  <c:pt idx="2">
                    <c:v>2.7492474384301238</c:v>
                  </c:pt>
                  <c:pt idx="3">
                    <c:v>1.2684955987253277</c:v>
                  </c:pt>
                  <c:pt idx="4">
                    <c:v>0.30681589286110278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4:$C$8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4:$G$8</c:f>
              <c:numCache>
                <c:formatCode>General</c:formatCode>
                <c:ptCount val="5"/>
                <c:pt idx="0">
                  <c:v>100</c:v>
                </c:pt>
                <c:pt idx="1">
                  <c:v>65.4445468406347</c:v>
                </c:pt>
                <c:pt idx="2">
                  <c:v>63.869628175515359</c:v>
                </c:pt>
                <c:pt idx="3">
                  <c:v>62.146878217867595</c:v>
                </c:pt>
                <c:pt idx="4">
                  <c:v>64.3120391247990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F53-45D5-826C-F4F0C8EDB989}"/>
            </c:ext>
          </c:extLst>
        </c:ser>
        <c:ser>
          <c:idx val="1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26:$I$30</c:f>
                <c:numCache>
                  <c:formatCode>General</c:formatCode>
                  <c:ptCount val="5"/>
                  <c:pt idx="0">
                    <c:v>3.4564861804415816</c:v>
                  </c:pt>
                  <c:pt idx="1">
                    <c:v>1.1547392295703343</c:v>
                  </c:pt>
                  <c:pt idx="2">
                    <c:v>0.75139588578986694</c:v>
                  </c:pt>
                  <c:pt idx="3">
                    <c:v>0.74351618339998027</c:v>
                  </c:pt>
                  <c:pt idx="4">
                    <c:v>0.93346104451067691</c:v>
                  </c:pt>
                </c:numCache>
              </c:numRef>
            </c:plus>
            <c:minus>
              <c:numRef>
                <c:f>Sheet4!$I$26:$I$30</c:f>
                <c:numCache>
                  <c:formatCode>General</c:formatCode>
                  <c:ptCount val="5"/>
                  <c:pt idx="0">
                    <c:v>3.4564861804415816</c:v>
                  </c:pt>
                  <c:pt idx="1">
                    <c:v>1.1547392295703343</c:v>
                  </c:pt>
                  <c:pt idx="2">
                    <c:v>0.75139588578986694</c:v>
                  </c:pt>
                  <c:pt idx="3">
                    <c:v>0.74351618339998027</c:v>
                  </c:pt>
                  <c:pt idx="4">
                    <c:v>0.93346104451067691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12:$C$16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26:$G$30</c:f>
              <c:numCache>
                <c:formatCode>General</c:formatCode>
                <c:ptCount val="5"/>
                <c:pt idx="0">
                  <c:v>100</c:v>
                </c:pt>
                <c:pt idx="1">
                  <c:v>60.811803253248222</c:v>
                </c:pt>
                <c:pt idx="2">
                  <c:v>60.334167941476558</c:v>
                </c:pt>
                <c:pt idx="3">
                  <c:v>59.455092059051736</c:v>
                </c:pt>
                <c:pt idx="4">
                  <c:v>60.0505700719379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F53-45D5-826C-F4F0C8EDB9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err="1"/>
                  <a:t>Romidepsin</a:t>
                </a:r>
                <a:r>
                  <a:rPr lang="en-US" dirty="0"/>
                  <a:t> (</a:t>
                </a:r>
                <a:r>
                  <a:rPr lang="en-US" dirty="0">
                    <a:latin typeface="Symbol" panose="05050102010706020507" pitchFamily="18" charset="2"/>
                  </a:rPr>
                  <a:t>m</a:t>
                </a:r>
                <a:r>
                  <a:rPr lang="en-US" dirty="0"/>
                  <a:t>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"/>
      </c:val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9830674692347718"/>
          <c:y val="6.745938039755206E-2"/>
          <c:w val="0.39345268048390508"/>
          <c:h val="0.24358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" lastClr="FFFFFF"/>
      </a:solidFill>
      <a:round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876400512033046"/>
          <c:y val="6.9541690156501842E-2"/>
          <c:w val="0.78500684120048914"/>
          <c:h val="0.74627285792553644"/>
        </c:manualLayout>
      </c:layout>
      <c:scatterChart>
        <c:scatterStyle val="lineMarker"/>
        <c:varyColors val="0"/>
        <c:ser>
          <c:idx val="2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54:$I$58</c:f>
                <c:numCache>
                  <c:formatCode>General</c:formatCode>
                  <c:ptCount val="5"/>
                  <c:pt idx="0">
                    <c:v>0.67449330961351794</c:v>
                  </c:pt>
                  <c:pt idx="1">
                    <c:v>4.6132089324883028</c:v>
                  </c:pt>
                  <c:pt idx="2">
                    <c:v>4.6366300483590637</c:v>
                  </c:pt>
                  <c:pt idx="3">
                    <c:v>2.3621967392261656</c:v>
                  </c:pt>
                  <c:pt idx="4">
                    <c:v>1.2237758913058405</c:v>
                  </c:pt>
                </c:numCache>
              </c:numRef>
            </c:plus>
            <c:minus>
              <c:numRef>
                <c:f>Sheet4!$I$54:$I$58</c:f>
                <c:numCache>
                  <c:formatCode>General</c:formatCode>
                  <c:ptCount val="5"/>
                  <c:pt idx="0">
                    <c:v>0.67449330961351794</c:v>
                  </c:pt>
                  <c:pt idx="1">
                    <c:v>4.6132089324883028</c:v>
                  </c:pt>
                  <c:pt idx="2">
                    <c:v>4.6366300483590637</c:v>
                  </c:pt>
                  <c:pt idx="3">
                    <c:v>2.3621967392261656</c:v>
                  </c:pt>
                  <c:pt idx="4">
                    <c:v>1.2237758913058405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18:$C$22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54:$G$58</c:f>
              <c:numCache>
                <c:formatCode>General</c:formatCode>
                <c:ptCount val="5"/>
                <c:pt idx="0">
                  <c:v>100</c:v>
                </c:pt>
                <c:pt idx="1">
                  <c:v>50.877273873233719</c:v>
                </c:pt>
                <c:pt idx="2">
                  <c:v>47.311437773003199</c:v>
                </c:pt>
                <c:pt idx="3">
                  <c:v>46.998584663036034</c:v>
                </c:pt>
                <c:pt idx="4">
                  <c:v>44.3294396961952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824-4887-B8E8-B60A7DC023C8}"/>
            </c:ext>
          </c:extLst>
        </c:ser>
        <c:ser>
          <c:idx val="0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12:$I$16</c:f>
                <c:numCache>
                  <c:formatCode>General</c:formatCode>
                  <c:ptCount val="5"/>
                  <c:pt idx="0">
                    <c:v>1.2277816073608268</c:v>
                  </c:pt>
                  <c:pt idx="1">
                    <c:v>0.41880129722455739</c:v>
                  </c:pt>
                  <c:pt idx="2">
                    <c:v>3.4393455821915073</c:v>
                  </c:pt>
                  <c:pt idx="3">
                    <c:v>1.3129163045585188</c:v>
                  </c:pt>
                  <c:pt idx="4">
                    <c:v>2.4381134668999747</c:v>
                  </c:pt>
                </c:numCache>
              </c:numRef>
            </c:plus>
            <c:minus>
              <c:numRef>
                <c:f>Sheet4!$I$12:$I$16</c:f>
                <c:numCache>
                  <c:formatCode>General</c:formatCode>
                  <c:ptCount val="5"/>
                  <c:pt idx="0">
                    <c:v>1.2277816073608268</c:v>
                  </c:pt>
                  <c:pt idx="1">
                    <c:v>0.41880129722455739</c:v>
                  </c:pt>
                  <c:pt idx="2">
                    <c:v>3.4393455821915073</c:v>
                  </c:pt>
                  <c:pt idx="3">
                    <c:v>1.3129163045585188</c:v>
                  </c:pt>
                  <c:pt idx="4">
                    <c:v>2.4381134668999747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4:$C$8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12:$G$16</c:f>
              <c:numCache>
                <c:formatCode>General</c:formatCode>
                <c:ptCount val="5"/>
                <c:pt idx="0">
                  <c:v>100</c:v>
                </c:pt>
                <c:pt idx="1">
                  <c:v>71.606256662673346</c:v>
                </c:pt>
                <c:pt idx="2">
                  <c:v>65.385632273081271</c:v>
                </c:pt>
                <c:pt idx="3">
                  <c:v>63.105272073549408</c:v>
                </c:pt>
                <c:pt idx="4">
                  <c:v>62.2658823340321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824-4887-B8E8-B60A7DC023C8}"/>
            </c:ext>
          </c:extLst>
        </c:ser>
        <c:ser>
          <c:idx val="1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33:$I$37</c:f>
                <c:numCache>
                  <c:formatCode>General</c:formatCode>
                  <c:ptCount val="5"/>
                  <c:pt idx="0">
                    <c:v>3.4564861804415816</c:v>
                  </c:pt>
                  <c:pt idx="1">
                    <c:v>1.6700435061208732</c:v>
                  </c:pt>
                  <c:pt idx="2">
                    <c:v>3.1304772937783514</c:v>
                  </c:pt>
                  <c:pt idx="3">
                    <c:v>1.2133029874528705</c:v>
                  </c:pt>
                  <c:pt idx="4">
                    <c:v>1.198771942684723</c:v>
                  </c:pt>
                </c:numCache>
              </c:numRef>
            </c:plus>
            <c:minus>
              <c:numRef>
                <c:f>Sheet4!$I$33:$I$37</c:f>
                <c:numCache>
                  <c:formatCode>General</c:formatCode>
                  <c:ptCount val="5"/>
                  <c:pt idx="0">
                    <c:v>3.4564861804415816</c:v>
                  </c:pt>
                  <c:pt idx="1">
                    <c:v>1.6700435061208732</c:v>
                  </c:pt>
                  <c:pt idx="2">
                    <c:v>3.1304772937783514</c:v>
                  </c:pt>
                  <c:pt idx="3">
                    <c:v>1.2133029874528705</c:v>
                  </c:pt>
                  <c:pt idx="4">
                    <c:v>1.198771942684723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12:$C$16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33:$G$37</c:f>
              <c:numCache>
                <c:formatCode>General</c:formatCode>
                <c:ptCount val="5"/>
                <c:pt idx="0">
                  <c:v>100</c:v>
                </c:pt>
                <c:pt idx="1">
                  <c:v>65.383644569010499</c:v>
                </c:pt>
                <c:pt idx="2">
                  <c:v>62.273183884762354</c:v>
                </c:pt>
                <c:pt idx="3">
                  <c:v>58.824695297651587</c:v>
                </c:pt>
                <c:pt idx="4">
                  <c:v>59.1020129180256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824-4887-B8E8-B60A7DC023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Panobinostat (</a:t>
                </a:r>
                <a:r>
                  <a:rPr lang="en-US" dirty="0">
                    <a:latin typeface="Symbol" panose="05050102010706020507" pitchFamily="18" charset="2"/>
                  </a:rPr>
                  <a:t>m</a:t>
                </a:r>
                <a:r>
                  <a:rPr lang="en-US" dirty="0"/>
                  <a:t>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"/>
      </c:val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0225103764482446"/>
          <c:y val="6.6945633272722946E-2"/>
          <c:w val="0.39345268048390508"/>
          <c:h val="0.24358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822903855412829"/>
          <c:y val="6.9378124712632924E-2"/>
          <c:w val="0.82327113227932802"/>
          <c:h val="0.7362703724595755"/>
        </c:manualLayout>
      </c:layout>
      <c:scatterChart>
        <c:scatterStyle val="lineMarker"/>
        <c:varyColors val="0"/>
        <c:ser>
          <c:idx val="2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60:$I$64</c:f>
                <c:numCache>
                  <c:formatCode>General</c:formatCode>
                  <c:ptCount val="5"/>
                  <c:pt idx="0">
                    <c:v>0.67449330961351794</c:v>
                  </c:pt>
                  <c:pt idx="1">
                    <c:v>16.722781246780126</c:v>
                  </c:pt>
                  <c:pt idx="2">
                    <c:v>0.71332069944844678</c:v>
                  </c:pt>
                  <c:pt idx="3">
                    <c:v>5.9804219528079123</c:v>
                  </c:pt>
                  <c:pt idx="4">
                    <c:v>3.8025080075526394</c:v>
                  </c:pt>
                </c:numCache>
              </c:numRef>
            </c:plus>
            <c:minus>
              <c:numRef>
                <c:f>Sheet4!$I$60:$I$64</c:f>
                <c:numCache>
                  <c:formatCode>General</c:formatCode>
                  <c:ptCount val="5"/>
                  <c:pt idx="0">
                    <c:v>0.67449330961351794</c:v>
                  </c:pt>
                  <c:pt idx="1">
                    <c:v>16.722781246780126</c:v>
                  </c:pt>
                  <c:pt idx="2">
                    <c:v>0.71332069944844678</c:v>
                  </c:pt>
                  <c:pt idx="3">
                    <c:v>5.9804219528079123</c:v>
                  </c:pt>
                  <c:pt idx="4">
                    <c:v>3.8025080075526394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18:$C$22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60:$G$64</c:f>
              <c:numCache>
                <c:formatCode>General</c:formatCode>
                <c:ptCount val="5"/>
                <c:pt idx="0">
                  <c:v>100</c:v>
                </c:pt>
                <c:pt idx="1">
                  <c:v>76.102990957954958</c:v>
                </c:pt>
                <c:pt idx="2">
                  <c:v>49.408453779002102</c:v>
                </c:pt>
                <c:pt idx="3">
                  <c:v>47.238468224600709</c:v>
                </c:pt>
                <c:pt idx="4">
                  <c:v>43.0210511310777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663-4E35-8F15-6B0B15B4F9F9}"/>
            </c:ext>
          </c:extLst>
        </c:ser>
        <c:ser>
          <c:idx val="0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18:$I$22</c:f>
                <c:numCache>
                  <c:formatCode>General</c:formatCode>
                  <c:ptCount val="5"/>
                  <c:pt idx="0">
                    <c:v>1.2277816073608268</c:v>
                  </c:pt>
                  <c:pt idx="1">
                    <c:v>1.8030987855694913</c:v>
                  </c:pt>
                  <c:pt idx="2">
                    <c:v>1.1266359036462246</c:v>
                  </c:pt>
                  <c:pt idx="3">
                    <c:v>1.7340156890337379</c:v>
                  </c:pt>
                  <c:pt idx="4">
                    <c:v>3.0638699240731753</c:v>
                  </c:pt>
                </c:numCache>
              </c:numRef>
            </c:plus>
            <c:minus>
              <c:numRef>
                <c:f>Sheet4!$I$18:$I$22</c:f>
                <c:numCache>
                  <c:formatCode>General</c:formatCode>
                  <c:ptCount val="5"/>
                  <c:pt idx="0">
                    <c:v>1.2277816073608268</c:v>
                  </c:pt>
                  <c:pt idx="1">
                    <c:v>1.8030987855694913</c:v>
                  </c:pt>
                  <c:pt idx="2">
                    <c:v>1.1266359036462246</c:v>
                  </c:pt>
                  <c:pt idx="3">
                    <c:v>1.7340156890337379</c:v>
                  </c:pt>
                  <c:pt idx="4">
                    <c:v>3.0638699240731753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4:$C$8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18:$G$22</c:f>
              <c:numCache>
                <c:formatCode>General</c:formatCode>
                <c:ptCount val="5"/>
                <c:pt idx="0">
                  <c:v>100</c:v>
                </c:pt>
                <c:pt idx="1">
                  <c:v>81.132692547680165</c:v>
                </c:pt>
                <c:pt idx="2">
                  <c:v>71.246648991569586</c:v>
                </c:pt>
                <c:pt idx="3">
                  <c:v>70.26214042033682</c:v>
                </c:pt>
                <c:pt idx="4">
                  <c:v>60.9839246853742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663-4E35-8F15-6B0B15B4F9F9}"/>
            </c:ext>
          </c:extLst>
        </c:ser>
        <c:ser>
          <c:idx val="1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4!$I$39:$I$43</c:f>
                <c:numCache>
                  <c:formatCode>General</c:formatCode>
                  <c:ptCount val="5"/>
                  <c:pt idx="0">
                    <c:v>3.4564861804415816</c:v>
                  </c:pt>
                  <c:pt idx="1">
                    <c:v>3.4620220475209691</c:v>
                  </c:pt>
                  <c:pt idx="2">
                    <c:v>1.2312984617804006</c:v>
                  </c:pt>
                  <c:pt idx="3">
                    <c:v>4.1476877462448947</c:v>
                  </c:pt>
                  <c:pt idx="4">
                    <c:v>0.67943605886299285</c:v>
                  </c:pt>
                </c:numCache>
              </c:numRef>
            </c:plus>
            <c:minus>
              <c:numRef>
                <c:f>Sheet4!$I$39:$I$43</c:f>
                <c:numCache>
                  <c:formatCode>General</c:formatCode>
                  <c:ptCount val="5"/>
                  <c:pt idx="0">
                    <c:v>3.4564861804415816</c:v>
                  </c:pt>
                  <c:pt idx="1">
                    <c:v>3.4620220475209691</c:v>
                  </c:pt>
                  <c:pt idx="2">
                    <c:v>1.2312984617804006</c:v>
                  </c:pt>
                  <c:pt idx="3">
                    <c:v>4.1476877462448947</c:v>
                  </c:pt>
                  <c:pt idx="4">
                    <c:v>0.67943605886299285</c:v>
                  </c:pt>
                </c:numCache>
              </c:numRef>
            </c:minus>
            <c:spPr>
              <a:ln w="15875">
                <a:solidFill>
                  <a:sysClr val="windowText" lastClr="000000"/>
                </a:solidFill>
              </a:ln>
            </c:spPr>
          </c:errBars>
          <c:xVal>
            <c:numRef>
              <c:f>Sheet4!$C$12:$C$16</c:f>
              <c:numCache>
                <c:formatCode>General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</c:numCache>
            </c:numRef>
          </c:xVal>
          <c:yVal>
            <c:numRef>
              <c:f>Sheet4!$G$39:$G$43</c:f>
              <c:numCache>
                <c:formatCode>General</c:formatCode>
                <c:ptCount val="5"/>
                <c:pt idx="0">
                  <c:v>100</c:v>
                </c:pt>
                <c:pt idx="1">
                  <c:v>88.808526618000315</c:v>
                </c:pt>
                <c:pt idx="2">
                  <c:v>81.692458114024987</c:v>
                </c:pt>
                <c:pt idx="3">
                  <c:v>72.915794954583234</c:v>
                </c:pt>
                <c:pt idx="4">
                  <c:v>63.6776565781642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663-4E35-8F15-6B0B15B4F9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1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err="1"/>
                  <a:t>Vorinostat</a:t>
                </a:r>
                <a:r>
                  <a:rPr lang="en-US" baseline="0" dirty="0"/>
                  <a:t> (</a:t>
                </a:r>
                <a:r>
                  <a:rPr lang="en-US" baseline="0" dirty="0">
                    <a:latin typeface="Symbol" panose="05050102010706020507" pitchFamily="18" charset="2"/>
                  </a:rPr>
                  <a:t>m</a:t>
                </a:r>
                <a:r>
                  <a:rPr lang="en-US" baseline="0" dirty="0"/>
                  <a:t>M)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"/>
      </c:val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371545593852657"/>
          <c:y val="7.1742745212937276E-2"/>
          <c:w val="0.39345268048390508"/>
          <c:h val="0.243588311461067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" lastClr="FFFFFF"/>
      </a:solidFill>
      <a:round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420653017011907"/>
          <c:y val="0.16246767026462119"/>
          <c:w val="0.80213549596994438"/>
          <c:h val="0.63209930599311326"/>
        </c:manualLayout>
      </c:layout>
      <c:barChart>
        <c:barDir val="col"/>
        <c:grouping val="clustered"/>
        <c:varyColors val="0"/>
        <c:ser>
          <c:idx val="1"/>
          <c:order val="0"/>
          <c:tx>
            <c:v>RPMI 8226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R$5:$R$11</c:f>
                <c:numCache>
                  <c:formatCode>General</c:formatCode>
                  <c:ptCount val="7"/>
                  <c:pt idx="0">
                    <c:v>3.2032689104208929</c:v>
                  </c:pt>
                  <c:pt idx="1">
                    <c:v>1.4621599916571268</c:v>
                  </c:pt>
                  <c:pt idx="2">
                    <c:v>3.5452728955521833</c:v>
                  </c:pt>
                  <c:pt idx="3">
                    <c:v>2.4006158580986403</c:v>
                  </c:pt>
                  <c:pt idx="4">
                    <c:v>0.92210634177518469</c:v>
                  </c:pt>
                  <c:pt idx="5">
                    <c:v>1.3145017121771538</c:v>
                  </c:pt>
                  <c:pt idx="6">
                    <c:v>2.2593630390417658</c:v>
                  </c:pt>
                </c:numCache>
              </c:numRef>
            </c:plus>
            <c:minus>
              <c:numRef>
                <c:f>Sheet3!$R$5:$R$11</c:f>
                <c:numCache>
                  <c:formatCode>General</c:formatCode>
                  <c:ptCount val="7"/>
                  <c:pt idx="0">
                    <c:v>3.2032689104208929</c:v>
                  </c:pt>
                  <c:pt idx="1">
                    <c:v>1.4621599916571268</c:v>
                  </c:pt>
                  <c:pt idx="2">
                    <c:v>3.5452728955521833</c:v>
                  </c:pt>
                  <c:pt idx="3">
                    <c:v>2.4006158580986403</c:v>
                  </c:pt>
                  <c:pt idx="4">
                    <c:v>0.92210634177518469</c:v>
                  </c:pt>
                  <c:pt idx="5">
                    <c:v>1.3145017121771538</c:v>
                  </c:pt>
                  <c:pt idx="6">
                    <c:v>2.2593630390417658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3!$N$5:$N$11</c:f>
              <c:numCache>
                <c:formatCode>General</c:formatCode>
                <c:ptCount val="7"/>
                <c:pt idx="0">
                  <c:v>99.999999999999702</c:v>
                </c:pt>
                <c:pt idx="1">
                  <c:v>137.65789643016183</c:v>
                </c:pt>
                <c:pt idx="2">
                  <c:v>114.76288750603598</c:v>
                </c:pt>
                <c:pt idx="3">
                  <c:v>94.494123570874507</c:v>
                </c:pt>
                <c:pt idx="4">
                  <c:v>44.478424356085291</c:v>
                </c:pt>
                <c:pt idx="5">
                  <c:v>18.26203195193148</c:v>
                </c:pt>
                <c:pt idx="6">
                  <c:v>16.1598208802679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BD-4F45-9A1A-9A32599D5F54}"/>
            </c:ext>
          </c:extLst>
        </c:ser>
        <c:ser>
          <c:idx val="0"/>
          <c:order val="1"/>
          <c:tx>
            <c:v>ARH 77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I$5:$I$11</c:f>
                <c:numCache>
                  <c:formatCode>General</c:formatCode>
                  <c:ptCount val="7"/>
                  <c:pt idx="0">
                    <c:v>2.459323750288041</c:v>
                  </c:pt>
                  <c:pt idx="1">
                    <c:v>4.2354029938132332</c:v>
                  </c:pt>
                  <c:pt idx="2">
                    <c:v>3.4072736907232395</c:v>
                  </c:pt>
                  <c:pt idx="3">
                    <c:v>2.6041182033325492</c:v>
                  </c:pt>
                  <c:pt idx="4">
                    <c:v>1.7064938529400604</c:v>
                  </c:pt>
                  <c:pt idx="5">
                    <c:v>3.8291539266747789</c:v>
                  </c:pt>
                  <c:pt idx="6">
                    <c:v>3.3067577389110281</c:v>
                  </c:pt>
                </c:numCache>
              </c:numRef>
            </c:plus>
            <c:minus>
              <c:numRef>
                <c:f>Sheet3!$I$5:$I$11</c:f>
                <c:numCache>
                  <c:formatCode>General</c:formatCode>
                  <c:ptCount val="7"/>
                  <c:pt idx="0">
                    <c:v>2.459323750288041</c:v>
                  </c:pt>
                  <c:pt idx="1">
                    <c:v>4.2354029938132332</c:v>
                  </c:pt>
                  <c:pt idx="2">
                    <c:v>3.4072736907232395</c:v>
                  </c:pt>
                  <c:pt idx="3">
                    <c:v>2.6041182033325492</c:v>
                  </c:pt>
                  <c:pt idx="4">
                    <c:v>1.7064938529400604</c:v>
                  </c:pt>
                  <c:pt idx="5">
                    <c:v>3.8291539266747789</c:v>
                  </c:pt>
                  <c:pt idx="6">
                    <c:v>3.306757738911028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3!$B$5:$B$11</c:f>
              <c:numCache>
                <c:formatCode>General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50</c:v>
                </c:pt>
                <c:pt idx="6">
                  <c:v>100</c:v>
                </c:pt>
              </c:numCache>
            </c:numRef>
          </c:cat>
          <c:val>
            <c:numRef>
              <c:f>Sheet3!$E$5:$E$11</c:f>
              <c:numCache>
                <c:formatCode>General</c:formatCode>
                <c:ptCount val="7"/>
                <c:pt idx="0">
                  <c:v>99.999999999999844</c:v>
                </c:pt>
                <c:pt idx="1">
                  <c:v>112.61316277191949</c:v>
                </c:pt>
                <c:pt idx="2">
                  <c:v>84.334918571124163</c:v>
                </c:pt>
                <c:pt idx="3">
                  <c:v>82.370138189077622</c:v>
                </c:pt>
                <c:pt idx="4">
                  <c:v>53.47111285600289</c:v>
                </c:pt>
                <c:pt idx="5">
                  <c:v>15.616149398065266</c:v>
                </c:pt>
                <c:pt idx="6">
                  <c:v>13.740543410189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EBD-4F45-9A1A-9A32599D5F54}"/>
            </c:ext>
          </c:extLst>
        </c:ser>
        <c:ser>
          <c:idx val="2"/>
          <c:order val="2"/>
          <c:tx>
            <c:v>U266</c:v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B$5:$AB$11</c:f>
                <c:numCache>
                  <c:formatCode>General</c:formatCode>
                  <c:ptCount val="7"/>
                  <c:pt idx="0">
                    <c:v>0.59171269514769764</c:v>
                  </c:pt>
                  <c:pt idx="1">
                    <c:v>6.2285018635875602</c:v>
                  </c:pt>
                  <c:pt idx="2">
                    <c:v>3.3738923941380019</c:v>
                  </c:pt>
                  <c:pt idx="3">
                    <c:v>3.4057691393387177</c:v>
                  </c:pt>
                  <c:pt idx="4">
                    <c:v>2.8271025829024095</c:v>
                  </c:pt>
                  <c:pt idx="5">
                    <c:v>0.57280716619459926</c:v>
                  </c:pt>
                  <c:pt idx="6">
                    <c:v>1.3513788727274469</c:v>
                  </c:pt>
                </c:numCache>
              </c:numRef>
            </c:plus>
            <c:minus>
              <c:numRef>
                <c:f>Sheet3!$AB$5:$AB$11</c:f>
                <c:numCache>
                  <c:formatCode>General</c:formatCode>
                  <c:ptCount val="7"/>
                  <c:pt idx="0">
                    <c:v>0.59171269514769764</c:v>
                  </c:pt>
                  <c:pt idx="1">
                    <c:v>6.2285018635875602</c:v>
                  </c:pt>
                  <c:pt idx="2">
                    <c:v>3.3738923941380019</c:v>
                  </c:pt>
                  <c:pt idx="3">
                    <c:v>3.4057691393387177</c:v>
                  </c:pt>
                  <c:pt idx="4">
                    <c:v>2.8271025829024095</c:v>
                  </c:pt>
                  <c:pt idx="5">
                    <c:v>0.57280716619459926</c:v>
                  </c:pt>
                  <c:pt idx="6">
                    <c:v>1.351378872727446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3!$X$5:$X$11</c:f>
              <c:numCache>
                <c:formatCode>General</c:formatCode>
                <c:ptCount val="7"/>
                <c:pt idx="0">
                  <c:v>99.999999999999702</c:v>
                </c:pt>
                <c:pt idx="1">
                  <c:v>110.31333372178165</c:v>
                </c:pt>
                <c:pt idx="2">
                  <c:v>78.834153602596729</c:v>
                </c:pt>
                <c:pt idx="3">
                  <c:v>73.8845094941083</c:v>
                </c:pt>
                <c:pt idx="4">
                  <c:v>54.139432188426774</c:v>
                </c:pt>
                <c:pt idx="5">
                  <c:v>20.668702472920618</c:v>
                </c:pt>
                <c:pt idx="6">
                  <c:v>19.4710347418694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EBD-4F45-9A1A-9A32599D5F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b="1"/>
                  <a:t>Nexturastat</a:t>
                </a:r>
                <a:r>
                  <a:rPr lang="en-US" sz="1400" b="1" baseline="0"/>
                  <a:t> (</a:t>
                </a:r>
                <a:r>
                  <a:rPr lang="en-US" sz="1400" b="1" baseline="0">
                    <a:latin typeface="Symbol" panose="05050102010706020507" pitchFamily="18" charset="2"/>
                  </a:rPr>
                  <a:t>m</a:t>
                </a:r>
                <a:r>
                  <a:rPr lang="en-US" sz="1400" b="1" baseline="0"/>
                  <a:t>M)</a:t>
                </a:r>
                <a:endParaRPr lang="en-US" sz="140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339933563666185"/>
          <c:y val="3.3076290995540443E-2"/>
          <c:w val="0.32515433080573747"/>
          <c:h val="0.254548651423637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35118297484063"/>
          <c:y val="0.16246767026462119"/>
          <c:w val="0.77283019639165729"/>
          <c:h val="0.64184728797242885"/>
        </c:manualLayout>
      </c:layout>
      <c:barChart>
        <c:barDir val="col"/>
        <c:grouping val="clustered"/>
        <c:varyColors val="0"/>
        <c:ser>
          <c:idx val="1"/>
          <c:order val="0"/>
          <c:tx>
            <c:v>RPMI 8226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R$14:$R$20</c:f>
                <c:numCache>
                  <c:formatCode>General</c:formatCode>
                  <c:ptCount val="7"/>
                  <c:pt idx="0">
                    <c:v>3.2032689104208929</c:v>
                  </c:pt>
                  <c:pt idx="1">
                    <c:v>4.3060557582138426</c:v>
                  </c:pt>
                  <c:pt idx="2">
                    <c:v>4.5678106204721765</c:v>
                  </c:pt>
                  <c:pt idx="3">
                    <c:v>3.3640652554814481</c:v>
                  </c:pt>
                  <c:pt idx="4">
                    <c:v>4.182452690846743</c:v>
                  </c:pt>
                  <c:pt idx="5">
                    <c:v>13.758827224943085</c:v>
                  </c:pt>
                  <c:pt idx="6">
                    <c:v>3.8682496782808227</c:v>
                  </c:pt>
                </c:numCache>
              </c:numRef>
            </c:plus>
            <c:minus>
              <c:numRef>
                <c:f>Sheet3!$R$14:$R$20</c:f>
                <c:numCache>
                  <c:formatCode>General</c:formatCode>
                  <c:ptCount val="7"/>
                  <c:pt idx="0">
                    <c:v>3.2032689104208929</c:v>
                  </c:pt>
                  <c:pt idx="1">
                    <c:v>4.3060557582138426</c:v>
                  </c:pt>
                  <c:pt idx="2">
                    <c:v>4.5678106204721765</c:v>
                  </c:pt>
                  <c:pt idx="3">
                    <c:v>3.3640652554814481</c:v>
                  </c:pt>
                  <c:pt idx="4">
                    <c:v>4.182452690846743</c:v>
                  </c:pt>
                  <c:pt idx="5">
                    <c:v>13.758827224943085</c:v>
                  </c:pt>
                  <c:pt idx="6">
                    <c:v>3.868249678280822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3!$N$14:$N$20</c:f>
              <c:numCache>
                <c:formatCode>General</c:formatCode>
                <c:ptCount val="7"/>
                <c:pt idx="0">
                  <c:v>99.999999999999702</c:v>
                </c:pt>
                <c:pt idx="1">
                  <c:v>124.3391086619305</c:v>
                </c:pt>
                <c:pt idx="2">
                  <c:v>119.14961232997425</c:v>
                </c:pt>
                <c:pt idx="3">
                  <c:v>126.08115613190797</c:v>
                </c:pt>
                <c:pt idx="4">
                  <c:v>110.17823887670303</c:v>
                </c:pt>
                <c:pt idx="5">
                  <c:v>59.839237666620463</c:v>
                </c:pt>
                <c:pt idx="6">
                  <c:v>16.653215402847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A2B-4D70-8097-4D0C29052947}"/>
            </c:ext>
          </c:extLst>
        </c:ser>
        <c:ser>
          <c:idx val="0"/>
          <c:order val="1"/>
          <c:tx>
            <c:v>ARH 77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I$14:$I$20</c:f>
                <c:numCache>
                  <c:formatCode>General</c:formatCode>
                  <c:ptCount val="7"/>
                  <c:pt idx="0">
                    <c:v>2.459323750288041</c:v>
                  </c:pt>
                  <c:pt idx="1">
                    <c:v>5.6603376087803348</c:v>
                  </c:pt>
                  <c:pt idx="2">
                    <c:v>2.5237930349710815</c:v>
                  </c:pt>
                  <c:pt idx="3">
                    <c:v>4.3402520323547265</c:v>
                  </c:pt>
                  <c:pt idx="4">
                    <c:v>4.5326628083268599</c:v>
                  </c:pt>
                  <c:pt idx="5">
                    <c:v>3.21706286332036</c:v>
                  </c:pt>
                  <c:pt idx="6">
                    <c:v>5.6684285787082667</c:v>
                  </c:pt>
                </c:numCache>
              </c:numRef>
            </c:plus>
            <c:minus>
              <c:numRef>
                <c:f>Sheet3!$I$14:$I$20</c:f>
                <c:numCache>
                  <c:formatCode>General</c:formatCode>
                  <c:ptCount val="7"/>
                  <c:pt idx="0">
                    <c:v>2.459323750288041</c:v>
                  </c:pt>
                  <c:pt idx="1">
                    <c:v>5.6603376087803348</c:v>
                  </c:pt>
                  <c:pt idx="2">
                    <c:v>2.5237930349710815</c:v>
                  </c:pt>
                  <c:pt idx="3">
                    <c:v>4.3402520323547265</c:v>
                  </c:pt>
                  <c:pt idx="4">
                    <c:v>4.5326628083268599</c:v>
                  </c:pt>
                  <c:pt idx="5">
                    <c:v>3.21706286332036</c:v>
                  </c:pt>
                  <c:pt idx="6">
                    <c:v>5.668428578708266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3!$B$5:$B$11</c:f>
              <c:numCache>
                <c:formatCode>General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50</c:v>
                </c:pt>
                <c:pt idx="6">
                  <c:v>100</c:v>
                </c:pt>
              </c:numCache>
            </c:numRef>
          </c:cat>
          <c:val>
            <c:numRef>
              <c:f>Sheet3!$E$14:$E$20</c:f>
              <c:numCache>
                <c:formatCode>General</c:formatCode>
                <c:ptCount val="7"/>
                <c:pt idx="0">
                  <c:v>99.999999999999844</c:v>
                </c:pt>
                <c:pt idx="1">
                  <c:v>112.07222580737437</c:v>
                </c:pt>
                <c:pt idx="2">
                  <c:v>105.52436190470118</c:v>
                </c:pt>
                <c:pt idx="3">
                  <c:v>113.73915738677347</c:v>
                </c:pt>
                <c:pt idx="4">
                  <c:v>85.023196818503919</c:v>
                </c:pt>
                <c:pt idx="5">
                  <c:v>59.056156201024159</c:v>
                </c:pt>
                <c:pt idx="6">
                  <c:v>9.5306784838938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A2B-4D70-8097-4D0C29052947}"/>
            </c:ext>
          </c:extLst>
        </c:ser>
        <c:ser>
          <c:idx val="2"/>
          <c:order val="2"/>
          <c:tx>
            <c:v>U266</c:v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B$14:$AB$20</c:f>
                <c:numCache>
                  <c:formatCode>General</c:formatCode>
                  <c:ptCount val="7"/>
                  <c:pt idx="0">
                    <c:v>0.59171269514769764</c:v>
                  </c:pt>
                  <c:pt idx="1">
                    <c:v>3.663250738997343</c:v>
                  </c:pt>
                  <c:pt idx="2">
                    <c:v>3.3622724750159825</c:v>
                  </c:pt>
                  <c:pt idx="3">
                    <c:v>3.5286610125949518</c:v>
                  </c:pt>
                  <c:pt idx="4">
                    <c:v>4.6890431789451901</c:v>
                  </c:pt>
                  <c:pt idx="5">
                    <c:v>4.115356090195637</c:v>
                  </c:pt>
                  <c:pt idx="6">
                    <c:v>1.9197253184049541</c:v>
                  </c:pt>
                </c:numCache>
              </c:numRef>
            </c:plus>
            <c:minus>
              <c:numRef>
                <c:f>Sheet3!$AB$14:$AB$20</c:f>
                <c:numCache>
                  <c:formatCode>General</c:formatCode>
                  <c:ptCount val="7"/>
                  <c:pt idx="0">
                    <c:v>0.59171269514769764</c:v>
                  </c:pt>
                  <c:pt idx="1">
                    <c:v>3.663250738997343</c:v>
                  </c:pt>
                  <c:pt idx="2">
                    <c:v>3.3622724750159825</c:v>
                  </c:pt>
                  <c:pt idx="3">
                    <c:v>3.5286610125949518</c:v>
                  </c:pt>
                  <c:pt idx="4">
                    <c:v>4.6890431789451901</c:v>
                  </c:pt>
                  <c:pt idx="5">
                    <c:v>4.115356090195637</c:v>
                  </c:pt>
                  <c:pt idx="6">
                    <c:v>1.919725318404954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3!$X$14:$X$20</c:f>
              <c:numCache>
                <c:formatCode>General</c:formatCode>
                <c:ptCount val="7"/>
                <c:pt idx="0">
                  <c:v>99.999999999999702</c:v>
                </c:pt>
                <c:pt idx="1">
                  <c:v>113.69285260772826</c:v>
                </c:pt>
                <c:pt idx="2">
                  <c:v>105.62778917444453</c:v>
                </c:pt>
                <c:pt idx="3">
                  <c:v>111.62643713717357</c:v>
                </c:pt>
                <c:pt idx="4">
                  <c:v>89.047464380659477</c:v>
                </c:pt>
                <c:pt idx="5">
                  <c:v>66.045195370689243</c:v>
                </c:pt>
                <c:pt idx="6">
                  <c:v>14.1037565831260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A2B-4D70-8097-4D0C290529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YF-2</a:t>
                </a:r>
                <a:r>
                  <a:rPr lang="en-US" b="1" baseline="0"/>
                  <a:t> (</a:t>
                </a:r>
                <a:r>
                  <a:rPr lang="en-US" b="1" baseline="0">
                    <a:latin typeface="Symbol" panose="05050102010706020507" pitchFamily="18" charset="2"/>
                  </a:rPr>
                  <a:t>m</a:t>
                </a:r>
                <a:r>
                  <a:rPr lang="en-US" b="1" baseline="0"/>
                  <a:t>M)</a:t>
                </a:r>
                <a:endParaRPr lang="en-US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689110658327578"/>
          <c:y val="3.3076290995540443E-2"/>
          <c:w val="0.29166255985912354"/>
          <c:h val="0.210953731398588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839300153844585"/>
          <c:y val="0.16246767026462119"/>
          <c:w val="0.79794902460161765"/>
          <c:h val="0.63203910852823397"/>
        </c:manualLayout>
      </c:layout>
      <c:barChart>
        <c:barDir val="col"/>
        <c:grouping val="clustered"/>
        <c:varyColors val="0"/>
        <c:ser>
          <c:idx val="1"/>
          <c:order val="0"/>
          <c:tx>
            <c:v>RPMI 8226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R$23:$R$29</c:f>
                <c:numCache>
                  <c:formatCode>General</c:formatCode>
                  <c:ptCount val="7"/>
                  <c:pt idx="0">
                    <c:v>3.2032689104208929</c:v>
                  </c:pt>
                  <c:pt idx="1">
                    <c:v>1.2938650285402662</c:v>
                  </c:pt>
                  <c:pt idx="2">
                    <c:v>1.8119260701004856</c:v>
                  </c:pt>
                  <c:pt idx="3">
                    <c:v>1.2398296975197194</c:v>
                  </c:pt>
                  <c:pt idx="4">
                    <c:v>1.8809396222947288</c:v>
                  </c:pt>
                  <c:pt idx="5">
                    <c:v>5.0280557886812298</c:v>
                  </c:pt>
                  <c:pt idx="6">
                    <c:v>6.3055901177683671</c:v>
                  </c:pt>
                </c:numCache>
              </c:numRef>
            </c:plus>
            <c:minus>
              <c:numRef>
                <c:f>Sheet3!$R$23:$R$29</c:f>
                <c:numCache>
                  <c:formatCode>General</c:formatCode>
                  <c:ptCount val="7"/>
                  <c:pt idx="0">
                    <c:v>3.2032689104208929</c:v>
                  </c:pt>
                  <c:pt idx="1">
                    <c:v>1.2938650285402662</c:v>
                  </c:pt>
                  <c:pt idx="2">
                    <c:v>1.8119260701004856</c:v>
                  </c:pt>
                  <c:pt idx="3">
                    <c:v>1.2398296975197194</c:v>
                  </c:pt>
                  <c:pt idx="4">
                    <c:v>1.8809396222947288</c:v>
                  </c:pt>
                  <c:pt idx="5">
                    <c:v>5.0280557886812298</c:v>
                  </c:pt>
                  <c:pt idx="6">
                    <c:v>6.305590117768367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3!$N$23:$N$29</c:f>
              <c:numCache>
                <c:formatCode>General</c:formatCode>
                <c:ptCount val="7"/>
                <c:pt idx="0">
                  <c:v>99.999999999999702</c:v>
                </c:pt>
                <c:pt idx="1">
                  <c:v>114.4648491894566</c:v>
                </c:pt>
                <c:pt idx="2">
                  <c:v>110.54841986434796</c:v>
                </c:pt>
                <c:pt idx="3">
                  <c:v>102.65865234141917</c:v>
                </c:pt>
                <c:pt idx="4">
                  <c:v>90.82013872533345</c:v>
                </c:pt>
                <c:pt idx="5">
                  <c:v>88.624119691363049</c:v>
                </c:pt>
                <c:pt idx="6">
                  <c:v>66.8060906456292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72-42F0-87E9-C2C04C57FC39}"/>
            </c:ext>
          </c:extLst>
        </c:ser>
        <c:ser>
          <c:idx val="0"/>
          <c:order val="1"/>
          <c:tx>
            <c:v>ARH 77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I$23:$I$29</c:f>
                <c:numCache>
                  <c:formatCode>General</c:formatCode>
                  <c:ptCount val="7"/>
                  <c:pt idx="0">
                    <c:v>2.459323750288041</c:v>
                  </c:pt>
                  <c:pt idx="1">
                    <c:v>2.0262251522797494</c:v>
                  </c:pt>
                  <c:pt idx="2">
                    <c:v>0.77163993715891555</c:v>
                  </c:pt>
                  <c:pt idx="3">
                    <c:v>1.3790126088145873</c:v>
                  </c:pt>
                  <c:pt idx="4">
                    <c:v>2.8670966046087414</c:v>
                  </c:pt>
                  <c:pt idx="5">
                    <c:v>1.3860738947884987</c:v>
                  </c:pt>
                  <c:pt idx="6">
                    <c:v>3.2532954523602093</c:v>
                  </c:pt>
                </c:numCache>
              </c:numRef>
            </c:plus>
            <c:minus>
              <c:numRef>
                <c:f>Sheet3!$I$23:$I$29</c:f>
                <c:numCache>
                  <c:formatCode>General</c:formatCode>
                  <c:ptCount val="7"/>
                  <c:pt idx="0">
                    <c:v>2.459323750288041</c:v>
                  </c:pt>
                  <c:pt idx="1">
                    <c:v>2.0262251522797494</c:v>
                  </c:pt>
                  <c:pt idx="2">
                    <c:v>0.77163993715891555</c:v>
                  </c:pt>
                  <c:pt idx="3">
                    <c:v>1.3790126088145873</c:v>
                  </c:pt>
                  <c:pt idx="4">
                    <c:v>2.8670966046087414</c:v>
                  </c:pt>
                  <c:pt idx="5">
                    <c:v>1.3860738947884987</c:v>
                  </c:pt>
                  <c:pt idx="6">
                    <c:v>3.253295452360209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3!$B$5:$B$11</c:f>
              <c:numCache>
                <c:formatCode>General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50</c:v>
                </c:pt>
                <c:pt idx="6">
                  <c:v>100</c:v>
                </c:pt>
              </c:numCache>
            </c:numRef>
          </c:cat>
          <c:val>
            <c:numRef>
              <c:f>Sheet3!$E$23:$E$29</c:f>
              <c:numCache>
                <c:formatCode>General</c:formatCode>
                <c:ptCount val="7"/>
                <c:pt idx="0">
                  <c:v>99.999999999999844</c:v>
                </c:pt>
                <c:pt idx="1">
                  <c:v>108.10371333475308</c:v>
                </c:pt>
                <c:pt idx="2">
                  <c:v>99.50459199730409</c:v>
                </c:pt>
                <c:pt idx="3">
                  <c:v>94.746669252214787</c:v>
                </c:pt>
                <c:pt idx="4">
                  <c:v>89.184604967431497</c:v>
                </c:pt>
                <c:pt idx="5">
                  <c:v>52.616991820554389</c:v>
                </c:pt>
                <c:pt idx="6">
                  <c:v>69.7234485915648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72-42F0-87E9-C2C04C57FC39}"/>
            </c:ext>
          </c:extLst>
        </c:ser>
        <c:ser>
          <c:idx val="2"/>
          <c:order val="2"/>
          <c:tx>
            <c:v>U266</c:v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AB$23:$AB$29</c:f>
                <c:numCache>
                  <c:formatCode>General</c:formatCode>
                  <c:ptCount val="7"/>
                  <c:pt idx="0">
                    <c:v>0.59171269514769764</c:v>
                  </c:pt>
                  <c:pt idx="1">
                    <c:v>4.2884735275939514</c:v>
                  </c:pt>
                  <c:pt idx="2">
                    <c:v>3.118683341891372</c:v>
                  </c:pt>
                  <c:pt idx="3">
                    <c:v>1.337622499517872</c:v>
                  </c:pt>
                  <c:pt idx="4">
                    <c:v>3.4906540383690587</c:v>
                  </c:pt>
                  <c:pt idx="5">
                    <c:v>2.9053939919458611</c:v>
                  </c:pt>
                  <c:pt idx="6">
                    <c:v>4.2139159413581506</c:v>
                  </c:pt>
                </c:numCache>
              </c:numRef>
            </c:plus>
            <c:minus>
              <c:numRef>
                <c:f>Sheet3!$AB$23:$AB$29</c:f>
                <c:numCache>
                  <c:formatCode>General</c:formatCode>
                  <c:ptCount val="7"/>
                  <c:pt idx="0">
                    <c:v>0.59171269514769764</c:v>
                  </c:pt>
                  <c:pt idx="1">
                    <c:v>4.2884735275939514</c:v>
                  </c:pt>
                  <c:pt idx="2">
                    <c:v>3.118683341891372</c:v>
                  </c:pt>
                  <c:pt idx="3">
                    <c:v>1.337622499517872</c:v>
                  </c:pt>
                  <c:pt idx="4">
                    <c:v>3.4906540383690587</c:v>
                  </c:pt>
                  <c:pt idx="5">
                    <c:v>2.9053939919458611</c:v>
                  </c:pt>
                  <c:pt idx="6">
                    <c:v>4.213915941358150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3!$X$23:$X$29</c:f>
              <c:numCache>
                <c:formatCode>General</c:formatCode>
                <c:ptCount val="7"/>
                <c:pt idx="0">
                  <c:v>99.999999999999702</c:v>
                </c:pt>
                <c:pt idx="1">
                  <c:v>108.10730334499277</c:v>
                </c:pt>
                <c:pt idx="2">
                  <c:v>101.8659598184106</c:v>
                </c:pt>
                <c:pt idx="3">
                  <c:v>98.784653405335305</c:v>
                </c:pt>
                <c:pt idx="4">
                  <c:v>83.049710450014842</c:v>
                </c:pt>
                <c:pt idx="5">
                  <c:v>89.004842642747391</c:v>
                </c:pt>
                <c:pt idx="6">
                  <c:v>67.8967575474077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772-42F0-87E9-C2C04C57FC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TP.B/P300</a:t>
                </a:r>
                <a:r>
                  <a:rPr lang="en-US" b="1" baseline="0"/>
                  <a:t> (</a:t>
                </a:r>
                <a:r>
                  <a:rPr lang="en-US" b="1" baseline="0">
                    <a:latin typeface="Symbol" panose="05050102010706020507" pitchFamily="18" charset="2"/>
                  </a:rPr>
                  <a:t>m</a:t>
                </a:r>
                <a:r>
                  <a:rPr lang="en-US" b="1" baseline="0"/>
                  <a:t>M)</a:t>
                </a:r>
                <a:endParaRPr lang="en-US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339933563666185"/>
          <c:y val="3.3076290995540443E-2"/>
          <c:w val="0.32515433080573747"/>
          <c:h val="0.210953731398588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092653843180043"/>
          <c:y val="0.16246767026462119"/>
          <c:w val="0.8054156949484309"/>
          <c:h val="0.63709281131525231"/>
        </c:manualLayout>
      </c:layout>
      <c:barChart>
        <c:barDir val="col"/>
        <c:grouping val="clustered"/>
        <c:varyColors val="0"/>
        <c:ser>
          <c:idx val="2"/>
          <c:order val="0"/>
          <c:tx>
            <c:v>RPMI 8226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AA$5:$AA$11</c:f>
                <c:numCache>
                  <c:formatCode>General</c:formatCode>
                  <c:ptCount val="7"/>
                  <c:pt idx="0">
                    <c:v>1.572898638735162</c:v>
                  </c:pt>
                  <c:pt idx="1">
                    <c:v>1.5502881166193645</c:v>
                  </c:pt>
                  <c:pt idx="2">
                    <c:v>2.1853721131669288</c:v>
                  </c:pt>
                  <c:pt idx="3">
                    <c:v>1.1628251436038752</c:v>
                  </c:pt>
                  <c:pt idx="4">
                    <c:v>1.5516305945946804</c:v>
                  </c:pt>
                  <c:pt idx="5">
                    <c:v>1.8710749265673283</c:v>
                  </c:pt>
                  <c:pt idx="6">
                    <c:v>0.56661166815238651</c:v>
                  </c:pt>
                </c:numCache>
              </c:numRef>
            </c:plus>
            <c:minus>
              <c:numRef>
                <c:f>Sheet5!$AA$5:$AA$11</c:f>
                <c:numCache>
                  <c:formatCode>General</c:formatCode>
                  <c:ptCount val="7"/>
                  <c:pt idx="0">
                    <c:v>1.572898638735162</c:v>
                  </c:pt>
                  <c:pt idx="1">
                    <c:v>1.5502881166193645</c:v>
                  </c:pt>
                  <c:pt idx="2">
                    <c:v>2.1853721131669288</c:v>
                  </c:pt>
                  <c:pt idx="3">
                    <c:v>1.1628251436038752</c:v>
                  </c:pt>
                  <c:pt idx="4">
                    <c:v>1.5516305945946804</c:v>
                  </c:pt>
                  <c:pt idx="5">
                    <c:v>1.8710749265673283</c:v>
                  </c:pt>
                  <c:pt idx="6">
                    <c:v>0.5666116681523865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5!$W$5:$W$11</c:f>
              <c:numCache>
                <c:formatCode>General</c:formatCode>
                <c:ptCount val="7"/>
                <c:pt idx="0">
                  <c:v>100.00000000000004</c:v>
                </c:pt>
                <c:pt idx="1">
                  <c:v>35.828507472796623</c:v>
                </c:pt>
                <c:pt idx="2">
                  <c:v>39.230349722708695</c:v>
                </c:pt>
                <c:pt idx="3">
                  <c:v>26.222390606705542</c:v>
                </c:pt>
                <c:pt idx="4">
                  <c:v>16.590220986749028</c:v>
                </c:pt>
                <c:pt idx="5">
                  <c:v>-22.399737785373731</c:v>
                </c:pt>
                <c:pt idx="6">
                  <c:v>14.804526171680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B8-4AA6-8668-3F11EC474375}"/>
            </c:ext>
          </c:extLst>
        </c:ser>
        <c:ser>
          <c:idx val="0"/>
          <c:order val="1"/>
          <c:tx>
            <c:v>ARH-77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I$5:$I$11</c:f>
                <c:numCache>
                  <c:formatCode>General</c:formatCode>
                  <c:ptCount val="7"/>
                  <c:pt idx="0">
                    <c:v>5.7296186207584849</c:v>
                  </c:pt>
                  <c:pt idx="1">
                    <c:v>2.078813368871379</c:v>
                  </c:pt>
                  <c:pt idx="2">
                    <c:v>1.1669245619325752</c:v>
                  </c:pt>
                  <c:pt idx="3">
                    <c:v>2.8513944553486388</c:v>
                  </c:pt>
                  <c:pt idx="4">
                    <c:v>2.0824725069570054</c:v>
                  </c:pt>
                  <c:pt idx="5">
                    <c:v>0.71882219932873781</c:v>
                  </c:pt>
                  <c:pt idx="6">
                    <c:v>0.81002514561783356</c:v>
                  </c:pt>
                </c:numCache>
              </c:numRef>
            </c:plus>
            <c:minus>
              <c:numRef>
                <c:f>Sheet5!$I$5:$I$11</c:f>
                <c:numCache>
                  <c:formatCode>General</c:formatCode>
                  <c:ptCount val="7"/>
                  <c:pt idx="0">
                    <c:v>5.7296186207584849</c:v>
                  </c:pt>
                  <c:pt idx="1">
                    <c:v>2.078813368871379</c:v>
                  </c:pt>
                  <c:pt idx="2">
                    <c:v>1.1669245619325752</c:v>
                  </c:pt>
                  <c:pt idx="3">
                    <c:v>2.8513944553486388</c:v>
                  </c:pt>
                  <c:pt idx="4">
                    <c:v>2.0824725069570054</c:v>
                  </c:pt>
                  <c:pt idx="5">
                    <c:v>0.71882219932873781</c:v>
                  </c:pt>
                  <c:pt idx="6">
                    <c:v>0.8100251456178335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5!$B$5:$B$11</c:f>
              <c:numCache>
                <c:formatCode>General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50</c:v>
                </c:pt>
                <c:pt idx="6">
                  <c:v>100</c:v>
                </c:pt>
              </c:numCache>
            </c:numRef>
          </c:cat>
          <c:val>
            <c:numRef>
              <c:f>Sheet5!$E$5:$E$11</c:f>
              <c:numCache>
                <c:formatCode>General</c:formatCode>
                <c:ptCount val="7"/>
                <c:pt idx="0">
                  <c:v>100.00000000000004</c:v>
                </c:pt>
                <c:pt idx="1">
                  <c:v>100.66611418866864</c:v>
                </c:pt>
                <c:pt idx="2">
                  <c:v>97.561989147506708</c:v>
                </c:pt>
                <c:pt idx="3">
                  <c:v>83.022201470022495</c:v>
                </c:pt>
                <c:pt idx="4">
                  <c:v>71.207271928054197</c:v>
                </c:pt>
                <c:pt idx="5">
                  <c:v>17.961584142613429</c:v>
                </c:pt>
                <c:pt idx="6">
                  <c:v>31.6053126857114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B8-4AA6-8668-3F11EC474375}"/>
            </c:ext>
          </c:extLst>
        </c:ser>
        <c:ser>
          <c:idx val="1"/>
          <c:order val="2"/>
          <c:tx>
            <c:v>U266</c:v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R$5:$R$11</c:f>
                <c:numCache>
                  <c:formatCode>General</c:formatCode>
                  <c:ptCount val="7"/>
                  <c:pt idx="0">
                    <c:v>2.4698946157028638</c:v>
                  </c:pt>
                  <c:pt idx="1">
                    <c:v>0.19264063576743667</c:v>
                  </c:pt>
                  <c:pt idx="2">
                    <c:v>1.8484893699737104</c:v>
                  </c:pt>
                  <c:pt idx="3">
                    <c:v>2.6452279234071137</c:v>
                  </c:pt>
                  <c:pt idx="4">
                    <c:v>0.31257180637509741</c:v>
                  </c:pt>
                  <c:pt idx="5">
                    <c:v>1.0203835791395615</c:v>
                  </c:pt>
                  <c:pt idx="6">
                    <c:v>2.2231890807804753</c:v>
                  </c:pt>
                </c:numCache>
              </c:numRef>
            </c:plus>
            <c:minus>
              <c:numRef>
                <c:f>Sheet5!$R$5:$R$11</c:f>
                <c:numCache>
                  <c:formatCode>General</c:formatCode>
                  <c:ptCount val="7"/>
                  <c:pt idx="0">
                    <c:v>2.4698946157028638</c:v>
                  </c:pt>
                  <c:pt idx="1">
                    <c:v>0.19264063576743667</c:v>
                  </c:pt>
                  <c:pt idx="2">
                    <c:v>1.8484893699737104</c:v>
                  </c:pt>
                  <c:pt idx="3">
                    <c:v>2.6452279234071137</c:v>
                  </c:pt>
                  <c:pt idx="4">
                    <c:v>0.31257180637509741</c:v>
                  </c:pt>
                  <c:pt idx="5">
                    <c:v>1.0203835791395615</c:v>
                  </c:pt>
                  <c:pt idx="6">
                    <c:v>2.223189080780475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5!$N$5:$N$11</c:f>
              <c:numCache>
                <c:formatCode>General</c:formatCode>
                <c:ptCount val="7"/>
                <c:pt idx="0">
                  <c:v>99.999999999999986</c:v>
                </c:pt>
                <c:pt idx="1">
                  <c:v>70.022273637553553</c:v>
                </c:pt>
                <c:pt idx="2">
                  <c:v>51.671627221782714</c:v>
                </c:pt>
                <c:pt idx="3">
                  <c:v>54.387296602628702</c:v>
                </c:pt>
                <c:pt idx="4">
                  <c:v>46.284468597753104</c:v>
                </c:pt>
                <c:pt idx="5">
                  <c:v>2.3103481170087798</c:v>
                </c:pt>
                <c:pt idx="6">
                  <c:v>16.2148517533420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4B8-4AA6-8668-3F11EC4743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Nexturastat</a:t>
                </a:r>
                <a:r>
                  <a:rPr lang="en-US" b="1" baseline="0"/>
                  <a:t>-A (</a:t>
                </a:r>
                <a:r>
                  <a:rPr lang="en-US" b="1" baseline="0">
                    <a:latin typeface="Symbol" panose="05050102010706020507" pitchFamily="18" charset="2"/>
                  </a:rPr>
                  <a:t>m</a:t>
                </a:r>
                <a:r>
                  <a:rPr lang="en-US" b="1" baseline="0"/>
                  <a:t>M)</a:t>
                </a:r>
                <a:endParaRPr lang="en-US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338400476337436"/>
          <c:y val="3.3076290995540443E-2"/>
          <c:w val="0.35169701819902421"/>
          <c:h val="0.24093220273892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236002138365309"/>
          <c:y val="0.16246767026462119"/>
          <c:w val="0.773982264641773"/>
          <c:h val="0.63709281131525231"/>
        </c:manualLayout>
      </c:layout>
      <c:barChart>
        <c:barDir val="col"/>
        <c:grouping val="clustered"/>
        <c:varyColors val="0"/>
        <c:ser>
          <c:idx val="2"/>
          <c:order val="0"/>
          <c:tx>
            <c:v>RPMI 8226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AA$13:$AA$19</c:f>
                <c:numCache>
                  <c:formatCode>General</c:formatCode>
                  <c:ptCount val="7"/>
                  <c:pt idx="0">
                    <c:v>1.572898638735162</c:v>
                  </c:pt>
                  <c:pt idx="1">
                    <c:v>0.59106966887978574</c:v>
                  </c:pt>
                  <c:pt idx="2">
                    <c:v>0.93875072641084611</c:v>
                  </c:pt>
                  <c:pt idx="3">
                    <c:v>0.68184026462445213</c:v>
                  </c:pt>
                  <c:pt idx="4">
                    <c:v>2.6055975807948877</c:v>
                  </c:pt>
                  <c:pt idx="5">
                    <c:v>1.8186412127786329</c:v>
                  </c:pt>
                  <c:pt idx="6">
                    <c:v>2.8870221359696697</c:v>
                  </c:pt>
                </c:numCache>
              </c:numRef>
            </c:plus>
            <c:minus>
              <c:numRef>
                <c:f>Sheet5!$AA$13:$AA$19</c:f>
                <c:numCache>
                  <c:formatCode>General</c:formatCode>
                  <c:ptCount val="7"/>
                  <c:pt idx="0">
                    <c:v>1.572898638735162</c:v>
                  </c:pt>
                  <c:pt idx="1">
                    <c:v>0.59106966887978574</c:v>
                  </c:pt>
                  <c:pt idx="2">
                    <c:v>0.93875072641084611</c:v>
                  </c:pt>
                  <c:pt idx="3">
                    <c:v>0.68184026462445213</c:v>
                  </c:pt>
                  <c:pt idx="4">
                    <c:v>2.6055975807948877</c:v>
                  </c:pt>
                  <c:pt idx="5">
                    <c:v>1.8186412127786329</c:v>
                  </c:pt>
                  <c:pt idx="6">
                    <c:v>2.887022135969669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5!$W$13:$W$19</c:f>
              <c:numCache>
                <c:formatCode>General</c:formatCode>
                <c:ptCount val="7"/>
                <c:pt idx="0">
                  <c:v>100.00000000000004</c:v>
                </c:pt>
                <c:pt idx="1">
                  <c:v>47.674278962908609</c:v>
                </c:pt>
                <c:pt idx="2">
                  <c:v>49.330051836727598</c:v>
                </c:pt>
                <c:pt idx="3">
                  <c:v>59.00960718847751</c:v>
                </c:pt>
                <c:pt idx="4">
                  <c:v>56.663879030303463</c:v>
                </c:pt>
                <c:pt idx="5">
                  <c:v>1.0910501646244033</c:v>
                </c:pt>
                <c:pt idx="6">
                  <c:v>-43.453212138864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0A-46CF-8C2B-81C8AB6063E1}"/>
            </c:ext>
          </c:extLst>
        </c:ser>
        <c:ser>
          <c:idx val="0"/>
          <c:order val="1"/>
          <c:tx>
            <c:v>ARH-77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I$13:$I$19</c:f>
                <c:numCache>
                  <c:formatCode>General</c:formatCode>
                  <c:ptCount val="7"/>
                  <c:pt idx="0">
                    <c:v>5.7296186207584849</c:v>
                  </c:pt>
                  <c:pt idx="1">
                    <c:v>2.5770702908761214</c:v>
                  </c:pt>
                  <c:pt idx="2">
                    <c:v>5.2080840817248637</c:v>
                  </c:pt>
                  <c:pt idx="3">
                    <c:v>3.2576476632919822</c:v>
                  </c:pt>
                  <c:pt idx="4">
                    <c:v>6.4618956985377132</c:v>
                  </c:pt>
                  <c:pt idx="5">
                    <c:v>1.7117992488600842</c:v>
                  </c:pt>
                  <c:pt idx="6">
                    <c:v>0.37550912591192531</c:v>
                  </c:pt>
                </c:numCache>
              </c:numRef>
            </c:plus>
            <c:minus>
              <c:numRef>
                <c:f>Sheet5!$I$13:$I$19</c:f>
                <c:numCache>
                  <c:formatCode>General</c:formatCode>
                  <c:ptCount val="7"/>
                  <c:pt idx="0">
                    <c:v>5.7296186207584849</c:v>
                  </c:pt>
                  <c:pt idx="1">
                    <c:v>2.5770702908761214</c:v>
                  </c:pt>
                  <c:pt idx="2">
                    <c:v>5.2080840817248637</c:v>
                  </c:pt>
                  <c:pt idx="3">
                    <c:v>3.2576476632919822</c:v>
                  </c:pt>
                  <c:pt idx="4">
                    <c:v>6.4618956985377132</c:v>
                  </c:pt>
                  <c:pt idx="5">
                    <c:v>1.7117992488600842</c:v>
                  </c:pt>
                  <c:pt idx="6">
                    <c:v>0.3755091259119253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5!$B$5:$B$11</c:f>
              <c:numCache>
                <c:formatCode>General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50</c:v>
                </c:pt>
                <c:pt idx="6">
                  <c:v>100</c:v>
                </c:pt>
              </c:numCache>
            </c:numRef>
          </c:cat>
          <c:val>
            <c:numRef>
              <c:f>Sheet5!$E$13:$E$19</c:f>
              <c:numCache>
                <c:formatCode>General</c:formatCode>
                <c:ptCount val="7"/>
                <c:pt idx="0">
                  <c:v>100.00000000000004</c:v>
                </c:pt>
                <c:pt idx="1">
                  <c:v>107.53673735424375</c:v>
                </c:pt>
                <c:pt idx="2">
                  <c:v>100.77117479048133</c:v>
                </c:pt>
                <c:pt idx="3">
                  <c:v>105.20089756197517</c:v>
                </c:pt>
                <c:pt idx="4">
                  <c:v>99.580875069282797</c:v>
                </c:pt>
                <c:pt idx="5">
                  <c:v>93.077946079756359</c:v>
                </c:pt>
                <c:pt idx="6">
                  <c:v>-0.404478099762803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90A-46CF-8C2B-81C8AB6063E1}"/>
            </c:ext>
          </c:extLst>
        </c:ser>
        <c:ser>
          <c:idx val="1"/>
          <c:order val="2"/>
          <c:tx>
            <c:v>U266</c:v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R$13:$R$19</c:f>
                <c:numCache>
                  <c:formatCode>General</c:formatCode>
                  <c:ptCount val="7"/>
                  <c:pt idx="0">
                    <c:v>2.4698946157028638</c:v>
                  </c:pt>
                  <c:pt idx="1">
                    <c:v>1.5793601517805209</c:v>
                  </c:pt>
                  <c:pt idx="2">
                    <c:v>1.1678437559774282</c:v>
                  </c:pt>
                  <c:pt idx="3">
                    <c:v>3.3762814238571699</c:v>
                  </c:pt>
                  <c:pt idx="4">
                    <c:v>1.3778830597043725</c:v>
                  </c:pt>
                  <c:pt idx="5">
                    <c:v>0.88576854406699468</c:v>
                  </c:pt>
                  <c:pt idx="6">
                    <c:v>0.6595547848202451</c:v>
                  </c:pt>
                </c:numCache>
              </c:numRef>
            </c:plus>
            <c:minus>
              <c:numRef>
                <c:f>Sheet5!$R$13:$R$19</c:f>
                <c:numCache>
                  <c:formatCode>General</c:formatCode>
                  <c:ptCount val="7"/>
                  <c:pt idx="0">
                    <c:v>2.4698946157028638</c:v>
                  </c:pt>
                  <c:pt idx="1">
                    <c:v>1.5793601517805209</c:v>
                  </c:pt>
                  <c:pt idx="2">
                    <c:v>1.1678437559774282</c:v>
                  </c:pt>
                  <c:pt idx="3">
                    <c:v>3.3762814238571699</c:v>
                  </c:pt>
                  <c:pt idx="4">
                    <c:v>1.3778830597043725</c:v>
                  </c:pt>
                  <c:pt idx="5">
                    <c:v>0.88576854406699468</c:v>
                  </c:pt>
                  <c:pt idx="6">
                    <c:v>0.659554784820245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5!$N$13:$N$19</c:f>
              <c:numCache>
                <c:formatCode>General</c:formatCode>
                <c:ptCount val="7"/>
                <c:pt idx="0">
                  <c:v>99.999999999999986</c:v>
                </c:pt>
                <c:pt idx="1">
                  <c:v>91.694699157159306</c:v>
                </c:pt>
                <c:pt idx="2">
                  <c:v>95.303160677256884</c:v>
                </c:pt>
                <c:pt idx="3">
                  <c:v>70.186465759120736</c:v>
                </c:pt>
                <c:pt idx="4">
                  <c:v>80.367716610695041</c:v>
                </c:pt>
                <c:pt idx="5">
                  <c:v>47.696749052574958</c:v>
                </c:pt>
                <c:pt idx="6">
                  <c:v>-34.8338053075114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90A-46CF-8C2B-81C8AB6063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YF-2</a:t>
                </a:r>
                <a:r>
                  <a:rPr lang="en-US" b="1" baseline="0"/>
                  <a:t> (</a:t>
                </a:r>
                <a:r>
                  <a:rPr lang="en-US" b="1" baseline="0">
                    <a:latin typeface="Symbol" panose="05050102010706020507" pitchFamily="18" charset="2"/>
                  </a:rPr>
                  <a:t>m</a:t>
                </a:r>
                <a:r>
                  <a:rPr lang="en-US" b="1" baseline="0"/>
                  <a:t>M)</a:t>
                </a:r>
                <a:endParaRPr lang="en-US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6608382881266504"/>
          <c:y val="3.3076262929150509E-2"/>
          <c:w val="0.27458378504945918"/>
          <c:h val="0.189742397266058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1215 0.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2685777914650288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934218609760238"/>
          <c:y val="0.13004629629629633"/>
          <c:w val="0.77930902346021935"/>
          <c:h val="0.62567680635810374"/>
        </c:manualLayout>
      </c:layout>
      <c:scatterChart>
        <c:scatterStyle val="lineMarker"/>
        <c:varyColors val="0"/>
        <c:ser>
          <c:idx val="0"/>
          <c:order val="0"/>
          <c:tx>
            <c:v>RPMI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X$28:$X$35</c:f>
                <c:numCache>
                  <c:formatCode>General</c:formatCode>
                  <c:ptCount val="8"/>
                  <c:pt idx="0">
                    <c:v>6.6988145885609072</c:v>
                  </c:pt>
                  <c:pt idx="1">
                    <c:v>6.6642372926583553</c:v>
                  </c:pt>
                  <c:pt idx="2">
                    <c:v>1.3946070165739499</c:v>
                  </c:pt>
                  <c:pt idx="3">
                    <c:v>2.1644978148053462</c:v>
                  </c:pt>
                  <c:pt idx="4">
                    <c:v>1.3048093277417314</c:v>
                  </c:pt>
                  <c:pt idx="5">
                    <c:v>0.83623690525066208</c:v>
                  </c:pt>
                  <c:pt idx="6">
                    <c:v>2.3943060665826366</c:v>
                  </c:pt>
                  <c:pt idx="7">
                    <c:v>0.70533246202283739</c:v>
                  </c:pt>
                </c:numCache>
              </c:numRef>
            </c:plus>
            <c:minus>
              <c:numRef>
                <c:f>[1]Sheet1!$X$28:$X$35</c:f>
                <c:numCache>
                  <c:formatCode>General</c:formatCode>
                  <c:ptCount val="8"/>
                  <c:pt idx="0">
                    <c:v>6.6988145885609072</c:v>
                  </c:pt>
                  <c:pt idx="1">
                    <c:v>6.6642372926583553</c:v>
                  </c:pt>
                  <c:pt idx="2">
                    <c:v>1.3946070165739499</c:v>
                  </c:pt>
                  <c:pt idx="3">
                    <c:v>2.1644978148053462</c:v>
                  </c:pt>
                  <c:pt idx="4">
                    <c:v>1.3048093277417314</c:v>
                  </c:pt>
                  <c:pt idx="5">
                    <c:v>0.83623690525066208</c:v>
                  </c:pt>
                  <c:pt idx="6">
                    <c:v>2.3943060665826366</c:v>
                  </c:pt>
                  <c:pt idx="7">
                    <c:v>0.7053324620228373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V$28:$V$35</c:f>
              <c:numCache>
                <c:formatCode>General</c:formatCode>
                <c:ptCount val="8"/>
                <c:pt idx="0">
                  <c:v>138.75939168446294</c:v>
                </c:pt>
                <c:pt idx="1">
                  <c:v>105.33312141472042</c:v>
                </c:pt>
                <c:pt idx="2">
                  <c:v>112.25517872520903</c:v>
                </c:pt>
                <c:pt idx="3">
                  <c:v>101.50795312176506</c:v>
                </c:pt>
                <c:pt idx="4">
                  <c:v>103.75682597605319</c:v>
                </c:pt>
                <c:pt idx="5">
                  <c:v>99.155329164452013</c:v>
                </c:pt>
                <c:pt idx="6">
                  <c:v>101.58700048729796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1C2-4A18-95D9-21AE56A6DD46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G$28:$AG$35</c:f>
                <c:numCache>
                  <c:formatCode>General</c:formatCode>
                  <c:ptCount val="8"/>
                  <c:pt idx="0">
                    <c:v>1.460429004023047</c:v>
                  </c:pt>
                  <c:pt idx="1">
                    <c:v>4.2774053100005327</c:v>
                  </c:pt>
                  <c:pt idx="2">
                    <c:v>0.4330661716772275</c:v>
                  </c:pt>
                  <c:pt idx="3">
                    <c:v>1.0671364284855935</c:v>
                  </c:pt>
                  <c:pt idx="4">
                    <c:v>0.64023565019391582</c:v>
                  </c:pt>
                  <c:pt idx="5">
                    <c:v>1.363596459659171</c:v>
                  </c:pt>
                  <c:pt idx="6">
                    <c:v>2.344645031349923</c:v>
                  </c:pt>
                  <c:pt idx="7">
                    <c:v>1.6986304427714487</c:v>
                  </c:pt>
                </c:numCache>
              </c:numRef>
            </c:plus>
            <c:minus>
              <c:numRef>
                <c:f>[1]Sheet1!$AG$28:$AG$35</c:f>
                <c:numCache>
                  <c:formatCode>General</c:formatCode>
                  <c:ptCount val="8"/>
                  <c:pt idx="0">
                    <c:v>1.460429004023047</c:v>
                  </c:pt>
                  <c:pt idx="1">
                    <c:v>4.2774053100005327</c:v>
                  </c:pt>
                  <c:pt idx="2">
                    <c:v>0.4330661716772275</c:v>
                  </c:pt>
                  <c:pt idx="3">
                    <c:v>1.0671364284855935</c:v>
                  </c:pt>
                  <c:pt idx="4">
                    <c:v>0.64023565019391582</c:v>
                  </c:pt>
                  <c:pt idx="5">
                    <c:v>1.363596459659171</c:v>
                  </c:pt>
                  <c:pt idx="6">
                    <c:v>2.344645031349923</c:v>
                  </c:pt>
                  <c:pt idx="7">
                    <c:v>1.698630442771448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E$28:$AE$35</c:f>
              <c:numCache>
                <c:formatCode>General</c:formatCode>
                <c:ptCount val="8"/>
                <c:pt idx="0">
                  <c:v>140.77194942674171</c:v>
                </c:pt>
                <c:pt idx="1">
                  <c:v>129.66921326762207</c:v>
                </c:pt>
                <c:pt idx="2">
                  <c:v>124.79337075996767</c:v>
                </c:pt>
                <c:pt idx="3">
                  <c:v>115.54368897550553</c:v>
                </c:pt>
                <c:pt idx="4">
                  <c:v>97.325658205082576</c:v>
                </c:pt>
                <c:pt idx="5">
                  <c:v>96.956213697564422</c:v>
                </c:pt>
                <c:pt idx="6">
                  <c:v>100.50192025755511</c:v>
                </c:pt>
                <c:pt idx="7">
                  <c:v>100.00000000000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1C2-4A18-95D9-21AE56A6DD46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O$28:$AO$35</c:f>
                <c:numCache>
                  <c:formatCode>General</c:formatCode>
                  <c:ptCount val="8"/>
                  <c:pt idx="0">
                    <c:v>1.0905685046152436</c:v>
                  </c:pt>
                  <c:pt idx="1">
                    <c:v>2.3364889027215696</c:v>
                  </c:pt>
                  <c:pt idx="2">
                    <c:v>0.58576820711206457</c:v>
                  </c:pt>
                  <c:pt idx="3">
                    <c:v>4.6948568679806737</c:v>
                  </c:pt>
                  <c:pt idx="4">
                    <c:v>0.1374169151152054</c:v>
                  </c:pt>
                  <c:pt idx="5">
                    <c:v>3.2394156474389471</c:v>
                  </c:pt>
                  <c:pt idx="6">
                    <c:v>1.5836616083120134</c:v>
                  </c:pt>
                  <c:pt idx="7">
                    <c:v>2.3466791317107205</c:v>
                  </c:pt>
                </c:numCache>
              </c:numRef>
            </c:plus>
            <c:minus>
              <c:numRef>
                <c:f>[1]Sheet1!$AO$28:$AO$35</c:f>
                <c:numCache>
                  <c:formatCode>General</c:formatCode>
                  <c:ptCount val="8"/>
                  <c:pt idx="0">
                    <c:v>1.0905685046152436</c:v>
                  </c:pt>
                  <c:pt idx="1">
                    <c:v>2.3364889027215696</c:v>
                  </c:pt>
                  <c:pt idx="2">
                    <c:v>0.58576820711206457</c:v>
                  </c:pt>
                  <c:pt idx="3">
                    <c:v>4.6948568679806737</c:v>
                  </c:pt>
                  <c:pt idx="4">
                    <c:v>0.1374169151152054</c:v>
                  </c:pt>
                  <c:pt idx="5">
                    <c:v>3.2394156474389471</c:v>
                  </c:pt>
                  <c:pt idx="6">
                    <c:v>1.5836616083120134</c:v>
                  </c:pt>
                  <c:pt idx="7">
                    <c:v>2.346679131710720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M$28:$AM$35</c:f>
              <c:numCache>
                <c:formatCode>General</c:formatCode>
                <c:ptCount val="8"/>
                <c:pt idx="0">
                  <c:v>147.48915610118428</c:v>
                </c:pt>
                <c:pt idx="1">
                  <c:v>157.04245779825268</c:v>
                </c:pt>
                <c:pt idx="2">
                  <c:v>133.90745780115881</c:v>
                </c:pt>
                <c:pt idx="3">
                  <c:v>123.25981571273562</c:v>
                </c:pt>
                <c:pt idx="4">
                  <c:v>106.51404998044535</c:v>
                </c:pt>
                <c:pt idx="5">
                  <c:v>105.98370906279442</c:v>
                </c:pt>
                <c:pt idx="6">
                  <c:v>101.54871794304402</c:v>
                </c:pt>
                <c:pt idx="7">
                  <c:v>100.00000000000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1C2-4A18-95D9-21AE56A6DD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ime (h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613126499880229"/>
          <c:y val="0.46784995625546805"/>
          <c:w val="0.36541175978982365"/>
          <c:h val="0.260217993584135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283954481906369"/>
          <c:y val="0.16246767026462119"/>
          <c:w val="0.78350274916455931"/>
          <c:h val="0.63709281131525231"/>
        </c:manualLayout>
      </c:layout>
      <c:barChart>
        <c:barDir val="col"/>
        <c:grouping val="clustered"/>
        <c:varyColors val="0"/>
        <c:ser>
          <c:idx val="2"/>
          <c:order val="0"/>
          <c:tx>
            <c:v>RPMI 8226</c:v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AA$23:$AA$29</c:f>
                <c:numCache>
                  <c:formatCode>General</c:formatCode>
                  <c:ptCount val="7"/>
                  <c:pt idx="0">
                    <c:v>1.572898638735162</c:v>
                  </c:pt>
                  <c:pt idx="1">
                    <c:v>0.40954382095247405</c:v>
                  </c:pt>
                  <c:pt idx="2">
                    <c:v>1.1755367484115835</c:v>
                  </c:pt>
                  <c:pt idx="3">
                    <c:v>1.8981743984018171</c:v>
                  </c:pt>
                  <c:pt idx="4">
                    <c:v>1.5550622797403872</c:v>
                  </c:pt>
                  <c:pt idx="5">
                    <c:v>2.477062054509473</c:v>
                  </c:pt>
                  <c:pt idx="6">
                    <c:v>3.783390122605538</c:v>
                  </c:pt>
                </c:numCache>
              </c:numRef>
            </c:plus>
            <c:minus>
              <c:numRef>
                <c:f>Sheet5!$AA$23:$AA$29</c:f>
                <c:numCache>
                  <c:formatCode>General</c:formatCode>
                  <c:ptCount val="7"/>
                  <c:pt idx="0">
                    <c:v>1.572898638735162</c:v>
                  </c:pt>
                  <c:pt idx="1">
                    <c:v>0.40954382095247405</c:v>
                  </c:pt>
                  <c:pt idx="2">
                    <c:v>1.1755367484115835</c:v>
                  </c:pt>
                  <c:pt idx="3">
                    <c:v>1.8981743984018171</c:v>
                  </c:pt>
                  <c:pt idx="4">
                    <c:v>1.5550622797403872</c:v>
                  </c:pt>
                  <c:pt idx="5">
                    <c:v>2.477062054509473</c:v>
                  </c:pt>
                  <c:pt idx="6">
                    <c:v>3.783390122605538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5!$W$23:$W$29</c:f>
              <c:numCache>
                <c:formatCode>General</c:formatCode>
                <c:ptCount val="7"/>
                <c:pt idx="0">
                  <c:v>100.00000000000004</c:v>
                </c:pt>
                <c:pt idx="1">
                  <c:v>79.952004279523862</c:v>
                </c:pt>
                <c:pt idx="2">
                  <c:v>82.816568674552684</c:v>
                </c:pt>
                <c:pt idx="3">
                  <c:v>92.28424928788408</c:v>
                </c:pt>
                <c:pt idx="4">
                  <c:v>113.63834056467471</c:v>
                </c:pt>
                <c:pt idx="5">
                  <c:v>129.88691223086721</c:v>
                </c:pt>
                <c:pt idx="6">
                  <c:v>157.457926832667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4B-4378-BC6C-81BF6D1FBD46}"/>
            </c:ext>
          </c:extLst>
        </c:ser>
        <c:ser>
          <c:idx val="0"/>
          <c:order val="1"/>
          <c:tx>
            <c:v>ARH-77</c:v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I$23:$I$29</c:f>
                <c:numCache>
                  <c:formatCode>General</c:formatCode>
                  <c:ptCount val="7"/>
                  <c:pt idx="0">
                    <c:v>5.7296186207584849</c:v>
                  </c:pt>
                  <c:pt idx="1">
                    <c:v>3.1644704004582991</c:v>
                  </c:pt>
                  <c:pt idx="2">
                    <c:v>3.9114772078458948</c:v>
                  </c:pt>
                  <c:pt idx="3">
                    <c:v>1.4206025072481328</c:v>
                  </c:pt>
                  <c:pt idx="4">
                    <c:v>1.6687819697111341</c:v>
                  </c:pt>
                  <c:pt idx="5">
                    <c:v>1.8108933364589828</c:v>
                  </c:pt>
                  <c:pt idx="6">
                    <c:v>2.7744105621858859</c:v>
                  </c:pt>
                </c:numCache>
              </c:numRef>
            </c:plus>
            <c:minus>
              <c:numRef>
                <c:f>Sheet5!$I$23:$I$29</c:f>
                <c:numCache>
                  <c:formatCode>General</c:formatCode>
                  <c:ptCount val="7"/>
                  <c:pt idx="0">
                    <c:v>5.7296186207584849</c:v>
                  </c:pt>
                  <c:pt idx="1">
                    <c:v>3.1644704004582991</c:v>
                  </c:pt>
                  <c:pt idx="2">
                    <c:v>3.9114772078458948</c:v>
                  </c:pt>
                  <c:pt idx="3">
                    <c:v>1.4206025072481328</c:v>
                  </c:pt>
                  <c:pt idx="4">
                    <c:v>1.6687819697111341</c:v>
                  </c:pt>
                  <c:pt idx="5">
                    <c:v>1.8108933364589828</c:v>
                  </c:pt>
                  <c:pt idx="6">
                    <c:v>2.774410562185885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5!$B$5:$B$11</c:f>
              <c:numCache>
                <c:formatCode>General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50</c:v>
                </c:pt>
                <c:pt idx="6">
                  <c:v>100</c:v>
                </c:pt>
              </c:numCache>
            </c:numRef>
          </c:cat>
          <c:val>
            <c:numRef>
              <c:f>Sheet5!$E$23:$E$29</c:f>
              <c:numCache>
                <c:formatCode>General</c:formatCode>
                <c:ptCount val="7"/>
                <c:pt idx="0">
                  <c:v>100.00000000000004</c:v>
                </c:pt>
                <c:pt idx="1">
                  <c:v>87.633605070559938</c:v>
                </c:pt>
                <c:pt idx="2">
                  <c:v>89.022820231094002</c:v>
                </c:pt>
                <c:pt idx="3">
                  <c:v>86.474186441987172</c:v>
                </c:pt>
                <c:pt idx="4">
                  <c:v>95.851894181978849</c:v>
                </c:pt>
                <c:pt idx="5">
                  <c:v>90.797161182207276</c:v>
                </c:pt>
                <c:pt idx="6">
                  <c:v>121.32844115484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4B-4378-BC6C-81BF6D1FBD46}"/>
            </c:ext>
          </c:extLst>
        </c:ser>
        <c:ser>
          <c:idx val="1"/>
          <c:order val="2"/>
          <c:tx>
            <c:v>U266</c:v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R$23:$R$29</c:f>
                <c:numCache>
                  <c:formatCode>General</c:formatCode>
                  <c:ptCount val="7"/>
                  <c:pt idx="0">
                    <c:v>2.4698946157028638</c:v>
                  </c:pt>
                  <c:pt idx="1">
                    <c:v>1.2170643589838361</c:v>
                  </c:pt>
                  <c:pt idx="2">
                    <c:v>2.6409648651138067</c:v>
                  </c:pt>
                  <c:pt idx="3">
                    <c:v>3.249040831558299</c:v>
                  </c:pt>
                  <c:pt idx="4">
                    <c:v>3.4895236335596942</c:v>
                  </c:pt>
                  <c:pt idx="5">
                    <c:v>3.7588703262390077</c:v>
                  </c:pt>
                  <c:pt idx="6">
                    <c:v>3.9616230258081719</c:v>
                  </c:pt>
                </c:numCache>
              </c:numRef>
            </c:plus>
            <c:minus>
              <c:numRef>
                <c:f>Sheet5!$R$23:$R$29</c:f>
                <c:numCache>
                  <c:formatCode>General</c:formatCode>
                  <c:ptCount val="7"/>
                  <c:pt idx="0">
                    <c:v>2.4698946157028638</c:v>
                  </c:pt>
                  <c:pt idx="1">
                    <c:v>1.2170643589838361</c:v>
                  </c:pt>
                  <c:pt idx="2">
                    <c:v>2.6409648651138067</c:v>
                  </c:pt>
                  <c:pt idx="3">
                    <c:v>3.249040831558299</c:v>
                  </c:pt>
                  <c:pt idx="4">
                    <c:v>3.4895236335596942</c:v>
                  </c:pt>
                  <c:pt idx="5">
                    <c:v>3.7588703262390077</c:v>
                  </c:pt>
                  <c:pt idx="6">
                    <c:v>3.961623025808171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val>
            <c:numRef>
              <c:f>Sheet5!$N$23:$N$29</c:f>
              <c:numCache>
                <c:formatCode>General</c:formatCode>
                <c:ptCount val="7"/>
                <c:pt idx="0">
                  <c:v>99.999999999999986</c:v>
                </c:pt>
                <c:pt idx="1">
                  <c:v>81.681456406862324</c:v>
                </c:pt>
                <c:pt idx="2">
                  <c:v>83.588839227227538</c:v>
                </c:pt>
                <c:pt idx="3">
                  <c:v>72.90039459358151</c:v>
                </c:pt>
                <c:pt idx="4">
                  <c:v>69.626743956733037</c:v>
                </c:pt>
                <c:pt idx="5">
                  <c:v>108.90611573598446</c:v>
                </c:pt>
                <c:pt idx="6">
                  <c:v>146.926702902793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74B-4378-BC6C-81BF6D1FBD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07278200"/>
        <c:axId val="1131435656"/>
      </c:barChart>
      <c:catAx>
        <c:axId val="6072782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CTPB/P300</a:t>
                </a:r>
                <a:r>
                  <a:rPr lang="en-US" b="1" baseline="0"/>
                  <a:t> (</a:t>
                </a:r>
                <a:r>
                  <a:rPr lang="en-US" b="1" baseline="0">
                    <a:latin typeface="Symbol" panose="05050102010706020507" pitchFamily="18" charset="2"/>
                  </a:rPr>
                  <a:t>m</a:t>
                </a:r>
                <a:r>
                  <a:rPr lang="en-US" b="1" baseline="0"/>
                  <a:t>M)</a:t>
                </a:r>
                <a:endParaRPr lang="en-US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auto val="1"/>
        <c:lblAlgn val="ctr"/>
        <c:lblOffset val="100"/>
        <c:tickMarkSkip val="1"/>
        <c:noMultiLvlLbl val="0"/>
      </c:catAx>
      <c:valAx>
        <c:axId val="1131435656"/>
        <c:scaling>
          <c:orientation val="minMax"/>
          <c:max val="18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5260596335378329"/>
          <c:y val="3.3076290995540443E-2"/>
          <c:w val="0.26247526426124601"/>
          <c:h val="0.19457893188245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Tubastatin-A 1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28416393323317957"/>
          <c:y val="5.092592592592592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557804737125477"/>
          <c:y val="0.13004629629629633"/>
          <c:w val="0.79307333132533087"/>
          <c:h val="0.69525036395554773"/>
        </c:manualLayout>
      </c:layout>
      <c:scatterChart>
        <c:scatterStyle val="lineMarker"/>
        <c:varyColors val="0"/>
        <c:ser>
          <c:idx val="0"/>
          <c:order val="0"/>
          <c:tx>
            <c:v>RPMI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X$63:$X$70</c:f>
                <c:numCache>
                  <c:formatCode>General</c:formatCode>
                  <c:ptCount val="8"/>
                  <c:pt idx="0">
                    <c:v>1.0610932061450145</c:v>
                  </c:pt>
                  <c:pt idx="1">
                    <c:v>0.99554696983210744</c:v>
                  </c:pt>
                  <c:pt idx="2">
                    <c:v>1.0303522041869673</c:v>
                  </c:pt>
                  <c:pt idx="3">
                    <c:v>1.8509598664381157</c:v>
                  </c:pt>
                  <c:pt idx="4">
                    <c:v>3.4369898436132336</c:v>
                  </c:pt>
                  <c:pt idx="5">
                    <c:v>0.81197689898476255</c:v>
                  </c:pt>
                  <c:pt idx="6">
                    <c:v>3.7575974594647099</c:v>
                  </c:pt>
                  <c:pt idx="7">
                    <c:v>1.9054141422115236</c:v>
                  </c:pt>
                </c:numCache>
              </c:numRef>
            </c:plus>
            <c:minus>
              <c:numRef>
                <c:f>[1]Sheet1!$X$63:$X$70</c:f>
                <c:numCache>
                  <c:formatCode>General</c:formatCode>
                  <c:ptCount val="8"/>
                  <c:pt idx="0">
                    <c:v>1.0610932061450145</c:v>
                  </c:pt>
                  <c:pt idx="1">
                    <c:v>0.99554696983210744</c:v>
                  </c:pt>
                  <c:pt idx="2">
                    <c:v>1.0303522041869673</c:v>
                  </c:pt>
                  <c:pt idx="3">
                    <c:v>1.8509598664381157</c:v>
                  </c:pt>
                  <c:pt idx="4">
                    <c:v>3.4369898436132336</c:v>
                  </c:pt>
                  <c:pt idx="5">
                    <c:v>0.81197689898476255</c:v>
                  </c:pt>
                  <c:pt idx="6">
                    <c:v>3.7575974594647099</c:v>
                  </c:pt>
                  <c:pt idx="7">
                    <c:v>1.9054141422115236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V$63:$V$70</c:f>
              <c:numCache>
                <c:formatCode>General</c:formatCode>
                <c:ptCount val="8"/>
                <c:pt idx="0">
                  <c:v>182.90313447871222</c:v>
                </c:pt>
                <c:pt idx="1">
                  <c:v>150.51531608448914</c:v>
                </c:pt>
                <c:pt idx="2">
                  <c:v>136.16727062752889</c:v>
                </c:pt>
                <c:pt idx="3">
                  <c:v>110.57014704323076</c:v>
                </c:pt>
                <c:pt idx="4">
                  <c:v>105.1531388272053</c:v>
                </c:pt>
                <c:pt idx="5">
                  <c:v>106.7830546727774</c:v>
                </c:pt>
                <c:pt idx="6">
                  <c:v>98.92384469189598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1D1-42F3-8C1A-9D499AA69B59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G$63:$AG$70</c:f>
                <c:numCache>
                  <c:formatCode>General</c:formatCode>
                  <c:ptCount val="8"/>
                  <c:pt idx="0">
                    <c:v>0.85599026777448339</c:v>
                  </c:pt>
                  <c:pt idx="1">
                    <c:v>0.9204559047605908</c:v>
                  </c:pt>
                  <c:pt idx="2">
                    <c:v>1.9373182331705503</c:v>
                  </c:pt>
                  <c:pt idx="3">
                    <c:v>1.3201847161464064</c:v>
                  </c:pt>
                  <c:pt idx="4">
                    <c:v>1.0746888437886764</c:v>
                  </c:pt>
                  <c:pt idx="5">
                    <c:v>1.1802432886450369</c:v>
                  </c:pt>
                  <c:pt idx="6">
                    <c:v>1.0704606503403871</c:v>
                  </c:pt>
                  <c:pt idx="7">
                    <c:v>1.4328350619202135</c:v>
                  </c:pt>
                </c:numCache>
              </c:numRef>
            </c:plus>
            <c:minus>
              <c:numRef>
                <c:f>[1]Sheet1!$AG$63:$AG$70</c:f>
                <c:numCache>
                  <c:formatCode>General</c:formatCode>
                  <c:ptCount val="8"/>
                  <c:pt idx="0">
                    <c:v>0.85599026777448339</c:v>
                  </c:pt>
                  <c:pt idx="1">
                    <c:v>0.9204559047605908</c:v>
                  </c:pt>
                  <c:pt idx="2">
                    <c:v>1.9373182331705503</c:v>
                  </c:pt>
                  <c:pt idx="3">
                    <c:v>1.3201847161464064</c:v>
                  </c:pt>
                  <c:pt idx="4">
                    <c:v>1.0746888437886764</c:v>
                  </c:pt>
                  <c:pt idx="5">
                    <c:v>1.1802432886450369</c:v>
                  </c:pt>
                  <c:pt idx="6">
                    <c:v>1.0704606503403871</c:v>
                  </c:pt>
                  <c:pt idx="7">
                    <c:v>1.432835061920213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E$63:$AE$70</c:f>
              <c:numCache>
                <c:formatCode>General</c:formatCode>
                <c:ptCount val="8"/>
                <c:pt idx="0">
                  <c:v>177.42424439787752</c:v>
                </c:pt>
                <c:pt idx="1">
                  <c:v>159.95572198550371</c:v>
                </c:pt>
                <c:pt idx="2">
                  <c:v>148.04812048285402</c:v>
                </c:pt>
                <c:pt idx="3">
                  <c:v>135.67132515165622</c:v>
                </c:pt>
                <c:pt idx="4">
                  <c:v>102.17749327737336</c:v>
                </c:pt>
                <c:pt idx="5">
                  <c:v>100.28876113856727</c:v>
                </c:pt>
                <c:pt idx="6">
                  <c:v>99.036143541647618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1D1-42F3-8C1A-9D499AA69B59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O$63:$AO$70</c:f>
                <c:numCache>
                  <c:formatCode>General</c:formatCode>
                  <c:ptCount val="8"/>
                  <c:pt idx="0">
                    <c:v>1.2584335892706311</c:v>
                  </c:pt>
                  <c:pt idx="1">
                    <c:v>0.65595373591332218</c:v>
                  </c:pt>
                  <c:pt idx="2">
                    <c:v>0.73937392875951469</c:v>
                  </c:pt>
                  <c:pt idx="3">
                    <c:v>0.83644925928986069</c:v>
                  </c:pt>
                  <c:pt idx="4">
                    <c:v>1.3153122399844925</c:v>
                  </c:pt>
                  <c:pt idx="5">
                    <c:v>1.4322324845010221</c:v>
                  </c:pt>
                  <c:pt idx="6">
                    <c:v>6.0337449760024073</c:v>
                  </c:pt>
                  <c:pt idx="7">
                    <c:v>0.98787134982110969</c:v>
                  </c:pt>
                </c:numCache>
              </c:numRef>
            </c:plus>
            <c:minus>
              <c:numRef>
                <c:f>[1]Sheet1!$AO$63:$AO$70</c:f>
                <c:numCache>
                  <c:formatCode>General</c:formatCode>
                  <c:ptCount val="8"/>
                  <c:pt idx="0">
                    <c:v>1.2584335892706311</c:v>
                  </c:pt>
                  <c:pt idx="1">
                    <c:v>0.65595373591332218</c:v>
                  </c:pt>
                  <c:pt idx="2">
                    <c:v>0.73937392875951469</c:v>
                  </c:pt>
                  <c:pt idx="3">
                    <c:v>0.83644925928986069</c:v>
                  </c:pt>
                  <c:pt idx="4">
                    <c:v>1.3153122399844925</c:v>
                  </c:pt>
                  <c:pt idx="5">
                    <c:v>1.4322324845010221</c:v>
                  </c:pt>
                  <c:pt idx="6">
                    <c:v>6.0337449760024073</c:v>
                  </c:pt>
                  <c:pt idx="7">
                    <c:v>0.9878713498211096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M$63:$AM$70</c:f>
              <c:numCache>
                <c:formatCode>General</c:formatCode>
                <c:ptCount val="8"/>
                <c:pt idx="0">
                  <c:v>168.23671942667292</c:v>
                </c:pt>
                <c:pt idx="1">
                  <c:v>156.64417393130864</c:v>
                </c:pt>
                <c:pt idx="2">
                  <c:v>141.99848570151468</c:v>
                </c:pt>
                <c:pt idx="3">
                  <c:v>135.70834233817851</c:v>
                </c:pt>
                <c:pt idx="4">
                  <c:v>102.50634685515996</c:v>
                </c:pt>
                <c:pt idx="5">
                  <c:v>101.0185753076446</c:v>
                </c:pt>
                <c:pt idx="6">
                  <c:v>100.38659714560278</c:v>
                </c:pt>
                <c:pt idx="7">
                  <c:v>100.00000000000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1D1-42F3-8C1A-9D499AA69B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6613118760027226"/>
          <c:y val="0.48915406856942534"/>
          <c:w val="0.36541175978982365"/>
          <c:h val="0.292625400991542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738 1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8873686782311256"/>
          <c:y val="5.092592592592592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410385281371717"/>
          <c:y val="0.13004629629629633"/>
          <c:w val="0.79038960469353425"/>
          <c:h val="0.67474355181861523"/>
        </c:manualLayout>
      </c:layout>
      <c:scatterChart>
        <c:scatterStyle val="lineMarker"/>
        <c:varyColors val="0"/>
        <c:ser>
          <c:idx val="0"/>
          <c:order val="0"/>
          <c:tx>
            <c:v>RPMI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X$52:$X$59</c:f>
                <c:numCache>
                  <c:formatCode>General</c:formatCode>
                  <c:ptCount val="8"/>
                  <c:pt idx="0">
                    <c:v>0.88483683940262858</c:v>
                  </c:pt>
                  <c:pt idx="1">
                    <c:v>3.1459999241826866</c:v>
                  </c:pt>
                  <c:pt idx="2">
                    <c:v>1.5478110958677587</c:v>
                  </c:pt>
                  <c:pt idx="3">
                    <c:v>0.26120245583023305</c:v>
                  </c:pt>
                  <c:pt idx="4">
                    <c:v>0.51711852273099934</c:v>
                  </c:pt>
                  <c:pt idx="5">
                    <c:v>1.6053101411469823</c:v>
                  </c:pt>
                  <c:pt idx="6">
                    <c:v>1.8266620946551935</c:v>
                  </c:pt>
                  <c:pt idx="7">
                    <c:v>2.7865896369107452</c:v>
                  </c:pt>
                </c:numCache>
              </c:numRef>
            </c:plus>
            <c:minus>
              <c:numRef>
                <c:f>[1]Sheet1!$X$52:$X$59</c:f>
                <c:numCache>
                  <c:formatCode>General</c:formatCode>
                  <c:ptCount val="8"/>
                  <c:pt idx="0">
                    <c:v>0.88483683940262858</c:v>
                  </c:pt>
                  <c:pt idx="1">
                    <c:v>3.1459999241826866</c:v>
                  </c:pt>
                  <c:pt idx="2">
                    <c:v>1.5478110958677587</c:v>
                  </c:pt>
                  <c:pt idx="3">
                    <c:v>0.26120245583023305</c:v>
                  </c:pt>
                  <c:pt idx="4">
                    <c:v>0.51711852273099934</c:v>
                  </c:pt>
                  <c:pt idx="5">
                    <c:v>1.6053101411469823</c:v>
                  </c:pt>
                  <c:pt idx="6">
                    <c:v>1.8266620946551935</c:v>
                  </c:pt>
                  <c:pt idx="7">
                    <c:v>2.786589636910745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V$52:$V$59</c:f>
              <c:numCache>
                <c:formatCode>General</c:formatCode>
                <c:ptCount val="8"/>
                <c:pt idx="0">
                  <c:v>104.00709646871627</c:v>
                </c:pt>
                <c:pt idx="1">
                  <c:v>85.223545797297348</c:v>
                </c:pt>
                <c:pt idx="2">
                  <c:v>97.328920980525453</c:v>
                </c:pt>
                <c:pt idx="3">
                  <c:v>86.332308035885603</c:v>
                </c:pt>
                <c:pt idx="4">
                  <c:v>104.03637564552361</c:v>
                </c:pt>
                <c:pt idx="5">
                  <c:v>97.072154081955276</c:v>
                </c:pt>
                <c:pt idx="6">
                  <c:v>97.618009793884909</c:v>
                </c:pt>
                <c:pt idx="7">
                  <c:v>100.000000000000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C66-4934-975A-339861EF4666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G$52:$AG$59</c:f>
                <c:numCache>
                  <c:formatCode>General</c:formatCode>
                  <c:ptCount val="8"/>
                  <c:pt idx="0">
                    <c:v>3.8737650255359628</c:v>
                  </c:pt>
                  <c:pt idx="1">
                    <c:v>2.9862170937916419</c:v>
                  </c:pt>
                  <c:pt idx="2">
                    <c:v>1.9208967654091242</c:v>
                  </c:pt>
                  <c:pt idx="3">
                    <c:v>1.6071674060046444</c:v>
                  </c:pt>
                  <c:pt idx="4">
                    <c:v>0.57998170793521242</c:v>
                  </c:pt>
                  <c:pt idx="5">
                    <c:v>0.41461649545654855</c:v>
                  </c:pt>
                  <c:pt idx="6">
                    <c:v>1.6261660011719814</c:v>
                  </c:pt>
                  <c:pt idx="7">
                    <c:v>1.8601061125603482</c:v>
                  </c:pt>
                </c:numCache>
              </c:numRef>
            </c:plus>
            <c:minus>
              <c:numRef>
                <c:f>[1]Sheet1!$AG$52:$AG$59</c:f>
                <c:numCache>
                  <c:formatCode>General</c:formatCode>
                  <c:ptCount val="8"/>
                  <c:pt idx="0">
                    <c:v>3.8737650255359628</c:v>
                  </c:pt>
                  <c:pt idx="1">
                    <c:v>2.9862170937916419</c:v>
                  </c:pt>
                  <c:pt idx="2">
                    <c:v>1.9208967654091242</c:v>
                  </c:pt>
                  <c:pt idx="3">
                    <c:v>1.6071674060046444</c:v>
                  </c:pt>
                  <c:pt idx="4">
                    <c:v>0.57998170793521242</c:v>
                  </c:pt>
                  <c:pt idx="5">
                    <c:v>0.41461649545654855</c:v>
                  </c:pt>
                  <c:pt idx="6">
                    <c:v>1.6261660011719814</c:v>
                  </c:pt>
                  <c:pt idx="7">
                    <c:v>1.860106112560348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E$52:$AE$59</c:f>
              <c:numCache>
                <c:formatCode>General</c:formatCode>
                <c:ptCount val="8"/>
                <c:pt idx="0">
                  <c:v>140.46810508676461</c:v>
                </c:pt>
                <c:pt idx="1">
                  <c:v>154.13227906152912</c:v>
                </c:pt>
                <c:pt idx="2">
                  <c:v>141.17891718614226</c:v>
                </c:pt>
                <c:pt idx="3">
                  <c:v>129.90555304662573</c:v>
                </c:pt>
                <c:pt idx="4">
                  <c:v>108.44441584781943</c:v>
                </c:pt>
                <c:pt idx="5">
                  <c:v>99.482707391258984</c:v>
                </c:pt>
                <c:pt idx="6">
                  <c:v>100.74003854588672</c:v>
                </c:pt>
                <c:pt idx="7">
                  <c:v>99.9999999999999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C66-4934-975A-339861EF4666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O$52:$AO$59</c:f>
                <c:numCache>
                  <c:formatCode>General</c:formatCode>
                  <c:ptCount val="8"/>
                  <c:pt idx="0">
                    <c:v>4.4895535715809771</c:v>
                  </c:pt>
                  <c:pt idx="1">
                    <c:v>3.6026797319671697</c:v>
                  </c:pt>
                  <c:pt idx="2">
                    <c:v>3.1618934058529891</c:v>
                  </c:pt>
                  <c:pt idx="3">
                    <c:v>1.0096298732141291</c:v>
                  </c:pt>
                  <c:pt idx="4">
                    <c:v>0.479631677809989</c:v>
                  </c:pt>
                  <c:pt idx="5">
                    <c:v>1.5348023799572146</c:v>
                  </c:pt>
                  <c:pt idx="6">
                    <c:v>1.6564313459335214</c:v>
                  </c:pt>
                  <c:pt idx="7">
                    <c:v>1.7358883674266179</c:v>
                  </c:pt>
                </c:numCache>
              </c:numRef>
            </c:plus>
            <c:minus>
              <c:numRef>
                <c:f>[1]Sheet1!$AO$52:$AO$59</c:f>
                <c:numCache>
                  <c:formatCode>General</c:formatCode>
                  <c:ptCount val="8"/>
                  <c:pt idx="0">
                    <c:v>4.4895535715809771</c:v>
                  </c:pt>
                  <c:pt idx="1">
                    <c:v>3.6026797319671697</c:v>
                  </c:pt>
                  <c:pt idx="2">
                    <c:v>3.1618934058529891</c:v>
                  </c:pt>
                  <c:pt idx="3">
                    <c:v>1.0096298732141291</c:v>
                  </c:pt>
                  <c:pt idx="4">
                    <c:v>0.479631677809989</c:v>
                  </c:pt>
                  <c:pt idx="5">
                    <c:v>1.5348023799572146</c:v>
                  </c:pt>
                  <c:pt idx="6">
                    <c:v>1.6564313459335214</c:v>
                  </c:pt>
                  <c:pt idx="7">
                    <c:v>1.735888367426617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M$52:$AM$59</c:f>
              <c:numCache>
                <c:formatCode>General</c:formatCode>
                <c:ptCount val="8"/>
                <c:pt idx="0">
                  <c:v>127.29183642269935</c:v>
                </c:pt>
                <c:pt idx="1">
                  <c:v>145.82684224046147</c:v>
                </c:pt>
                <c:pt idx="2">
                  <c:v>117.6001196057109</c:v>
                </c:pt>
                <c:pt idx="3">
                  <c:v>126.33869471237185</c:v>
                </c:pt>
                <c:pt idx="4">
                  <c:v>102.50452400447188</c:v>
                </c:pt>
                <c:pt idx="5">
                  <c:v>97.9226661728556</c:v>
                </c:pt>
                <c:pt idx="6">
                  <c:v>97.785616435581716</c:v>
                </c:pt>
                <c:pt idx="7">
                  <c:v>100.00000000000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C66-4934-975A-339861EF46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0959016609880168"/>
          <c:y val="0.51600984585336107"/>
          <c:w val="0.36541175978982365"/>
          <c:h val="0.269477252843394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1215 1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5902864776915433"/>
          <c:y val="4.6296296296296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130457458674724"/>
          <c:y val="0.13004629629629633"/>
          <c:w val="0.78734683132836991"/>
          <c:h val="0.64484844731681856"/>
        </c:manualLayout>
      </c:layout>
      <c:scatterChart>
        <c:scatterStyle val="lineMarker"/>
        <c:varyColors val="0"/>
        <c:ser>
          <c:idx val="0"/>
          <c:order val="0"/>
          <c:tx>
            <c:v>RPMI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X$40:$X$47</c:f>
                <c:numCache>
                  <c:formatCode>General</c:formatCode>
                  <c:ptCount val="8"/>
                  <c:pt idx="0">
                    <c:v>3.5785496435260917</c:v>
                  </c:pt>
                  <c:pt idx="1">
                    <c:v>0.64001357470027131</c:v>
                  </c:pt>
                  <c:pt idx="2">
                    <c:v>0.23623891384787241</c:v>
                  </c:pt>
                  <c:pt idx="3">
                    <c:v>1.6526870926392583</c:v>
                  </c:pt>
                  <c:pt idx="4">
                    <c:v>2.3028266595009188</c:v>
                  </c:pt>
                  <c:pt idx="5">
                    <c:v>0.27369920631863764</c:v>
                  </c:pt>
                  <c:pt idx="6">
                    <c:v>1.2417727665977074</c:v>
                  </c:pt>
                  <c:pt idx="7">
                    <c:v>2.4022021708492249</c:v>
                  </c:pt>
                </c:numCache>
              </c:numRef>
            </c:plus>
            <c:minus>
              <c:numRef>
                <c:f>[1]Sheet1!$X$40:$X$47</c:f>
                <c:numCache>
                  <c:formatCode>General</c:formatCode>
                  <c:ptCount val="8"/>
                  <c:pt idx="0">
                    <c:v>3.5785496435260917</c:v>
                  </c:pt>
                  <c:pt idx="1">
                    <c:v>0.64001357470027131</c:v>
                  </c:pt>
                  <c:pt idx="2">
                    <c:v>0.23623891384787241</c:v>
                  </c:pt>
                  <c:pt idx="3">
                    <c:v>1.6526870926392583</c:v>
                  </c:pt>
                  <c:pt idx="4">
                    <c:v>2.3028266595009188</c:v>
                  </c:pt>
                  <c:pt idx="5">
                    <c:v>0.27369920631863764</c:v>
                  </c:pt>
                  <c:pt idx="6">
                    <c:v>1.2417727665977074</c:v>
                  </c:pt>
                  <c:pt idx="7">
                    <c:v>2.402202170849224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V$40:$V$47</c:f>
              <c:numCache>
                <c:formatCode>General</c:formatCode>
                <c:ptCount val="8"/>
                <c:pt idx="0">
                  <c:v>89.427111993070085</c:v>
                </c:pt>
                <c:pt idx="1">
                  <c:v>80.206885995028884</c:v>
                </c:pt>
                <c:pt idx="2">
                  <c:v>100.83953723757146</c:v>
                </c:pt>
                <c:pt idx="3">
                  <c:v>101.11578887676825</c:v>
                </c:pt>
                <c:pt idx="4">
                  <c:v>107.57558736534502</c:v>
                </c:pt>
                <c:pt idx="5">
                  <c:v>99.742026082708506</c:v>
                </c:pt>
                <c:pt idx="6">
                  <c:v>100.39719793614722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5C0-456B-AE48-A812645BD189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G$40:$AG$47</c:f>
                <c:numCache>
                  <c:formatCode>General</c:formatCode>
                  <c:ptCount val="8"/>
                  <c:pt idx="0">
                    <c:v>1.6730622404646702</c:v>
                  </c:pt>
                  <c:pt idx="1">
                    <c:v>1.3673208075057932</c:v>
                  </c:pt>
                  <c:pt idx="2">
                    <c:v>0.3559090720372291</c:v>
                  </c:pt>
                  <c:pt idx="3">
                    <c:v>1.2646231776658303</c:v>
                  </c:pt>
                  <c:pt idx="4">
                    <c:v>0.81708385395155703</c:v>
                  </c:pt>
                  <c:pt idx="5">
                    <c:v>0.90271546187398721</c:v>
                  </c:pt>
                  <c:pt idx="6">
                    <c:v>1.8450074575992754</c:v>
                  </c:pt>
                  <c:pt idx="7">
                    <c:v>0.23275138831596923</c:v>
                  </c:pt>
                </c:numCache>
              </c:numRef>
            </c:plus>
            <c:minus>
              <c:numRef>
                <c:f>[1]Sheet1!$AG$40:$AG$47</c:f>
                <c:numCache>
                  <c:formatCode>General</c:formatCode>
                  <c:ptCount val="8"/>
                  <c:pt idx="0">
                    <c:v>1.6730622404646702</c:v>
                  </c:pt>
                  <c:pt idx="1">
                    <c:v>1.3673208075057932</c:v>
                  </c:pt>
                  <c:pt idx="2">
                    <c:v>0.3559090720372291</c:v>
                  </c:pt>
                  <c:pt idx="3">
                    <c:v>1.2646231776658303</c:v>
                  </c:pt>
                  <c:pt idx="4">
                    <c:v>0.81708385395155703</c:v>
                  </c:pt>
                  <c:pt idx="5">
                    <c:v>0.90271546187398721</c:v>
                  </c:pt>
                  <c:pt idx="6">
                    <c:v>1.8450074575992754</c:v>
                  </c:pt>
                  <c:pt idx="7">
                    <c:v>0.2327513883159692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E$40:$AE$47</c:f>
              <c:numCache>
                <c:formatCode>General</c:formatCode>
                <c:ptCount val="8"/>
                <c:pt idx="0">
                  <c:v>158.73426212754086</c:v>
                </c:pt>
                <c:pt idx="1">
                  <c:v>155.71176508856146</c:v>
                </c:pt>
                <c:pt idx="2">
                  <c:v>141.09720257880306</c:v>
                </c:pt>
                <c:pt idx="3">
                  <c:v>130.12877506933691</c:v>
                </c:pt>
                <c:pt idx="4">
                  <c:v>111.77010320166123</c:v>
                </c:pt>
                <c:pt idx="5">
                  <c:v>100.89236638352466</c:v>
                </c:pt>
                <c:pt idx="6">
                  <c:v>99.148739091074248</c:v>
                </c:pt>
                <c:pt idx="7">
                  <c:v>99.9999999999999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5C0-456B-AE48-A812645BD189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1!$AO$40:$AO$47</c:f>
                <c:numCache>
                  <c:formatCode>General</c:formatCode>
                  <c:ptCount val="8"/>
                  <c:pt idx="0">
                    <c:v>0.79213454710704545</c:v>
                  </c:pt>
                  <c:pt idx="1">
                    <c:v>2.0577313714556191</c:v>
                  </c:pt>
                  <c:pt idx="2">
                    <c:v>4.2529070110431029</c:v>
                  </c:pt>
                  <c:pt idx="3">
                    <c:v>0.53385739573615265</c:v>
                  </c:pt>
                  <c:pt idx="4">
                    <c:v>0.75619374942716722</c:v>
                  </c:pt>
                  <c:pt idx="5">
                    <c:v>1.0947505610550419</c:v>
                  </c:pt>
                  <c:pt idx="6">
                    <c:v>1.9884350192814304</c:v>
                  </c:pt>
                  <c:pt idx="7">
                    <c:v>4.9497043577122692</c:v>
                  </c:pt>
                </c:numCache>
              </c:numRef>
            </c:plus>
            <c:minus>
              <c:numRef>
                <c:f>[1]Sheet1!$AO$40:$AO$47</c:f>
                <c:numCache>
                  <c:formatCode>General</c:formatCode>
                  <c:ptCount val="8"/>
                  <c:pt idx="0">
                    <c:v>0.79213454710704545</c:v>
                  </c:pt>
                  <c:pt idx="1">
                    <c:v>2.0577313714556191</c:v>
                  </c:pt>
                  <c:pt idx="2">
                    <c:v>4.2529070110431029</c:v>
                  </c:pt>
                  <c:pt idx="3">
                    <c:v>0.53385739573615265</c:v>
                  </c:pt>
                  <c:pt idx="4">
                    <c:v>0.75619374942716722</c:v>
                  </c:pt>
                  <c:pt idx="5">
                    <c:v>1.0947505610550419</c:v>
                  </c:pt>
                  <c:pt idx="6">
                    <c:v>1.9884350192814304</c:v>
                  </c:pt>
                  <c:pt idx="7">
                    <c:v>4.949704357712269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1!$Q$6:$Q$13</c:f>
              <c:numCache>
                <c:formatCode>General</c:formatCode>
                <c:ptCount val="8"/>
                <c:pt idx="0">
                  <c:v>76</c:v>
                </c:pt>
                <c:pt idx="1">
                  <c:v>48</c:v>
                </c:pt>
                <c:pt idx="2">
                  <c:v>24</c:v>
                </c:pt>
                <c:pt idx="3">
                  <c:v>18</c:v>
                </c:pt>
                <c:pt idx="4">
                  <c:v>6</c:v>
                </c:pt>
                <c:pt idx="5">
                  <c:v>3</c:v>
                </c:pt>
                <c:pt idx="6">
                  <c:v>1</c:v>
                </c:pt>
                <c:pt idx="7">
                  <c:v>0</c:v>
                </c:pt>
              </c:numCache>
            </c:numRef>
          </c:xVal>
          <c:yVal>
            <c:numRef>
              <c:f>[1]Sheet1!$AM$40:$AM$47</c:f>
              <c:numCache>
                <c:formatCode>General</c:formatCode>
                <c:ptCount val="8"/>
                <c:pt idx="0">
                  <c:v>154.30168949110382</c:v>
                </c:pt>
                <c:pt idx="1">
                  <c:v>163.59722678819247</c:v>
                </c:pt>
                <c:pt idx="2">
                  <c:v>135.81646700374313</c:v>
                </c:pt>
                <c:pt idx="3">
                  <c:v>136.68344908302586</c:v>
                </c:pt>
                <c:pt idx="4">
                  <c:v>112.9685441111495</c:v>
                </c:pt>
                <c:pt idx="5">
                  <c:v>107.57145655034955</c:v>
                </c:pt>
                <c:pt idx="6">
                  <c:v>102.99501395664166</c:v>
                </c:pt>
                <c:pt idx="7">
                  <c:v>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5C0-456B-AE48-A812645BD1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9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ime (h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578880802776187"/>
          <c:y val="0.54789187949622964"/>
          <c:w val="0.31930176585867931"/>
          <c:h val="0.2231809565470983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Tubastatin-A 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2750390072208718"/>
          <c:y val="4.27994078594846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85351445208022"/>
          <c:y val="0.13547702730930261"/>
          <c:w val="0.78659427031479145"/>
          <c:h val="0.70267893118234448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F$41:$F$48</c:f>
                <c:numCache>
                  <c:formatCode>General</c:formatCode>
                  <c:ptCount val="8"/>
                  <c:pt idx="0">
                    <c:v>6.1968625918555027</c:v>
                  </c:pt>
                  <c:pt idx="1">
                    <c:v>6.2233992696534255</c:v>
                  </c:pt>
                  <c:pt idx="2">
                    <c:v>4.9738366400753735</c:v>
                  </c:pt>
                  <c:pt idx="3">
                    <c:v>7.9659499119218333</c:v>
                  </c:pt>
                  <c:pt idx="4">
                    <c:v>6.5484628969389442</c:v>
                  </c:pt>
                  <c:pt idx="5">
                    <c:v>4.8375957152999858</c:v>
                  </c:pt>
                  <c:pt idx="6">
                    <c:v>5.8905096009739415</c:v>
                  </c:pt>
                  <c:pt idx="7">
                    <c:v>8.2200340691260099</c:v>
                  </c:pt>
                </c:numCache>
              </c:numRef>
            </c:plus>
            <c:minus>
              <c:numRef>
                <c:f>[1]Sheet3!$F$41:$F$48</c:f>
                <c:numCache>
                  <c:formatCode>General</c:formatCode>
                  <c:ptCount val="8"/>
                  <c:pt idx="0">
                    <c:v>6.1968625918555027</c:v>
                  </c:pt>
                  <c:pt idx="1">
                    <c:v>6.2233992696534255</c:v>
                  </c:pt>
                  <c:pt idx="2">
                    <c:v>4.9738366400753735</c:v>
                  </c:pt>
                  <c:pt idx="3">
                    <c:v>7.9659499119218333</c:v>
                  </c:pt>
                  <c:pt idx="4">
                    <c:v>6.5484628969389442</c:v>
                  </c:pt>
                  <c:pt idx="5">
                    <c:v>4.8375957152999858</c:v>
                  </c:pt>
                  <c:pt idx="6">
                    <c:v>5.8905096009739415</c:v>
                  </c:pt>
                  <c:pt idx="7">
                    <c:v>8.2200340691260099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D$41:$D$48</c:f>
              <c:numCache>
                <c:formatCode>General</c:formatCode>
                <c:ptCount val="8"/>
                <c:pt idx="0">
                  <c:v>100</c:v>
                </c:pt>
                <c:pt idx="1">
                  <c:v>99.287153382011468</c:v>
                </c:pt>
                <c:pt idx="2">
                  <c:v>98.545275672482077</c:v>
                </c:pt>
                <c:pt idx="3">
                  <c:v>101.3986818648397</c:v>
                </c:pt>
                <c:pt idx="4">
                  <c:v>131.67820272663209</c:v>
                </c:pt>
                <c:pt idx="5">
                  <c:v>133.60184624107495</c:v>
                </c:pt>
                <c:pt idx="6">
                  <c:v>124.20212482550643</c:v>
                </c:pt>
                <c:pt idx="7">
                  <c:v>102.730040778123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32B-4DBF-BB44-A2DF34AF222A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F$8:$F$16</c:f>
                <c:numCache>
                  <c:formatCode>General</c:formatCode>
                  <c:ptCount val="9"/>
                  <c:pt idx="0">
                    <c:v>3.1198947461845252</c:v>
                  </c:pt>
                  <c:pt idx="1">
                    <c:v>2.7161084404896823</c:v>
                  </c:pt>
                  <c:pt idx="2">
                    <c:v>4.2039827907128675</c:v>
                  </c:pt>
                  <c:pt idx="3">
                    <c:v>4.7551568186263129</c:v>
                  </c:pt>
                  <c:pt idx="4">
                    <c:v>5.7691092613980226</c:v>
                  </c:pt>
                  <c:pt idx="5">
                    <c:v>5.5254657359571002</c:v>
                  </c:pt>
                  <c:pt idx="6">
                    <c:v>6.9518673435334515</c:v>
                  </c:pt>
                  <c:pt idx="7">
                    <c:v>7.0695212603905242</c:v>
                  </c:pt>
                  <c:pt idx="8">
                    <c:v>7.6505528607489923</c:v>
                  </c:pt>
                </c:numCache>
              </c:numRef>
            </c:plus>
            <c:minus>
              <c:numRef>
                <c:f>[1]Sheet3!$F$8:$F$16</c:f>
                <c:numCache>
                  <c:formatCode>General</c:formatCode>
                  <c:ptCount val="9"/>
                  <c:pt idx="0">
                    <c:v>3.1198947461845252</c:v>
                  </c:pt>
                  <c:pt idx="1">
                    <c:v>2.7161084404896823</c:v>
                  </c:pt>
                  <c:pt idx="2">
                    <c:v>4.2039827907128675</c:v>
                  </c:pt>
                  <c:pt idx="3">
                    <c:v>4.7551568186263129</c:v>
                  </c:pt>
                  <c:pt idx="4">
                    <c:v>5.7691092613980226</c:v>
                  </c:pt>
                  <c:pt idx="5">
                    <c:v>5.5254657359571002</c:v>
                  </c:pt>
                  <c:pt idx="6">
                    <c:v>6.9518673435334515</c:v>
                  </c:pt>
                  <c:pt idx="7">
                    <c:v>7.0695212603905242</c:v>
                  </c:pt>
                  <c:pt idx="8">
                    <c:v>7.650552860748992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D$8:$D$15</c:f>
              <c:numCache>
                <c:formatCode>General</c:formatCode>
                <c:ptCount val="8"/>
                <c:pt idx="0">
                  <c:v>100.53524195247113</c:v>
                </c:pt>
                <c:pt idx="1">
                  <c:v>100</c:v>
                </c:pt>
                <c:pt idx="2">
                  <c:v>105.73536160260302</c:v>
                </c:pt>
                <c:pt idx="3">
                  <c:v>112.32757274829721</c:v>
                </c:pt>
                <c:pt idx="4">
                  <c:v>125.76576147942897</c:v>
                </c:pt>
                <c:pt idx="5">
                  <c:v>123.03860034319611</c:v>
                </c:pt>
                <c:pt idx="6">
                  <c:v>135.00371191794437</c:v>
                </c:pt>
                <c:pt idx="7">
                  <c:v>138.279938387241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32B-4DBF-BB44-A2DF34AF222A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F$25:$F$33</c:f>
                <c:numCache>
                  <c:formatCode>General</c:formatCode>
                  <c:ptCount val="9"/>
                  <c:pt idx="0">
                    <c:v>1.5843881130049309</c:v>
                  </c:pt>
                  <c:pt idx="1">
                    <c:v>1.4624393182760582</c:v>
                  </c:pt>
                  <c:pt idx="2">
                    <c:v>0.61453250591791875</c:v>
                  </c:pt>
                  <c:pt idx="3">
                    <c:v>2.3453284743451568</c:v>
                  </c:pt>
                  <c:pt idx="4">
                    <c:v>1.9156792541527008</c:v>
                  </c:pt>
                  <c:pt idx="5">
                    <c:v>0.5162187287954223</c:v>
                  </c:pt>
                  <c:pt idx="6">
                    <c:v>0.66888071647037028</c:v>
                  </c:pt>
                  <c:pt idx="7">
                    <c:v>0.68128203618126237</c:v>
                  </c:pt>
                  <c:pt idx="8">
                    <c:v>2.1021832338987352</c:v>
                  </c:pt>
                </c:numCache>
              </c:numRef>
            </c:plus>
            <c:minus>
              <c:numRef>
                <c:f>[1]Sheet3!$F$25:$F$33</c:f>
                <c:numCache>
                  <c:formatCode>General</c:formatCode>
                  <c:ptCount val="9"/>
                  <c:pt idx="0">
                    <c:v>1.5843881130049309</c:v>
                  </c:pt>
                  <c:pt idx="1">
                    <c:v>1.4624393182760582</c:v>
                  </c:pt>
                  <c:pt idx="2">
                    <c:v>0.61453250591791875</c:v>
                  </c:pt>
                  <c:pt idx="3">
                    <c:v>2.3453284743451568</c:v>
                  </c:pt>
                  <c:pt idx="4">
                    <c:v>1.9156792541527008</c:v>
                  </c:pt>
                  <c:pt idx="5">
                    <c:v>0.5162187287954223</c:v>
                  </c:pt>
                  <c:pt idx="6">
                    <c:v>0.66888071647037028</c:v>
                  </c:pt>
                  <c:pt idx="7">
                    <c:v>0.68128203618126237</c:v>
                  </c:pt>
                  <c:pt idx="8">
                    <c:v>2.102183233898735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D$25:$D$32</c:f>
              <c:numCache>
                <c:formatCode>General</c:formatCode>
                <c:ptCount val="8"/>
                <c:pt idx="0">
                  <c:v>96.265235144557863</c:v>
                </c:pt>
                <c:pt idx="1">
                  <c:v>98.08797216053128</c:v>
                </c:pt>
                <c:pt idx="2">
                  <c:v>98.534629855373794</c:v>
                </c:pt>
                <c:pt idx="3">
                  <c:v>107.55570278471735</c:v>
                </c:pt>
                <c:pt idx="4">
                  <c:v>118.52803649342945</c:v>
                </c:pt>
                <c:pt idx="5">
                  <c:v>120.46998926322604</c:v>
                </c:pt>
                <c:pt idx="6">
                  <c:v>136.60544977457269</c:v>
                </c:pt>
                <c:pt idx="7">
                  <c:v>131.81275131054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32B-4DBF-BB44-A2DF34AF22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8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40153391543884959"/>
          <c:y val="0.51428529911269738"/>
          <c:w val="0.36640729675364064"/>
          <c:h val="0.266538430101081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1215 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1355397658757406"/>
          <c:y val="3.81855235283120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006184824198368"/>
          <c:y val="0.13293549627445145"/>
          <c:w val="0.80199533786709654"/>
          <c:h val="0.61898033913948503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N$41:$N$49</c:f>
                <c:numCache>
                  <c:formatCode>General</c:formatCode>
                  <c:ptCount val="9"/>
                  <c:pt idx="0">
                    <c:v>0.86478688772810475</c:v>
                  </c:pt>
                  <c:pt idx="1">
                    <c:v>2.2520771451110244</c:v>
                  </c:pt>
                  <c:pt idx="2">
                    <c:v>4.4347369785894051</c:v>
                  </c:pt>
                  <c:pt idx="3">
                    <c:v>6.998859503878573</c:v>
                  </c:pt>
                  <c:pt idx="4">
                    <c:v>9.9794088704443631</c:v>
                  </c:pt>
                  <c:pt idx="5">
                    <c:v>11.032148279266051</c:v>
                  </c:pt>
                  <c:pt idx="6">
                    <c:v>7.4341933407462513</c:v>
                  </c:pt>
                  <c:pt idx="7">
                    <c:v>8.3237866656764137</c:v>
                  </c:pt>
                  <c:pt idx="8">
                    <c:v>3.578176391411092</c:v>
                  </c:pt>
                </c:numCache>
              </c:numRef>
            </c:plus>
            <c:minus>
              <c:numRef>
                <c:f>[1]Sheet3!$N$41:$N$49</c:f>
                <c:numCache>
                  <c:formatCode>General</c:formatCode>
                  <c:ptCount val="9"/>
                  <c:pt idx="0">
                    <c:v>0.86478688772810475</c:v>
                  </c:pt>
                  <c:pt idx="1">
                    <c:v>2.2520771451110244</c:v>
                  </c:pt>
                  <c:pt idx="2">
                    <c:v>4.4347369785894051</c:v>
                  </c:pt>
                  <c:pt idx="3">
                    <c:v>6.998859503878573</c:v>
                  </c:pt>
                  <c:pt idx="4">
                    <c:v>9.9794088704443631</c:v>
                  </c:pt>
                  <c:pt idx="5">
                    <c:v>11.032148279266051</c:v>
                  </c:pt>
                  <c:pt idx="6">
                    <c:v>7.4341933407462513</c:v>
                  </c:pt>
                  <c:pt idx="7">
                    <c:v>8.3237866656764137</c:v>
                  </c:pt>
                  <c:pt idx="8">
                    <c:v>3.578176391411092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L$41:$L$49</c:f>
              <c:numCache>
                <c:formatCode>General</c:formatCode>
                <c:ptCount val="9"/>
                <c:pt idx="0">
                  <c:v>100</c:v>
                </c:pt>
                <c:pt idx="1">
                  <c:v>111.49387946000709</c:v>
                </c:pt>
                <c:pt idx="2">
                  <c:v>106.84174474099258</c:v>
                </c:pt>
                <c:pt idx="3">
                  <c:v>109.6281554404313</c:v>
                </c:pt>
                <c:pt idx="4">
                  <c:v>103.91006083966636</c:v>
                </c:pt>
                <c:pt idx="5">
                  <c:v>90.034977975733625</c:v>
                </c:pt>
                <c:pt idx="6">
                  <c:v>84.788183236547397</c:v>
                </c:pt>
                <c:pt idx="7">
                  <c:v>61.585544226954262</c:v>
                </c:pt>
                <c:pt idx="8">
                  <c:v>42.7104962511807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525-46AC-9DC5-138B149D84B9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N$8:$N$16</c:f>
                <c:numCache>
                  <c:formatCode>General</c:formatCode>
                  <c:ptCount val="9"/>
                  <c:pt idx="0">
                    <c:v>10.151499209596182</c:v>
                  </c:pt>
                  <c:pt idx="1">
                    <c:v>4.2738626721387591</c:v>
                  </c:pt>
                  <c:pt idx="2">
                    <c:v>1.7801978508387606</c:v>
                  </c:pt>
                  <c:pt idx="3">
                    <c:v>3.5355681780281043</c:v>
                  </c:pt>
                  <c:pt idx="4">
                    <c:v>1.784674704000482</c:v>
                  </c:pt>
                  <c:pt idx="5">
                    <c:v>1.1969567345503465</c:v>
                  </c:pt>
                  <c:pt idx="6">
                    <c:v>4.5741298149496439</c:v>
                  </c:pt>
                  <c:pt idx="7">
                    <c:v>2.207475284717749</c:v>
                  </c:pt>
                  <c:pt idx="8">
                    <c:v>4.996129314113583</c:v>
                  </c:pt>
                </c:numCache>
              </c:numRef>
            </c:plus>
            <c:minus>
              <c:numRef>
                <c:f>[1]Sheet3!$N$8:$N$16</c:f>
                <c:numCache>
                  <c:formatCode>General</c:formatCode>
                  <c:ptCount val="9"/>
                  <c:pt idx="0">
                    <c:v>10.151499209596182</c:v>
                  </c:pt>
                  <c:pt idx="1">
                    <c:v>4.2738626721387591</c:v>
                  </c:pt>
                  <c:pt idx="2">
                    <c:v>1.7801978508387606</c:v>
                  </c:pt>
                  <c:pt idx="3">
                    <c:v>3.5355681780281043</c:v>
                  </c:pt>
                  <c:pt idx="4">
                    <c:v>1.784674704000482</c:v>
                  </c:pt>
                  <c:pt idx="5">
                    <c:v>1.1969567345503465</c:v>
                  </c:pt>
                  <c:pt idx="6">
                    <c:v>4.5741298149496439</c:v>
                  </c:pt>
                  <c:pt idx="7">
                    <c:v>2.207475284717749</c:v>
                  </c:pt>
                  <c:pt idx="8">
                    <c:v>4.996129314113583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L$8:$L$16</c:f>
              <c:numCache>
                <c:formatCode>General</c:formatCode>
                <c:ptCount val="9"/>
                <c:pt idx="0">
                  <c:v>100</c:v>
                </c:pt>
                <c:pt idx="1">
                  <c:v>111.83907217651088</c:v>
                </c:pt>
                <c:pt idx="2">
                  <c:v>122.32706746899844</c:v>
                </c:pt>
                <c:pt idx="3">
                  <c:v>123.11965867533085</c:v>
                </c:pt>
                <c:pt idx="4">
                  <c:v>111.64161737107774</c:v>
                </c:pt>
                <c:pt idx="5">
                  <c:v>110.74700360960446</c:v>
                </c:pt>
                <c:pt idx="6">
                  <c:v>105.20363001685698</c:v>
                </c:pt>
                <c:pt idx="7">
                  <c:v>103.63618701783268</c:v>
                </c:pt>
                <c:pt idx="8">
                  <c:v>66.4044481112874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525-46AC-9DC5-138B149D84B9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N$25:$N$33</c:f>
                <c:numCache>
                  <c:formatCode>General</c:formatCode>
                  <c:ptCount val="9"/>
                  <c:pt idx="0">
                    <c:v>1.2760597804896836</c:v>
                  </c:pt>
                  <c:pt idx="1">
                    <c:v>1.8860122177785397</c:v>
                  </c:pt>
                  <c:pt idx="2">
                    <c:v>4.3644512473525605</c:v>
                  </c:pt>
                  <c:pt idx="3">
                    <c:v>2.6895764077364883</c:v>
                  </c:pt>
                  <c:pt idx="4">
                    <c:v>3.3501048447501374</c:v>
                  </c:pt>
                  <c:pt idx="5">
                    <c:v>2.2544179228592531</c:v>
                  </c:pt>
                  <c:pt idx="6">
                    <c:v>0.2519481709818262</c:v>
                  </c:pt>
                  <c:pt idx="7">
                    <c:v>1.5945241522453848</c:v>
                  </c:pt>
                  <c:pt idx="8">
                    <c:v>2.4128889157025681</c:v>
                  </c:pt>
                </c:numCache>
              </c:numRef>
            </c:plus>
            <c:minus>
              <c:numRef>
                <c:f>[1]Sheet3!$N$25:$N$33</c:f>
                <c:numCache>
                  <c:formatCode>General</c:formatCode>
                  <c:ptCount val="9"/>
                  <c:pt idx="0">
                    <c:v>1.2760597804896836</c:v>
                  </c:pt>
                  <c:pt idx="1">
                    <c:v>1.8860122177785397</c:v>
                  </c:pt>
                  <c:pt idx="2">
                    <c:v>4.3644512473525605</c:v>
                  </c:pt>
                  <c:pt idx="3">
                    <c:v>2.6895764077364883</c:v>
                  </c:pt>
                  <c:pt idx="4">
                    <c:v>3.3501048447501374</c:v>
                  </c:pt>
                  <c:pt idx="5">
                    <c:v>2.2544179228592531</c:v>
                  </c:pt>
                  <c:pt idx="6">
                    <c:v>0.2519481709818262</c:v>
                  </c:pt>
                  <c:pt idx="7">
                    <c:v>1.5945241522453848</c:v>
                  </c:pt>
                  <c:pt idx="8">
                    <c:v>2.4128889157025681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L$25:$L$33</c:f>
              <c:numCache>
                <c:formatCode>General</c:formatCode>
                <c:ptCount val="9"/>
                <c:pt idx="0">
                  <c:v>100</c:v>
                </c:pt>
                <c:pt idx="1">
                  <c:v>104.02073659460773</c:v>
                </c:pt>
                <c:pt idx="2">
                  <c:v>111.78071255126267</c:v>
                </c:pt>
                <c:pt idx="3">
                  <c:v>101.5848387767067</c:v>
                </c:pt>
                <c:pt idx="4">
                  <c:v>95.192621562377994</c:v>
                </c:pt>
                <c:pt idx="5">
                  <c:v>91.743389794376114</c:v>
                </c:pt>
                <c:pt idx="6">
                  <c:v>85.576840238777635</c:v>
                </c:pt>
                <c:pt idx="7">
                  <c:v>87.533845650751573</c:v>
                </c:pt>
                <c:pt idx="8">
                  <c:v>45.9269931099731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525-46AC-9DC5-138B149D84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8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ime (h)</a:t>
                </a:r>
              </a:p>
            </c:rich>
          </c:tx>
          <c:layout>
            <c:manualLayout>
              <c:xMode val="edge"/>
              <c:yMode val="edge"/>
              <c:x val="0.42795998161927717"/>
              <c:y val="0.861049657098798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8484686761848714"/>
          <c:y val="0.15317620944531513"/>
          <c:w val="0.3838572108059301"/>
          <c:h val="0.258646284305271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sng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400" b="1" u="sng"/>
              <a:t>ACY-738 3 </a:t>
            </a:r>
            <a:r>
              <a:rPr lang="en-US" sz="1400" b="1" u="sng">
                <a:latin typeface="Symbol" panose="05050102010706020507" pitchFamily="18" charset="2"/>
              </a:rPr>
              <a:t>m</a:t>
            </a:r>
            <a:r>
              <a:rPr lang="en-US" sz="1400" b="1" u="sng"/>
              <a:t>M</a:t>
            </a:r>
          </a:p>
        </c:rich>
      </c:tx>
      <c:layout>
        <c:manualLayout>
          <c:xMode val="edge"/>
          <c:yMode val="edge"/>
          <c:x val="0.32730307943975939"/>
          <c:y val="2.8761432164672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sng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366417342014271"/>
          <c:y val="0.13293549627445145"/>
          <c:w val="0.79839295877274719"/>
          <c:h val="0.70869493188985355"/>
        </c:manualLayout>
      </c:layout>
      <c:scatterChart>
        <c:scatterStyle val="lineMarker"/>
        <c:varyColors val="0"/>
        <c:ser>
          <c:idx val="0"/>
          <c:order val="0"/>
          <c:tx>
            <c:v>RPMI 8226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J$41:$J$49</c:f>
                <c:numCache>
                  <c:formatCode>General</c:formatCode>
                  <c:ptCount val="9"/>
                  <c:pt idx="0">
                    <c:v>2.14315781243873</c:v>
                  </c:pt>
                  <c:pt idx="1">
                    <c:v>1.5672623528424996</c:v>
                  </c:pt>
                  <c:pt idx="2">
                    <c:v>0.92132083588135871</c:v>
                  </c:pt>
                  <c:pt idx="3">
                    <c:v>3.1245042431728334</c:v>
                  </c:pt>
                  <c:pt idx="4">
                    <c:v>1.7081547015132086</c:v>
                  </c:pt>
                  <c:pt idx="5">
                    <c:v>4.0013739749443946</c:v>
                  </c:pt>
                  <c:pt idx="6">
                    <c:v>4.9424048729576642</c:v>
                  </c:pt>
                  <c:pt idx="7">
                    <c:v>3.5027321231717341</c:v>
                  </c:pt>
                  <c:pt idx="8">
                    <c:v>1.4286414301884987</c:v>
                  </c:pt>
                </c:numCache>
              </c:numRef>
            </c:plus>
            <c:minus>
              <c:numRef>
                <c:f>[1]Sheet3!$J$41:$J$49</c:f>
                <c:numCache>
                  <c:formatCode>General</c:formatCode>
                  <c:ptCount val="9"/>
                  <c:pt idx="0">
                    <c:v>2.14315781243873</c:v>
                  </c:pt>
                  <c:pt idx="1">
                    <c:v>1.5672623528424996</c:v>
                  </c:pt>
                  <c:pt idx="2">
                    <c:v>0.92132083588135871</c:v>
                  </c:pt>
                  <c:pt idx="3">
                    <c:v>3.1245042431728334</c:v>
                  </c:pt>
                  <c:pt idx="4">
                    <c:v>1.7081547015132086</c:v>
                  </c:pt>
                  <c:pt idx="5">
                    <c:v>4.0013739749443946</c:v>
                  </c:pt>
                  <c:pt idx="6">
                    <c:v>4.9424048729576642</c:v>
                  </c:pt>
                  <c:pt idx="7">
                    <c:v>3.5027321231717341</c:v>
                  </c:pt>
                  <c:pt idx="8">
                    <c:v>1.428641430188498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H$41:$H$49</c:f>
              <c:numCache>
                <c:formatCode>General</c:formatCode>
                <c:ptCount val="9"/>
                <c:pt idx="0">
                  <c:v>100.0000000000002</c:v>
                </c:pt>
                <c:pt idx="1">
                  <c:v>101.19477422463935</c:v>
                </c:pt>
                <c:pt idx="2">
                  <c:v>101.13783380592477</c:v>
                </c:pt>
                <c:pt idx="3">
                  <c:v>109.18379646912369</c:v>
                </c:pt>
                <c:pt idx="4">
                  <c:v>106.11530001863932</c:v>
                </c:pt>
                <c:pt idx="5">
                  <c:v>94.197742212417538</c:v>
                </c:pt>
                <c:pt idx="6">
                  <c:v>70.884327412804765</c:v>
                </c:pt>
                <c:pt idx="7">
                  <c:v>41.099421446130243</c:v>
                </c:pt>
                <c:pt idx="8">
                  <c:v>34.8239000583635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6E1-4F9C-949A-87BE1F44EF41}"/>
            </c:ext>
          </c:extLst>
        </c:ser>
        <c:ser>
          <c:idx val="1"/>
          <c:order val="1"/>
          <c:tx>
            <c:v>ARH 77</c:v>
          </c:tx>
          <c:spPr>
            <a:ln w="19050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J$8:$J$16</c:f>
                <c:numCache>
                  <c:formatCode>General</c:formatCode>
                  <c:ptCount val="9"/>
                  <c:pt idx="0">
                    <c:v>2.3342563638259132E-3</c:v>
                  </c:pt>
                  <c:pt idx="1">
                    <c:v>5.3515579355897245</c:v>
                  </c:pt>
                  <c:pt idx="2">
                    <c:v>5.1366375942453848</c:v>
                  </c:pt>
                  <c:pt idx="3">
                    <c:v>4.0498087633136368</c:v>
                  </c:pt>
                  <c:pt idx="4">
                    <c:v>5.245273478580577</c:v>
                  </c:pt>
                  <c:pt idx="5">
                    <c:v>2.8692457220555272</c:v>
                  </c:pt>
                  <c:pt idx="6">
                    <c:v>3.156704231893499</c:v>
                  </c:pt>
                  <c:pt idx="7">
                    <c:v>7.996208445725677</c:v>
                  </c:pt>
                  <c:pt idx="8">
                    <c:v>8.2136694520078475</c:v>
                  </c:pt>
                </c:numCache>
              </c:numRef>
            </c:plus>
            <c:minus>
              <c:numRef>
                <c:f>[1]Sheet3!$J$8:$J$16</c:f>
                <c:numCache>
                  <c:formatCode>General</c:formatCode>
                  <c:ptCount val="9"/>
                  <c:pt idx="0">
                    <c:v>2.3342563638259132E-3</c:v>
                  </c:pt>
                  <c:pt idx="1">
                    <c:v>5.3515579355897245</c:v>
                  </c:pt>
                  <c:pt idx="2">
                    <c:v>5.1366375942453848</c:v>
                  </c:pt>
                  <c:pt idx="3">
                    <c:v>4.0498087633136368</c:v>
                  </c:pt>
                  <c:pt idx="4">
                    <c:v>5.245273478580577</c:v>
                  </c:pt>
                  <c:pt idx="5">
                    <c:v>2.8692457220555272</c:v>
                  </c:pt>
                  <c:pt idx="6">
                    <c:v>3.156704231893499</c:v>
                  </c:pt>
                  <c:pt idx="7">
                    <c:v>7.996208445725677</c:v>
                  </c:pt>
                  <c:pt idx="8">
                    <c:v>8.2136694520078475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H$8:$H$16</c:f>
              <c:numCache>
                <c:formatCode>General</c:formatCode>
                <c:ptCount val="9"/>
                <c:pt idx="0">
                  <c:v>100</c:v>
                </c:pt>
                <c:pt idx="1">
                  <c:v>116.04611423332705</c:v>
                </c:pt>
                <c:pt idx="2">
                  <c:v>118.86446917725384</c:v>
                </c:pt>
                <c:pt idx="3">
                  <c:v>120.33969263707289</c:v>
                </c:pt>
                <c:pt idx="4">
                  <c:v>102.51588325911816</c:v>
                </c:pt>
                <c:pt idx="5">
                  <c:v>103.0861641408882</c:v>
                </c:pt>
                <c:pt idx="6">
                  <c:v>99.09005824635166</c:v>
                </c:pt>
                <c:pt idx="7">
                  <c:v>96.854058373788163</c:v>
                </c:pt>
                <c:pt idx="8">
                  <c:v>69.7047648876486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6E1-4F9C-949A-87BE1F44EF41}"/>
            </c:ext>
          </c:extLst>
        </c:ser>
        <c:ser>
          <c:idx val="2"/>
          <c:order val="2"/>
          <c:tx>
            <c:v>U266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70C0"/>
              </a:solidFill>
              <a:ln w="9525">
                <a:solidFill>
                  <a:srgbClr val="0070C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[1]Sheet3!$J$25:$J$33</c:f>
                <c:numCache>
                  <c:formatCode>General</c:formatCode>
                  <c:ptCount val="9"/>
                  <c:pt idx="0">
                    <c:v>2.3869986889575006</c:v>
                  </c:pt>
                  <c:pt idx="1">
                    <c:v>2.0338034351480587</c:v>
                  </c:pt>
                  <c:pt idx="2">
                    <c:v>5.8108655960141471</c:v>
                  </c:pt>
                  <c:pt idx="3">
                    <c:v>5.341778235931173</c:v>
                  </c:pt>
                  <c:pt idx="4">
                    <c:v>4.2422807183442242</c:v>
                  </c:pt>
                  <c:pt idx="5">
                    <c:v>3.7224143328743726</c:v>
                  </c:pt>
                  <c:pt idx="6">
                    <c:v>1.5546113382585418</c:v>
                  </c:pt>
                  <c:pt idx="7">
                    <c:v>2.3380278299066717</c:v>
                  </c:pt>
                  <c:pt idx="8">
                    <c:v>2.9238689365233297</c:v>
                  </c:pt>
                </c:numCache>
              </c:numRef>
            </c:plus>
            <c:minus>
              <c:numRef>
                <c:f>[1]Sheet3!$J$25:$J$33</c:f>
                <c:numCache>
                  <c:formatCode>General</c:formatCode>
                  <c:ptCount val="9"/>
                  <c:pt idx="0">
                    <c:v>2.3869986889575006</c:v>
                  </c:pt>
                  <c:pt idx="1">
                    <c:v>2.0338034351480587</c:v>
                  </c:pt>
                  <c:pt idx="2">
                    <c:v>5.8108655960141471</c:v>
                  </c:pt>
                  <c:pt idx="3">
                    <c:v>5.341778235931173</c:v>
                  </c:pt>
                  <c:pt idx="4">
                    <c:v>4.2422807183442242</c:v>
                  </c:pt>
                  <c:pt idx="5">
                    <c:v>3.7224143328743726</c:v>
                  </c:pt>
                  <c:pt idx="6">
                    <c:v>1.5546113382585418</c:v>
                  </c:pt>
                  <c:pt idx="7">
                    <c:v>2.3380278299066717</c:v>
                  </c:pt>
                  <c:pt idx="8">
                    <c:v>2.9238689365233297</c:v>
                  </c:pt>
                </c:numCache>
              </c:numRef>
            </c:minus>
            <c:spPr>
              <a:noFill/>
              <a:ln w="1587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[1]Sheet3!$C$8:$C$15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  <c:pt idx="5">
                  <c:v>24</c:v>
                </c:pt>
                <c:pt idx="6">
                  <c:v>48</c:v>
                </c:pt>
                <c:pt idx="7">
                  <c:v>72</c:v>
                </c:pt>
              </c:numCache>
            </c:numRef>
          </c:xVal>
          <c:yVal>
            <c:numRef>
              <c:f>[1]Sheet3!$H$25:$H$33</c:f>
              <c:numCache>
                <c:formatCode>General</c:formatCode>
                <c:ptCount val="9"/>
                <c:pt idx="0">
                  <c:v>100</c:v>
                </c:pt>
                <c:pt idx="1">
                  <c:v>103.87190233126928</c:v>
                </c:pt>
                <c:pt idx="2">
                  <c:v>105.58384691159664</c:v>
                </c:pt>
                <c:pt idx="3">
                  <c:v>109.02495854534907</c:v>
                </c:pt>
                <c:pt idx="4">
                  <c:v>96.120927598431621</c:v>
                </c:pt>
                <c:pt idx="5">
                  <c:v>94.233697149882346</c:v>
                </c:pt>
                <c:pt idx="6">
                  <c:v>93.921396781190083</c:v>
                </c:pt>
                <c:pt idx="7">
                  <c:v>89.837968435857562</c:v>
                </c:pt>
                <c:pt idx="8">
                  <c:v>61.9133357626044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6E1-4F9C-949A-87BE1F44EF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7278200"/>
        <c:axId val="1131435656"/>
      </c:scatterChart>
      <c:valAx>
        <c:axId val="607278200"/>
        <c:scaling>
          <c:orientation val="minMax"/>
          <c:max val="8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31435656"/>
        <c:crosses val="autoZero"/>
        <c:crossBetween val="midCat"/>
        <c:majorUnit val="24"/>
      </c:valAx>
      <c:valAx>
        <c:axId val="1131435656"/>
        <c:scaling>
          <c:orientation val="minMax"/>
          <c:max val="2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278200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1360253352831864"/>
          <c:y val="0.15427675847276037"/>
          <c:w val="0.44038854864672872"/>
          <c:h val="0.2542750145910949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6.xml"/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10" Type="http://schemas.openxmlformats.org/officeDocument/2006/relationships/chart" Target="../charts/chart18.xml"/><Relationship Id="rId4" Type="http://schemas.openxmlformats.org/officeDocument/2006/relationships/chart" Target="../charts/chart12.xml"/><Relationship Id="rId9" Type="http://schemas.openxmlformats.org/officeDocument/2006/relationships/chart" Target="../charts/chart1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7" Type="http://schemas.openxmlformats.org/officeDocument/2006/relationships/chart" Target="../charts/chart30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9.xml"/><Relationship Id="rId5" Type="http://schemas.openxmlformats.org/officeDocument/2006/relationships/chart" Target="../charts/chart28.xml"/><Relationship Id="rId4" Type="http://schemas.openxmlformats.org/officeDocument/2006/relationships/chart" Target="../charts/chart2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0BFED0C-7061-450F-9252-47129CB6C5D9}"/>
              </a:ext>
            </a:extLst>
          </p:cNvPr>
          <p:cNvGraphicFramePr>
            <a:graphicFrameLocks/>
          </p:cNvGraphicFramePr>
          <p:nvPr/>
        </p:nvGraphicFramePr>
        <p:xfrm>
          <a:off x="2905614" y="120315"/>
          <a:ext cx="3074132" cy="2128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54863D8-F9B5-47C4-A314-A2B9B6F02AAB}"/>
              </a:ext>
            </a:extLst>
          </p:cNvPr>
          <p:cNvGraphicFramePr>
            <a:graphicFrameLocks/>
          </p:cNvGraphicFramePr>
          <p:nvPr/>
        </p:nvGraphicFramePr>
        <p:xfrm>
          <a:off x="2905614" y="2311713"/>
          <a:ext cx="3077313" cy="2128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B5459507-A64A-4308-AC52-7F15838FA563}"/>
              </a:ext>
            </a:extLst>
          </p:cNvPr>
          <p:cNvGraphicFramePr>
            <a:graphicFrameLocks/>
          </p:cNvGraphicFramePr>
          <p:nvPr/>
        </p:nvGraphicFramePr>
        <p:xfrm>
          <a:off x="2905614" y="4503110"/>
          <a:ext cx="3076566" cy="23413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873E774-1835-4CBA-8B5D-07AD432BCB67}"/>
              </a:ext>
            </a:extLst>
          </p:cNvPr>
          <p:cNvGraphicFramePr>
            <a:graphicFrameLocks/>
          </p:cNvGraphicFramePr>
          <p:nvPr/>
        </p:nvGraphicFramePr>
        <p:xfrm>
          <a:off x="6096000" y="13563"/>
          <a:ext cx="3074132" cy="2128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E82F7964-CEC6-4CBA-8767-4B72024327A8}"/>
              </a:ext>
            </a:extLst>
          </p:cNvPr>
          <p:cNvGraphicFramePr>
            <a:graphicFrameLocks/>
          </p:cNvGraphicFramePr>
          <p:nvPr/>
        </p:nvGraphicFramePr>
        <p:xfrm>
          <a:off x="6096000" y="2201754"/>
          <a:ext cx="3074132" cy="2128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E0084511-D261-4E15-9BA5-009F49555BE5}"/>
              </a:ext>
            </a:extLst>
          </p:cNvPr>
          <p:cNvGraphicFramePr>
            <a:graphicFrameLocks/>
          </p:cNvGraphicFramePr>
          <p:nvPr/>
        </p:nvGraphicFramePr>
        <p:xfrm>
          <a:off x="6096000" y="4389944"/>
          <a:ext cx="3074132" cy="24544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52636561-CBB0-4452-AF41-52801C54504A}"/>
              </a:ext>
            </a:extLst>
          </p:cNvPr>
          <p:cNvGraphicFramePr>
            <a:graphicFrameLocks/>
          </p:cNvGraphicFramePr>
          <p:nvPr/>
        </p:nvGraphicFramePr>
        <p:xfrm>
          <a:off x="9104957" y="0"/>
          <a:ext cx="3120511" cy="2111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E4BE510D-564B-4733-B15D-11AD271F2DB3}"/>
              </a:ext>
            </a:extLst>
          </p:cNvPr>
          <p:cNvGraphicFramePr>
            <a:graphicFrameLocks/>
          </p:cNvGraphicFramePr>
          <p:nvPr/>
        </p:nvGraphicFramePr>
        <p:xfrm>
          <a:off x="9104957" y="4382795"/>
          <a:ext cx="3101075" cy="24616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C7FEDF11-26F5-4234-909C-168F78014FAD}"/>
              </a:ext>
            </a:extLst>
          </p:cNvPr>
          <p:cNvGraphicFramePr>
            <a:graphicFrameLocks/>
          </p:cNvGraphicFramePr>
          <p:nvPr/>
        </p:nvGraphicFramePr>
        <p:xfrm>
          <a:off x="9104957" y="2185124"/>
          <a:ext cx="3122286" cy="21235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EB0E698F-FFC1-FC53-725B-14CA0E4AD46D}"/>
              </a:ext>
            </a:extLst>
          </p:cNvPr>
          <p:cNvSpPr txBox="1"/>
          <p:nvPr/>
        </p:nvSpPr>
        <p:spPr>
          <a:xfrm rot="16200000">
            <a:off x="1178299" y="3081103"/>
            <a:ext cx="23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% Proteasome Activity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0B17ED9-4EA3-7D60-9C7F-6155267D06D3}"/>
              </a:ext>
            </a:extLst>
          </p:cNvPr>
          <p:cNvCxnSpPr/>
          <p:nvPr/>
        </p:nvCxnSpPr>
        <p:spPr>
          <a:xfrm>
            <a:off x="2767262" y="230169"/>
            <a:ext cx="0" cy="63976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27D6D89F-8BFC-78C4-FE1D-9B974C9F0E41}"/>
              </a:ext>
            </a:extLst>
          </p:cNvPr>
          <p:cNvSpPr txBox="1"/>
          <p:nvPr/>
        </p:nvSpPr>
        <p:spPr>
          <a:xfrm>
            <a:off x="75834" y="492804"/>
            <a:ext cx="269142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  Effect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HDAC6i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on    </a:t>
            </a:r>
          </a:p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  Proteasome Activity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3140" y="16901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4</a:t>
            </a:r>
          </a:p>
        </p:txBody>
      </p:sp>
    </p:spTree>
    <p:extLst>
      <p:ext uri="{BB962C8B-B14F-4D97-AF65-F5344CB8AC3E}">
        <p14:creationId xmlns:p14="http://schemas.microsoft.com/office/powerpoint/2010/main" val="36961400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6D55844D-1BA1-49D7-924B-4179509AB342}"/>
              </a:ext>
            </a:extLst>
          </p:cNvPr>
          <p:cNvGraphicFramePr>
            <a:graphicFrameLocks/>
          </p:cNvGraphicFramePr>
          <p:nvPr/>
        </p:nvGraphicFramePr>
        <p:xfrm>
          <a:off x="2438809" y="-33781"/>
          <a:ext cx="3096693" cy="22383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5C95A9FF-1353-47CF-9803-E8DC2DF9FDC8}"/>
              </a:ext>
            </a:extLst>
          </p:cNvPr>
          <p:cNvGraphicFramePr>
            <a:graphicFrameLocks/>
          </p:cNvGraphicFramePr>
          <p:nvPr/>
        </p:nvGraphicFramePr>
        <p:xfrm>
          <a:off x="5590364" y="-33781"/>
          <a:ext cx="3048308" cy="22446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0A8F0CF-4FAC-4521-928D-8CF2A00D1216}"/>
              </a:ext>
            </a:extLst>
          </p:cNvPr>
          <p:cNvGraphicFramePr>
            <a:graphicFrameLocks/>
          </p:cNvGraphicFramePr>
          <p:nvPr/>
        </p:nvGraphicFramePr>
        <p:xfrm>
          <a:off x="2458041" y="2170984"/>
          <a:ext cx="3084596" cy="22321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CB4C7B5-6282-429D-A5A9-E4152F09B812}"/>
              </a:ext>
            </a:extLst>
          </p:cNvPr>
          <p:cNvGraphicFramePr>
            <a:graphicFrameLocks/>
          </p:cNvGraphicFramePr>
          <p:nvPr/>
        </p:nvGraphicFramePr>
        <p:xfrm>
          <a:off x="5609596" y="2167840"/>
          <a:ext cx="3036210" cy="22383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C1D6125-1EEC-41F7-BD32-9336C61F7F80}"/>
              </a:ext>
            </a:extLst>
          </p:cNvPr>
          <p:cNvGraphicFramePr>
            <a:graphicFrameLocks/>
          </p:cNvGraphicFramePr>
          <p:nvPr/>
        </p:nvGraphicFramePr>
        <p:xfrm>
          <a:off x="2482776" y="4246075"/>
          <a:ext cx="3072500" cy="23717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F3BD3E68-0A29-400B-BDDA-358F232A6298}"/>
              </a:ext>
            </a:extLst>
          </p:cNvPr>
          <p:cNvGraphicFramePr>
            <a:graphicFrameLocks/>
          </p:cNvGraphicFramePr>
          <p:nvPr/>
        </p:nvGraphicFramePr>
        <p:xfrm>
          <a:off x="5646972" y="4246075"/>
          <a:ext cx="3018066" cy="23717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8E147780-9AD1-426D-9F37-F5984E5919ED}"/>
              </a:ext>
            </a:extLst>
          </p:cNvPr>
          <p:cNvGraphicFramePr>
            <a:graphicFrameLocks/>
          </p:cNvGraphicFramePr>
          <p:nvPr/>
        </p:nvGraphicFramePr>
        <p:xfrm>
          <a:off x="8693534" y="-33781"/>
          <a:ext cx="3024114" cy="22321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D99DC12C-0E22-486A-8250-6716166A5FA7}"/>
              </a:ext>
            </a:extLst>
          </p:cNvPr>
          <p:cNvGraphicFramePr>
            <a:graphicFrameLocks/>
          </p:cNvGraphicFramePr>
          <p:nvPr/>
        </p:nvGraphicFramePr>
        <p:xfrm>
          <a:off x="8683182" y="2098786"/>
          <a:ext cx="3024114" cy="22352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D25BAE23-B41C-42B9-B015-7322CAE745F5}"/>
              </a:ext>
            </a:extLst>
          </p:cNvPr>
          <p:cNvGraphicFramePr>
            <a:graphicFrameLocks/>
          </p:cNvGraphicFramePr>
          <p:nvPr/>
        </p:nvGraphicFramePr>
        <p:xfrm>
          <a:off x="8773678" y="4234497"/>
          <a:ext cx="3030162" cy="23717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BC893DB1-2E96-8597-729C-5BF2B52F859C}"/>
              </a:ext>
            </a:extLst>
          </p:cNvPr>
          <p:cNvSpPr txBox="1"/>
          <p:nvPr/>
        </p:nvSpPr>
        <p:spPr>
          <a:xfrm rot="16200000">
            <a:off x="1152767" y="3059516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% Cell Viability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3830BF2-8A27-FAEE-A029-A83CBE0B4A72}"/>
              </a:ext>
            </a:extLst>
          </p:cNvPr>
          <p:cNvCxnSpPr/>
          <p:nvPr/>
        </p:nvCxnSpPr>
        <p:spPr>
          <a:xfrm>
            <a:off x="2371850" y="208582"/>
            <a:ext cx="0" cy="63976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27D6D89F-8BFC-78C4-FE1D-9B974C9F0E41}"/>
              </a:ext>
            </a:extLst>
          </p:cNvPr>
          <p:cNvSpPr txBox="1"/>
          <p:nvPr/>
        </p:nvSpPr>
        <p:spPr>
          <a:xfrm>
            <a:off x="43140" y="483826"/>
            <a:ext cx="255307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  Effect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HDAC6i </a:t>
            </a:r>
            <a:endParaRPr lang="en-US" sz="1600" b="1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    on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ell Viability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140" y="16901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4</a:t>
            </a:r>
          </a:p>
        </p:txBody>
      </p:sp>
    </p:spTree>
    <p:extLst>
      <p:ext uri="{BB962C8B-B14F-4D97-AF65-F5344CB8AC3E}">
        <p14:creationId xmlns:p14="http://schemas.microsoft.com/office/powerpoint/2010/main" val="32336311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5F00828-FEE9-4394-A993-C40AFAE3AFAD}"/>
              </a:ext>
            </a:extLst>
          </p:cNvPr>
          <p:cNvGraphicFramePr>
            <a:graphicFrameLocks/>
          </p:cNvGraphicFramePr>
          <p:nvPr/>
        </p:nvGraphicFramePr>
        <p:xfrm>
          <a:off x="1760435" y="711573"/>
          <a:ext cx="3289661" cy="28343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033763F3-65F0-42A9-89C0-AD2066B8BC35}"/>
              </a:ext>
            </a:extLst>
          </p:cNvPr>
          <p:cNvGraphicFramePr>
            <a:graphicFrameLocks/>
          </p:cNvGraphicFramePr>
          <p:nvPr/>
        </p:nvGraphicFramePr>
        <p:xfrm>
          <a:off x="5167501" y="711572"/>
          <a:ext cx="3289661" cy="28343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63FB34A-5E11-4B8D-BD04-99F353F11AA0}"/>
              </a:ext>
            </a:extLst>
          </p:cNvPr>
          <p:cNvGraphicFramePr>
            <a:graphicFrameLocks/>
          </p:cNvGraphicFramePr>
          <p:nvPr/>
        </p:nvGraphicFramePr>
        <p:xfrm>
          <a:off x="8574567" y="711572"/>
          <a:ext cx="3309039" cy="28343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EDA1D1B-87CD-47A2-BB06-8F66B88C9FC0}"/>
              </a:ext>
            </a:extLst>
          </p:cNvPr>
          <p:cNvGraphicFramePr>
            <a:graphicFrameLocks/>
          </p:cNvGraphicFramePr>
          <p:nvPr/>
        </p:nvGraphicFramePr>
        <p:xfrm>
          <a:off x="1750451" y="3629719"/>
          <a:ext cx="3292597" cy="2819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E6834CB-D4DA-47C8-BFE5-556380F826DD}"/>
              </a:ext>
            </a:extLst>
          </p:cNvPr>
          <p:cNvGraphicFramePr>
            <a:graphicFrameLocks/>
          </p:cNvGraphicFramePr>
          <p:nvPr/>
        </p:nvGraphicFramePr>
        <p:xfrm>
          <a:off x="5157518" y="3621511"/>
          <a:ext cx="3280265" cy="28040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E2EDB50C-A64F-4C0E-8A19-ABDA876AC101}"/>
              </a:ext>
            </a:extLst>
          </p:cNvPr>
          <p:cNvGraphicFramePr>
            <a:graphicFrameLocks/>
          </p:cNvGraphicFramePr>
          <p:nvPr/>
        </p:nvGraphicFramePr>
        <p:xfrm>
          <a:off x="8564584" y="3621512"/>
          <a:ext cx="3319022" cy="27965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FBD154BE-D219-58BC-80FF-DBCC09BC9DE2}"/>
              </a:ext>
            </a:extLst>
          </p:cNvPr>
          <p:cNvSpPr txBox="1"/>
          <p:nvPr/>
        </p:nvSpPr>
        <p:spPr>
          <a:xfrm rot="16200000">
            <a:off x="768131" y="4932298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% Cell Viabilit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C853B7-BAA3-B950-9D17-CAAD518AAB9E}"/>
              </a:ext>
            </a:extLst>
          </p:cNvPr>
          <p:cNvSpPr txBox="1"/>
          <p:nvPr/>
        </p:nvSpPr>
        <p:spPr>
          <a:xfrm rot="16200000">
            <a:off x="373879" y="2076804"/>
            <a:ext cx="23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% Proteasome Activity</a:t>
            </a:r>
          </a:p>
        </p:txBody>
      </p:sp>
      <p:sp>
        <p:nvSpPr>
          <p:cNvPr id="11" name="TextBox 14">
            <a:extLst>
              <a:ext uri="{FF2B5EF4-FFF2-40B4-BE49-F238E27FC236}">
                <a16:creationId xmlns:a16="http://schemas.microsoft.com/office/drawing/2014/main" id="{27D6D89F-8BFC-78C4-FE1D-9B974C9F0E41}"/>
              </a:ext>
            </a:extLst>
          </p:cNvPr>
          <p:cNvSpPr txBox="1"/>
          <p:nvPr/>
        </p:nvSpPr>
        <p:spPr>
          <a:xfrm>
            <a:off x="0" y="306654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  Effect of Non-specific HDAC6 Inhibitors on proteasome activity and cell viability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5"/>
          <p:cNvSpPr txBox="1"/>
          <p:nvPr/>
        </p:nvSpPr>
        <p:spPr>
          <a:xfrm>
            <a:off x="0" y="0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4</a:t>
            </a:r>
          </a:p>
        </p:txBody>
      </p:sp>
    </p:spTree>
    <p:extLst>
      <p:ext uri="{BB962C8B-B14F-4D97-AF65-F5344CB8AC3E}">
        <p14:creationId xmlns:p14="http://schemas.microsoft.com/office/powerpoint/2010/main" val="1632365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F3740668-4C09-CA35-186B-EB3AE1F520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2185238"/>
              </p:ext>
            </p:extLst>
          </p:nvPr>
        </p:nvGraphicFramePr>
        <p:xfrm>
          <a:off x="1369259" y="591195"/>
          <a:ext cx="3033581" cy="2621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4A52BE8B-77B9-4110-AFD8-35CD72D921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0035783"/>
              </p:ext>
            </p:extLst>
          </p:nvPr>
        </p:nvGraphicFramePr>
        <p:xfrm>
          <a:off x="4529640" y="591195"/>
          <a:ext cx="3033581" cy="2621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7166E87-3C20-4F9E-8B53-4E76199C12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4767135"/>
              </p:ext>
            </p:extLst>
          </p:nvPr>
        </p:nvGraphicFramePr>
        <p:xfrm>
          <a:off x="7690020" y="591195"/>
          <a:ext cx="3033581" cy="26218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229F3DA-1424-48E9-82C4-E8A094A657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7007879"/>
              </p:ext>
            </p:extLst>
          </p:nvPr>
        </p:nvGraphicFramePr>
        <p:xfrm>
          <a:off x="1413627" y="3241648"/>
          <a:ext cx="3026426" cy="2603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3F38BD83-D83F-4C4C-976C-381318118F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49376"/>
              </p:ext>
            </p:extLst>
          </p:nvPr>
        </p:nvGraphicFramePr>
        <p:xfrm>
          <a:off x="4566853" y="3213071"/>
          <a:ext cx="3033581" cy="2593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B518C286-6B17-4DCD-9F17-DA7B47B3F6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0177614"/>
              </p:ext>
            </p:extLst>
          </p:nvPr>
        </p:nvGraphicFramePr>
        <p:xfrm>
          <a:off x="7727233" y="3213071"/>
          <a:ext cx="3119436" cy="2593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A6426D7-7D56-CB63-823C-AE0FE2DD2052}"/>
              </a:ext>
            </a:extLst>
          </p:cNvPr>
          <p:cNvSpPr txBox="1"/>
          <p:nvPr/>
        </p:nvSpPr>
        <p:spPr>
          <a:xfrm rot="16200000">
            <a:off x="260138" y="4252027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% Cell Viabilit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A69690-86C7-CE74-766D-788D91C0FE0D}"/>
              </a:ext>
            </a:extLst>
          </p:cNvPr>
          <p:cNvSpPr txBox="1"/>
          <p:nvPr/>
        </p:nvSpPr>
        <p:spPr>
          <a:xfrm rot="16200000">
            <a:off x="-109739" y="1647173"/>
            <a:ext cx="2335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% Proteasome Activity</a:t>
            </a:r>
          </a:p>
        </p:txBody>
      </p:sp>
      <p:sp>
        <p:nvSpPr>
          <p:cNvPr id="11" name="TextBox 14">
            <a:extLst>
              <a:ext uri="{FF2B5EF4-FFF2-40B4-BE49-F238E27FC236}">
                <a16:creationId xmlns:a16="http://schemas.microsoft.com/office/drawing/2014/main" id="{27D6D89F-8BFC-78C4-FE1D-9B974C9F0E41}"/>
              </a:ext>
            </a:extLst>
          </p:cNvPr>
          <p:cNvSpPr txBox="1"/>
          <p:nvPr/>
        </p:nvSpPr>
        <p:spPr>
          <a:xfrm>
            <a:off x="59243" y="258561"/>
            <a:ext cx="72480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d   Effect of HAT Activators on proteasome activity and cell viability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5"/>
          <p:cNvSpPr txBox="1"/>
          <p:nvPr/>
        </p:nvSpPr>
        <p:spPr>
          <a:xfrm>
            <a:off x="0" y="0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4</a:t>
            </a:r>
          </a:p>
        </p:txBody>
      </p:sp>
      <p:sp>
        <p:nvSpPr>
          <p:cNvPr id="10" name="Rectangle 9"/>
          <p:cNvSpPr/>
          <p:nvPr/>
        </p:nvSpPr>
        <p:spPr>
          <a:xfrm>
            <a:off x="184377" y="6027003"/>
            <a:ext cx="1193557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</a:t>
            </a: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b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14 a-d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HDAC6 inhibitors at the indicated concentrations and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imes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n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proteasome activity and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ell viability. Panel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shows the effect of non-specific HDAC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hibitors on proteasome activity and cell viability. In panels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and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, MM cells (50,000/well) were incubated with each pharmacologic at 1 uM for 72 h. Cell viability was determined using the XTT assay. </a:t>
            </a:r>
            <a:r>
              <a:rPr lang="en-US" sz="1200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 Effect of HAT activators on proteasome activity and cell viability. MM cells (50,000/well) were incubated with each pharmacologic at 1 uM for 72 h. Cell viability was determined using the XTT assay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0211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379</TotalTime>
  <Words>312</Words>
  <Application>Microsoft Office PowerPoint</Application>
  <PresentationFormat>Widescreen</PresentationFormat>
  <Paragraphs>5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98</cp:revision>
  <cp:lastPrinted>2024-03-02T18:31:01Z</cp:lastPrinted>
  <dcterms:created xsi:type="dcterms:W3CDTF">2022-08-15T18:48:13Z</dcterms:created>
  <dcterms:modified xsi:type="dcterms:W3CDTF">2024-05-03T22:25:12Z</dcterms:modified>
</cp:coreProperties>
</file>